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4941550" cy="16202025"/>
  <p:notesSz cx="6858000" cy="9144000"/>
  <p:defaultTextStyle>
    <a:defPPr>
      <a:defRPr lang="de-DE"/>
    </a:defPPr>
    <a:lvl1pPr marL="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1pPr>
    <a:lvl2pPr marL="87439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2pPr>
    <a:lvl3pPr marL="174879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3pPr>
    <a:lvl4pPr marL="262318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4pPr>
    <a:lvl5pPr marL="349758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5pPr>
    <a:lvl6pPr marL="437197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6pPr>
    <a:lvl7pPr marL="524637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7pPr>
    <a:lvl8pPr marL="6120765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8pPr>
    <a:lvl9pPr marL="6995160" algn="l" defTabSz="1748790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103">
          <p15:clr>
            <a:srgbClr val="A4A3A4"/>
          </p15:clr>
        </p15:guide>
        <p15:guide id="2" pos="470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CAA7777-180A-4B5D-8194-D34F96268794}" v="215" dt="2024-02-25T23:49:09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4660"/>
  </p:normalViewPr>
  <p:slideViewPr>
    <p:cSldViewPr>
      <p:cViewPr varScale="1">
        <p:scale>
          <a:sx n="46" d="100"/>
          <a:sy n="46" d="100"/>
        </p:scale>
        <p:origin x="-3096" y="-138"/>
      </p:cViewPr>
      <p:guideLst>
        <p:guide orient="horz" pos="5103"/>
        <p:guide pos="47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minik Aumann" userId="013c187a20e8f01a" providerId="LiveId" clId="{ECAA7777-180A-4B5D-8194-D34F96268794}"/>
    <pc:docChg chg="undo redo custSel addSld delSld modSld sldOrd">
      <pc:chgData name="Dominik Aumann" userId="013c187a20e8f01a" providerId="LiveId" clId="{ECAA7777-180A-4B5D-8194-D34F96268794}" dt="2024-02-25T23:49:17.918" v="811" actId="207"/>
      <pc:docMkLst>
        <pc:docMk/>
      </pc:docMkLst>
      <pc:sldChg chg="addSp delSp modSp mod ord">
        <pc:chgData name="Dominik Aumann" userId="013c187a20e8f01a" providerId="LiveId" clId="{ECAA7777-180A-4B5D-8194-D34F96268794}" dt="2024-02-25T23:49:17.918" v="811" actId="207"/>
        <pc:sldMkLst>
          <pc:docMk/>
          <pc:sldMk cId="677912352" sldId="256"/>
        </pc:sldMkLst>
        <pc:spChg chg="add mod">
          <ac:chgData name="Dominik Aumann" userId="013c187a20e8f01a" providerId="LiveId" clId="{ECAA7777-180A-4B5D-8194-D34F96268794}" dt="2024-02-25T23:49:17.918" v="811" actId="207"/>
          <ac:spMkLst>
            <pc:docMk/>
            <pc:sldMk cId="677912352" sldId="256"/>
            <ac:spMk id="2" creationId="{BEACECC4-1169-8B84-7703-332CD8866D81}"/>
          </ac:spMkLst>
        </pc:spChg>
        <pc:picChg chg="add del">
          <ac:chgData name="Dominik Aumann" userId="013c187a20e8f01a" providerId="LiveId" clId="{ECAA7777-180A-4B5D-8194-D34F96268794}" dt="2024-02-25T22:50:17.010" v="48" actId="21"/>
          <ac:picMkLst>
            <pc:docMk/>
            <pc:sldMk cId="677912352" sldId="256"/>
            <ac:picMk id="9" creationId="{00000000-0000-0000-0000-000000000000}"/>
          </ac:picMkLst>
        </pc:picChg>
        <pc:picChg chg="add del">
          <ac:chgData name="Dominik Aumann" userId="013c187a20e8f01a" providerId="LiveId" clId="{ECAA7777-180A-4B5D-8194-D34F96268794}" dt="2024-02-25T22:50:17.010" v="48" actId="21"/>
          <ac:picMkLst>
            <pc:docMk/>
            <pc:sldMk cId="677912352" sldId="256"/>
            <ac:picMk id="160" creationId="{00000000-0000-0000-0000-000000000000}"/>
          </ac:picMkLst>
        </pc:picChg>
        <pc:picChg chg="add del">
          <ac:chgData name="Dominik Aumann" userId="013c187a20e8f01a" providerId="LiveId" clId="{ECAA7777-180A-4B5D-8194-D34F96268794}" dt="2024-02-25T22:50:17.010" v="48" actId="21"/>
          <ac:picMkLst>
            <pc:docMk/>
            <pc:sldMk cId="677912352" sldId="256"/>
            <ac:picMk id="183" creationId="{00000000-0000-0000-0000-000000000000}"/>
          </ac:picMkLst>
        </pc:picChg>
        <pc:picChg chg="add del">
          <ac:chgData name="Dominik Aumann" userId="013c187a20e8f01a" providerId="LiveId" clId="{ECAA7777-180A-4B5D-8194-D34F96268794}" dt="2024-02-25T22:50:17.010" v="48" actId="21"/>
          <ac:picMkLst>
            <pc:docMk/>
            <pc:sldMk cId="677912352" sldId="256"/>
            <ac:picMk id="184" creationId="{00000000-0000-0000-0000-000000000000}"/>
          </ac:picMkLst>
        </pc:picChg>
      </pc:sldChg>
      <pc:sldChg chg="addSp delSp modSp add del mod">
        <pc:chgData name="Dominik Aumann" userId="013c187a20e8f01a" providerId="LiveId" clId="{ECAA7777-180A-4B5D-8194-D34F96268794}" dt="2024-02-25T23:39:56.398" v="763" actId="47"/>
        <pc:sldMkLst>
          <pc:docMk/>
          <pc:sldMk cId="2080604651" sldId="260"/>
        </pc:sldMkLst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" creationId="{78CAA2AD-7F6A-4A45-F1F8-48AB84D6A95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" creationId="{AB902B63-3AA2-CF1F-DE01-4491AF3E080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6" creationId="{ACBF7729-9068-1939-77CA-C5FF2F1079AE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7" creationId="{39E7695A-08C0-5209-4602-8AA3DC66F59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8" creationId="{00D73CC4-C342-AE85-4EFE-A116FCADD7B8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9" creationId="{866D74DC-81DF-100F-DD70-5B97C51D9531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0" creationId="{575FBEA9-000C-C460-E235-6185031095B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1" creationId="{F44D1E44-E192-7F51-4628-0411D8246FDC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2" creationId="{1066BFFE-147A-A156-1C04-0E823357E1D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" creationId="{E695BF28-6BB0-A852-483A-079A88EBDE4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" creationId="{C2B6253C-C7C6-0686-B741-AE75592D1D5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5" creationId="{9DD3E980-CC08-96ED-02B0-2526AB00B01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6" creationId="{2C4F83D0-CE9B-0F3E-AFAB-DC088FE29C01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0" creationId="{661438FF-D24A-6F34-2FBA-388A553C0E8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1" creationId="{1F7CF788-0EC1-4E44-8AF4-47826CD7B7AC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2" creationId="{46481AB6-6FA6-42B7-27C4-AD1BA0640E0B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4" creationId="{20323A53-9C17-60DC-5DF9-BA5CAE409CB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5" creationId="{8F5E4D6E-A49C-A1CC-4505-85FD3861D73E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6" creationId="{0584C51A-E639-D6B4-1E4C-20D278F67DF9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7" creationId="{49719657-67E3-E838-3739-90231E62A31C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8" creationId="{EDC1AAB7-A480-80C4-71D8-0B749DB8168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29" creationId="{46950DF6-E975-0917-7DBE-4418EA2A2A8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0" creationId="{0C1DE165-BAB4-C12D-7A6F-34A4B607D84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1" creationId="{38630F65-05F4-FB1F-46AA-FA5F62DA3B2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2" creationId="{11D08352-6640-6A11-835B-C594C08984B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3" creationId="{6D9D2E82-3BCE-A06F-13F8-C92135D005EB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4" creationId="{8074E9B5-4742-248F-5D1F-87854D0923AD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5" creationId="{CFC0C7F4-307A-839D-5D9F-98650B1752F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6" creationId="{D7BB44F1-4C2A-3589-9C48-94F9EF74737E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39" creationId="{D36B3AC4-88FE-74D6-2E1B-25F083CEB64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0" creationId="{0CA51E32-7EAB-853C-281A-22A61B8914E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1" creationId="{589ED652-7D00-F273-4464-4CF44E5C3D5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3" creationId="{ABDD240E-0F1B-C58B-A465-BD7640343CCD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4" creationId="{3A62B077-7BE1-3D2F-FE39-C1018818C591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5" creationId="{02760908-29DE-9879-2EF7-71E7867D71A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6" creationId="{7F26C161-6510-EEA2-06C3-25A41887BC0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7" creationId="{854FC75A-FDF6-4B77-4A7E-EBA9C782C475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8" creationId="{43940BDF-0D11-63C6-7FB7-98319C0FCF6B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49" creationId="{9F49F44C-C8F4-CF8C-22BB-6AD5B92D5781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0" creationId="{7575AC7D-9BBE-A45F-5538-E419826CF095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1" creationId="{470549FF-E06F-0064-F546-E7A73363D518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2" creationId="{7DCB238A-DA0E-9DEE-69B2-2B632123059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3" creationId="{16072688-9AEC-9B65-FF44-93E9EC67B0F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4" creationId="{09514E61-AF3C-98C1-9B55-134FBFD3FBA8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55" creationId="{082C79EA-3FAE-829E-F3DB-457B6659268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60" creationId="{743CD3FF-C43F-A925-3B64-30E24C7F52E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61" creationId="{72398D81-49B5-59C3-A673-8877BD6DF7F1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62" creationId="{266D21EC-2BB5-E631-6680-1B22022DE68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28" creationId="{EE7D692E-8233-F21D-7181-C8EF927D06A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29" creationId="{5CFE32DE-5EB9-40A8-9B90-BDB3DE891B8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0" creationId="{04E64A1F-8C27-8ED2-90E8-97C626CE4375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1" creationId="{5BD24956-F7BF-4804-E3E4-BA30BF7F461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2" creationId="{9CE55A76-A9D5-2F52-1880-A39B6801ABF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3" creationId="{302C11B0-E930-4824-7838-3698A65CD6FB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4" creationId="{43EC5139-F99E-0207-5621-E47594B533C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5" creationId="{F7EC1818-AB6E-45B2-E2DD-A8D49593961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6" creationId="{46C8B8CA-EE55-E493-3644-FE7ED491651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7" creationId="{7B988B94-96AA-905A-2B29-C293673B07F7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38" creationId="{6EDD6399-FA2A-93D8-0757-9EBAF6F8D1B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1" creationId="{8B71092E-3668-1C80-908C-C2073F9F3E38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2" creationId="{2D7C992F-7BC8-36CB-82F1-31C4DB5D5C2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3" creationId="{347499B6-EB12-CD71-B7E3-3CC86EA3117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5" creationId="{554A198A-D7E2-D833-5667-286BC15BC4E9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6" creationId="{72E1CF81-37CF-3677-E127-9A59376822FD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7" creationId="{90716150-15BF-612E-99E7-9745AB03218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8" creationId="{77D26EA6-D580-B7F9-4162-154670189447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49" creationId="{47ECB4C6-47A6-B3E6-9F0C-423ACDE0D30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52" creationId="{C4D5BE2D-D0C3-5C3E-EE21-F7F5C999DEA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53" creationId="{355ADC33-4FE8-80B2-E980-E28F07CE8862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54" creationId="{A9F25FF4-1F74-FA40-3ED1-4BBDC80A7BF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55" creationId="{3A9132E3-42F1-14A6-B98E-461F0D15DA0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56" creationId="{B343AF55-636F-4FCB-1D17-693ACC6F9FA0}"/>
          </ac:spMkLst>
        </pc:spChg>
        <pc:spChg chg="del mod topLvl">
          <ac:chgData name="Dominik Aumann" userId="013c187a20e8f01a" providerId="LiveId" clId="{ECAA7777-180A-4B5D-8194-D34F96268794}" dt="2024-02-25T22:56:38.962" v="102" actId="478"/>
          <ac:spMkLst>
            <pc:docMk/>
            <pc:sldMk cId="2080604651" sldId="260"/>
            <ac:spMk id="157" creationId="{50E65700-C5C5-97D8-665F-4BCD07828DE2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58" creationId="{3C08F1BE-9FDD-0275-478A-DB7B8F3FB72A}"/>
          </ac:spMkLst>
        </pc:spChg>
        <pc:spChg chg="del mod topLvl">
          <ac:chgData name="Dominik Aumann" userId="013c187a20e8f01a" providerId="LiveId" clId="{ECAA7777-180A-4B5D-8194-D34F96268794}" dt="2024-02-25T22:56:38.962" v="102" actId="478"/>
          <ac:spMkLst>
            <pc:docMk/>
            <pc:sldMk cId="2080604651" sldId="260"/>
            <ac:spMk id="159" creationId="{58986C65-13EF-29A3-E036-20AAC075EF03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60" creationId="{46C2B436-D56E-19CC-CCF1-6D56E4D3AD2C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61" creationId="{FE4A0189-290E-95B4-C5C1-301A24EA6ED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62" creationId="{7FEF71F8-819C-A49E-D437-0833864B15E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63" creationId="{21DD025F-AB5A-C05A-A621-6BA873D719FF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64" creationId="{36C7DE49-B143-E20D-6E4A-28502107704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65" creationId="{E0EB279C-AB8B-0BAA-5830-0CB3A83501D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69" creationId="{86904431-95D0-BC00-D1BF-11AFEFFC664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0" creationId="{9A71B6D5-30E6-A717-EA66-0BEBB6F695FD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2" creationId="{9AB3DD75-8458-2B0F-E26B-31CA1631C5F4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3" creationId="{8D8F0133-63C0-99D4-929D-D0118E32576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74" creationId="{D2C9532C-A077-5D7E-1A2B-A099E0277A89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5" creationId="{647F18C9-D60B-6813-52A1-EE9673608BB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6" creationId="{566FA8C8-42BA-9362-F38B-89034A6929DE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7" creationId="{9310FDB1-542B-F636-557E-82F8C54765C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8" creationId="{12AEFA30-3844-64F4-1D42-5A86140D5D5F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79" creationId="{9C2DF51F-F09A-62FB-F411-2CF611B9E5C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80" creationId="{C3955529-2482-EC29-FEBA-72568571B920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81" creationId="{800605EF-57D4-222A-611E-C3AFEFFA5FD6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82" creationId="{E56BF542-8FCF-335B-FA8B-C8CA317F9C8E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83" creationId="{081D6E68-3EA4-9314-FC96-B5BD11D553B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84" creationId="{359BD2E5-62EF-7392-F2F7-2FBDBE9CB469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85" creationId="{1B0DBF69-9E07-0566-C26F-4AD089E8C399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86" creationId="{463F4E02-2927-E326-821B-535A9602628A}"/>
          </ac:spMkLst>
        </pc:spChg>
        <pc:spChg chg="add mod">
          <ac:chgData name="Dominik Aumann" userId="013c187a20e8f01a" providerId="LiveId" clId="{ECAA7777-180A-4B5D-8194-D34F96268794}" dt="2024-02-25T22:52:28.619" v="74" actId="571"/>
          <ac:spMkLst>
            <pc:docMk/>
            <pc:sldMk cId="2080604651" sldId="260"/>
            <ac:spMk id="190" creationId="{32532449-A550-14FF-4738-892ED3615B58}"/>
          </ac:spMkLst>
        </pc:spChg>
        <pc:spChg chg="add del mod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91" creationId="{1CE12440-26E8-C5F7-0ADC-893993753879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2" creationId="{188505A2-E288-339E-ED20-69BFCAD14C77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93" creationId="{30C94AA8-5D89-75B9-EABD-45467A985EC6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4" creationId="{9E9E493A-6175-D175-FA1F-82B1FEEC3D37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5" creationId="{208C3D96-770A-1ECF-C752-718DD668EFB8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6" creationId="{2DD52E8B-5F36-74AE-C337-A3EEF2A243D5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7" creationId="{25D04608-8AB3-FFB9-11B4-219F405DEB06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8" creationId="{56D02665-1305-3F96-9EFB-50F951158DAC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99" creationId="{99EF7279-D11C-E1ED-C0DE-9349653AA11F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203" creationId="{9FC61261-6EBE-52AF-0DC7-94AAA0F30FEA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204" creationId="{A0472745-FC22-374A-9B0B-1C9FCA911107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205" creationId="{459497D9-8E7C-3276-0DEF-3ADA82186139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10" creationId="{FC14CC69-871D-2C34-A03F-1389BD29BB52}"/>
          </ac:spMkLst>
        </pc:spChg>
        <pc:spChg chg="del mod topLvl">
          <ac:chgData name="Dominik Aumann" userId="013c187a20e8f01a" providerId="LiveId" clId="{ECAA7777-180A-4B5D-8194-D34F96268794}" dt="2024-02-25T23:23:40.169" v="531" actId="478"/>
          <ac:spMkLst>
            <pc:docMk/>
            <pc:sldMk cId="2080604651" sldId="260"/>
            <ac:spMk id="216" creationId="{FD352E86-938F-A09F-E0A7-A850520423CE}"/>
          </ac:spMkLst>
        </pc:spChg>
        <pc:spChg chg="del mod topLvl">
          <ac:chgData name="Dominik Aumann" userId="013c187a20e8f01a" providerId="LiveId" clId="{ECAA7777-180A-4B5D-8194-D34F96268794}" dt="2024-02-25T23:23:42.918" v="532" actId="478"/>
          <ac:spMkLst>
            <pc:docMk/>
            <pc:sldMk cId="2080604651" sldId="260"/>
            <ac:spMk id="217" creationId="{8D589C2D-855F-819D-16B8-951494F7F754}"/>
          </ac:spMkLst>
        </pc:spChg>
        <pc:spChg chg="del mod topLvl">
          <ac:chgData name="Dominik Aumann" userId="013c187a20e8f01a" providerId="LiveId" clId="{ECAA7777-180A-4B5D-8194-D34F96268794}" dt="2024-02-25T23:23:49.557" v="534" actId="478"/>
          <ac:spMkLst>
            <pc:docMk/>
            <pc:sldMk cId="2080604651" sldId="260"/>
            <ac:spMk id="218" creationId="{AF56EABC-64CE-E0BC-1D60-4265315A82C2}"/>
          </ac:spMkLst>
        </pc:spChg>
        <pc:spChg chg="del mod topLvl">
          <ac:chgData name="Dominik Aumann" userId="013c187a20e8f01a" providerId="LiveId" clId="{ECAA7777-180A-4B5D-8194-D34F96268794}" dt="2024-02-25T23:23:51.869" v="535" actId="478"/>
          <ac:spMkLst>
            <pc:docMk/>
            <pc:sldMk cId="2080604651" sldId="260"/>
            <ac:spMk id="219" creationId="{F0CC0E19-E883-144A-C69F-7FBBF15DB8C7}"/>
          </ac:spMkLst>
        </pc:spChg>
        <pc:spChg chg="del mod topLvl">
          <ac:chgData name="Dominik Aumann" userId="013c187a20e8f01a" providerId="LiveId" clId="{ECAA7777-180A-4B5D-8194-D34F96268794}" dt="2024-02-25T23:23:55.946" v="536" actId="478"/>
          <ac:spMkLst>
            <pc:docMk/>
            <pc:sldMk cId="2080604651" sldId="260"/>
            <ac:spMk id="220" creationId="{C234B30D-32EE-BC42-A097-61C3D311976B}"/>
          </ac:spMkLst>
        </pc:spChg>
        <pc:spChg chg="del mod topLvl">
          <ac:chgData name="Dominik Aumann" userId="013c187a20e8f01a" providerId="LiveId" clId="{ECAA7777-180A-4B5D-8194-D34F96268794}" dt="2024-02-25T23:23:57.040" v="537" actId="478"/>
          <ac:spMkLst>
            <pc:docMk/>
            <pc:sldMk cId="2080604651" sldId="260"/>
            <ac:spMk id="221" creationId="{6781CB48-9F66-ACA9-BB44-96FEE212C257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2" creationId="{DC2EED84-35D7-607D-F4C9-FE48D45BC23D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3" creationId="{E6C649E8-68AB-67F6-64F8-B8C9CD3CFE76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4" creationId="{2796A195-2C60-EDB0-5AE1-5ABD317333A3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5" creationId="{524F6D54-ACC2-8327-6C35-77821D28A16C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6" creationId="{F53A9B68-608D-032A-972A-833E2AC999E7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28" creationId="{351C50CB-5235-78B7-4AFE-E32276459970}"/>
          </ac:spMkLst>
        </pc:spChg>
        <pc:spChg chg="del mod">
          <ac:chgData name="Dominik Aumann" userId="013c187a20e8f01a" providerId="LiveId" clId="{ECAA7777-180A-4B5D-8194-D34F96268794}" dt="2024-02-25T23:23:29.468" v="528" actId="478"/>
          <ac:spMkLst>
            <pc:docMk/>
            <pc:sldMk cId="2080604651" sldId="260"/>
            <ac:spMk id="232" creationId="{EED9611B-5108-EFE5-95FE-1242B436A0FA}"/>
          </ac:spMkLst>
        </pc:spChg>
        <pc:spChg chg="del mod topLvl">
          <ac:chgData name="Dominik Aumann" userId="013c187a20e8f01a" providerId="LiveId" clId="{ECAA7777-180A-4B5D-8194-D34F96268794}" dt="2024-02-25T23:23:45.496" v="533" actId="478"/>
          <ac:spMkLst>
            <pc:docMk/>
            <pc:sldMk cId="2080604651" sldId="260"/>
            <ac:spMk id="233" creationId="{A54799BE-3568-78FC-2260-0D43F0644A58}"/>
          </ac:spMkLst>
        </pc:spChg>
        <pc:spChg chg="del mod topLvl">
          <ac:chgData name="Dominik Aumann" userId="013c187a20e8f01a" providerId="LiveId" clId="{ECAA7777-180A-4B5D-8194-D34F96268794}" dt="2024-02-25T23:23:39.232" v="530" actId="478"/>
          <ac:spMkLst>
            <pc:docMk/>
            <pc:sldMk cId="2080604651" sldId="260"/>
            <ac:spMk id="234" creationId="{4A535AF3-6066-0D98-73B6-75655D8AA951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0" creationId="{526B94A1-3EC6-EDE4-D6FD-B90BB33082AE}"/>
          </ac:spMkLst>
        </pc:spChg>
        <pc:spChg chg="del mod topLvl">
          <ac:chgData name="Dominik Aumann" userId="013c187a20e8f01a" providerId="LiveId" clId="{ECAA7777-180A-4B5D-8194-D34F96268794}" dt="2024-02-25T23:26:31.269" v="576"/>
          <ac:spMkLst>
            <pc:docMk/>
            <pc:sldMk cId="2080604651" sldId="260"/>
            <ac:spMk id="241" creationId="{81DB9A28-8BA6-26C8-46A0-952B7ED07256}"/>
          </ac:spMkLst>
        </pc:spChg>
        <pc:spChg chg="del mod topLvl">
          <ac:chgData name="Dominik Aumann" userId="013c187a20e8f01a" providerId="LiveId" clId="{ECAA7777-180A-4B5D-8194-D34F96268794}" dt="2024-02-25T23:26:25.692" v="572" actId="478"/>
          <ac:spMkLst>
            <pc:docMk/>
            <pc:sldMk cId="2080604651" sldId="260"/>
            <ac:spMk id="242" creationId="{F300F8EF-A6D3-8A98-892F-1F0C88646A01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3" creationId="{DCB31DD5-C79E-66AB-1755-B97AF21C8DE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44" creationId="{FF27F8ED-1645-7CB3-87C6-9DBF72FC94D2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5" creationId="{19EA39EA-54E9-076D-FDA5-78989889F600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6" creationId="{5889D3E1-F4DF-1550-5E58-8CF17A59662D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7" creationId="{A01B7265-1009-51A1-9F66-220B6516E308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8" creationId="{BA6A8B2B-DFA0-3E2F-2617-58DA94BB533F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49" creationId="{BD031EF7-3361-24BC-91BB-783E90AF0E64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50" creationId="{B52C82AE-F022-DDE5-5D61-E1C432232159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51" creationId="{A5EAA284-57E3-D031-CB6F-734DB6B022ED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252" creationId="{BFB96CF9-E98A-56F3-E14D-51726CCEDDAE}"/>
          </ac:spMkLst>
        </pc:spChg>
        <pc:spChg chg="del mod topLvl">
          <ac:chgData name="Dominik Aumann" userId="013c187a20e8f01a" providerId="LiveId" clId="{ECAA7777-180A-4B5D-8194-D34F96268794}" dt="2024-02-25T22:56:14.780" v="98" actId="478"/>
          <ac:spMkLst>
            <pc:docMk/>
            <pc:sldMk cId="2080604651" sldId="260"/>
            <ac:spMk id="269" creationId="{7A1E39ED-01ED-93BA-48D5-BD92BC551642}"/>
          </ac:spMkLst>
        </pc:spChg>
        <pc:spChg chg="del mod topLvl">
          <ac:chgData name="Dominik Aumann" userId="013c187a20e8f01a" providerId="LiveId" clId="{ECAA7777-180A-4B5D-8194-D34F96268794}" dt="2024-02-25T22:56:14.780" v="98" actId="478"/>
          <ac:spMkLst>
            <pc:docMk/>
            <pc:sldMk cId="2080604651" sldId="260"/>
            <ac:spMk id="271" creationId="{4A01AD4B-DD22-7124-10D3-6F10F30802C8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2" creationId="{889049F8-10A9-0255-8A87-8B8F2EBD549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3" creationId="{691FCD08-08F3-1606-BA93-918BA59FB82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4" creationId="{DBB84D6C-C30C-E1C5-D616-35DF7850F8A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5" creationId="{08EBCF42-778F-D012-AD38-95FFE03D244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6" creationId="{B31BCB92-E6E4-F339-8C08-04BBEC39202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7" creationId="{7A92C428-662D-B157-44CE-1E1F63AEBFD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8" creationId="{7AD8FEB6-C653-EB80-852E-6EBA5F6B86D9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79" creationId="{B210DD91-A725-84D6-0A53-B47277B8020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80" creationId="{E37C60F6-4DC7-7E81-FB9D-DF604E026E17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281" creationId="{76EE3191-54DF-3C60-3377-62FB9D8C85AC}"/>
          </ac:spMkLst>
        </pc:spChg>
        <pc:spChg chg="del mod topLvl">
          <ac:chgData name="Dominik Aumann" userId="013c187a20e8f01a" providerId="LiveId" clId="{ECAA7777-180A-4B5D-8194-D34F96268794}" dt="2024-02-25T22:56:14.780" v="98" actId="478"/>
          <ac:spMkLst>
            <pc:docMk/>
            <pc:sldMk cId="2080604651" sldId="260"/>
            <ac:spMk id="298" creationId="{3023BF00-E196-798F-D9A2-2029B6C36FA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04" creationId="{3FFCAE77-D3AF-A3FA-5B0C-0CB3EF6AFC35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05" creationId="{D8E84565-E841-D5F6-D44F-0AC396DF7D8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07" creationId="{F9E7F699-6A10-E826-FEDE-0549F24FC3D0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308" creationId="{B3DBF8CB-D38F-60CD-D963-20AAE3636BCA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309" creationId="{4430A9A0-338E-D6B3-C7A8-72872BEBAAE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0" creationId="{11E3E2BA-F208-1B4B-CE51-F0B85587E46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1" creationId="{4ED32AE9-F69C-0FFD-4FB1-E46683224CC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2" creationId="{5D5A07D5-96CE-CBA3-8A57-DD1E3AEC36C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3" creationId="{5BAD791D-0A74-61BE-B55E-0E930510C4F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4" creationId="{4BF6ED26-97F5-3FAB-EADB-2E744CB51995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5" creationId="{F85B05EA-A88F-6AC4-0432-70199A6B622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6" creationId="{C7FE6576-F1F1-CA9F-9AF1-C2A27C8D6B21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7" creationId="{4CF6C694-EF25-FD73-D28E-955C2FE32DE9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318" creationId="{CD6B0239-675A-A6E2-0734-503AE5338AED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319" creationId="{7D1E409C-488E-99F9-2171-27521D2B3C3F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24" creationId="{5EF5474E-EAC9-F447-B24B-E8066E76B90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25" creationId="{179AFAB3-F173-DB47-2FDA-C2EEA4B71098}"/>
          </ac:spMkLst>
        </pc:spChg>
        <pc:spChg chg="del mod topLvl">
          <ac:chgData name="Dominik Aumann" userId="013c187a20e8f01a" providerId="LiveId" clId="{ECAA7777-180A-4B5D-8194-D34F96268794}" dt="2024-02-25T22:56:38.962" v="102" actId="478"/>
          <ac:spMkLst>
            <pc:docMk/>
            <pc:sldMk cId="2080604651" sldId="260"/>
            <ac:spMk id="1026" creationId="{B8A71972-8690-BAC9-30FB-34FD818013F0}"/>
          </ac:spMkLst>
        </pc:spChg>
        <pc:spChg chg="del mod topLvl">
          <ac:chgData name="Dominik Aumann" userId="013c187a20e8f01a" providerId="LiveId" clId="{ECAA7777-180A-4B5D-8194-D34F96268794}" dt="2024-02-25T22:56:38.962" v="102" actId="478"/>
          <ac:spMkLst>
            <pc:docMk/>
            <pc:sldMk cId="2080604651" sldId="260"/>
            <ac:spMk id="1031" creationId="{2FD4EC72-F968-56E2-2DFB-28E53CA3BE20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38" creationId="{130D8F73-1752-5EFB-2D6B-253388B6EAA5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39" creationId="{F49463AA-FDAA-89DE-A874-1A4CFC8EAE5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1" creationId="{0196F1CC-0199-0780-24E8-F7399B24D252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42" creationId="{AAA1F28D-8134-CE1B-865A-608F1B22D1F3}"/>
          </ac:spMkLst>
        </pc:spChg>
        <pc:spChg chg="del mod topLvl">
          <ac:chgData name="Dominik Aumann" userId="013c187a20e8f01a" providerId="LiveId" clId="{ECAA7777-180A-4B5D-8194-D34F96268794}" dt="2024-02-25T22:55:36.211" v="95" actId="478"/>
          <ac:spMkLst>
            <pc:docMk/>
            <pc:sldMk cId="2080604651" sldId="260"/>
            <ac:spMk id="1043" creationId="{7BE6116D-4852-BD7A-D788-6DC20EF65CC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4" creationId="{42AF30E7-F31D-FD5E-EE01-E4026488EDF8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5" creationId="{42763ABB-B222-F663-BBF5-594ECD7695FA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6" creationId="{2D8E1F0D-5248-6018-1F52-1D007AB4F4AF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7" creationId="{03EA5C65-1522-8C0F-E4EB-E70CC4D1C73D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8" creationId="{DA26ED67-C1DB-4911-32D1-4A73C2285AE8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49" creationId="{3FE51211-9034-BDEA-7450-2E334F17B51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50" creationId="{56AB3D6F-2C73-EF9D-C34D-72CF0F074138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51" creationId="{A282A5A7-1CC3-493B-43BB-0647C61702FD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52" creationId="{708F623F-B6DF-2CBB-5627-B5B221DCDA7A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53" creationId="{F19222F7-9854-FF10-F358-2BBF76A031D8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57" creationId="{FBFEC080-6869-A10F-A480-78822051D663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060" creationId="{1B083E91-C9BA-CB3E-45BB-65A04FCD515E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63" creationId="{1C5D5332-1989-D44D-AF9A-8CEAE2970FFA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64" creationId="{D1036944-3CCD-486E-7A44-5C6B44A82E0A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66" creationId="{169F43CB-E4DB-88A8-C302-E908EBB1FEFC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67" creationId="{204BC8B5-DFCA-437F-D8A4-39A5D3CB454F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68" creationId="{94D115E4-D4D3-FAC5-1418-A14C088F927A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69" creationId="{2CF4F75C-8E97-4276-5276-37F449A5DCA5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0" creationId="{A94F96A9-AD77-F86C-FDC1-41A6CE0300FC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1" creationId="{F8B20533-3B5D-68DC-8C44-C5228B77FF8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2" creationId="{2596FD70-F91A-AD0D-A764-08EB194C9209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3" creationId="{F4AC8F15-2956-79A8-08CF-61FCD2B18443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4" creationId="{74A737D8-56E0-9A2B-CFD5-D6339375DE0F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5" creationId="{12A36279-10FB-8CC7-4935-30DAADDA60A0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6" creationId="{D63620FC-21B6-B506-F83F-09139C61AB39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77" creationId="{EB6C514D-419D-7BAF-0F83-09ADF9F1E47B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78" creationId="{00F09AE0-B348-090B-974B-5ADAFA2EF320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82" creationId="{EDA7FB08-BE87-B250-9DD0-C82C8A440AFC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083" creationId="{2CE85145-1308-C7FA-637D-8C9F519FBEE2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085" creationId="{1C1B2B72-4184-421F-4206-B87A8ABEE66F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086" creationId="{F83CCE53-543A-1F99-D0B2-F210F8BB0EF4}"/>
          </ac:spMkLst>
        </pc:spChg>
        <pc:spChg chg="add mod">
          <ac:chgData name="Dominik Aumann" userId="013c187a20e8f01a" providerId="LiveId" clId="{ECAA7777-180A-4B5D-8194-D34F96268794}" dt="2024-02-25T23:04:46.317" v="269" actId="164"/>
          <ac:spMkLst>
            <pc:docMk/>
            <pc:sldMk cId="2080604651" sldId="260"/>
            <ac:spMk id="1087" creationId="{62CB5969-3156-308B-5355-788F68652618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091" creationId="{A341EACA-2250-04FF-BA97-D2E88D1F59D1}"/>
          </ac:spMkLst>
        </pc:spChg>
        <pc:spChg chg="del mod topLvl">
          <ac:chgData name="Dominik Aumann" userId="013c187a20e8f01a" providerId="LiveId" clId="{ECAA7777-180A-4B5D-8194-D34F96268794}" dt="2024-02-25T23:26:24.693" v="571" actId="478"/>
          <ac:spMkLst>
            <pc:docMk/>
            <pc:sldMk cId="2080604651" sldId="260"/>
            <ac:spMk id="1092" creationId="{BA7F16E4-6441-C5C0-C374-DD2527D2E257}"/>
          </ac:spMkLst>
        </pc:spChg>
        <pc:spChg chg="del mod topLvl">
          <ac:chgData name="Dominik Aumann" userId="013c187a20e8f01a" providerId="LiveId" clId="{ECAA7777-180A-4B5D-8194-D34F96268794}" dt="2024-02-25T23:26:32.050" v="577" actId="478"/>
          <ac:spMkLst>
            <pc:docMk/>
            <pc:sldMk cId="2080604651" sldId="260"/>
            <ac:spMk id="1094" creationId="{B38E3D09-A1F4-9012-5AF8-B3D0D00FD4CE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97" creationId="{7CD85EE0-AF7C-2DFC-7708-50DF87104C02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098" creationId="{A272A752-8B4C-6149-6CEC-CF7564EF3AA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0" creationId="{0F2CCF47-FA7E-1BDD-FAAA-DBD49B3B639E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101" creationId="{C5D41F64-14D1-6662-3C22-A00501355696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102" creationId="{59EB9277-C795-F7FC-9F83-04B10025C758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3" creationId="{E44C2EAB-A5B7-8384-3446-AA0B17FD450F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4" creationId="{4AFBE7FA-2FBE-E21E-E530-5C63296EBB17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5" creationId="{DB781014-F516-2D76-6C52-92A0A266E62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6" creationId="{82FC73A1-DF39-FEE1-66F7-BC372A64FE14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7" creationId="{E92C04B2-B451-22F6-6F99-C80DE968B156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8" creationId="{DC0CA4FE-AF9F-AC9B-3E58-D7100C5FD967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09" creationId="{9A31CD27-5542-1A4D-3B3E-67B310DAD9BD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10" creationId="{01883266-197D-C203-4201-1382A8BB7F1B}"/>
          </ac:spMkLst>
        </pc:spChg>
        <pc:spChg chg="del mod topLv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11" creationId="{3EE97462-74B0-44DC-3E81-761F4D370A5B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112" creationId="{E23C2B3A-178E-7B7A-E36B-2C0E69CC5A53}"/>
          </ac:spMkLst>
        </pc:spChg>
        <pc:spChg chg="del mod topLvl">
          <ac:chgData name="Dominik Aumann" userId="013c187a20e8f01a" providerId="LiveId" clId="{ECAA7777-180A-4B5D-8194-D34F96268794}" dt="2024-02-25T22:56:13.343" v="97" actId="478"/>
          <ac:spMkLst>
            <pc:docMk/>
            <pc:sldMk cId="2080604651" sldId="260"/>
            <ac:spMk id="1116" creationId="{BB9E0902-91EB-38E4-084A-71A74753FE82}"/>
          </ac:spMkLst>
        </pc:spChg>
        <pc:spChg chg="del mod topLvl">
          <ac:chgData name="Dominik Aumann" userId="013c187a20e8f01a" providerId="LiveId" clId="{ECAA7777-180A-4B5D-8194-D34F96268794}" dt="2024-02-25T23:26:24.693" v="571" actId="478"/>
          <ac:spMkLst>
            <pc:docMk/>
            <pc:sldMk cId="2080604651" sldId="260"/>
            <ac:spMk id="1117" creationId="{1CB32AA8-DD2E-2178-6B52-0366F27E5BC5}"/>
          </ac:spMkLst>
        </pc:spChg>
        <pc:spChg chg="del">
          <ac:chgData name="Dominik Aumann" userId="013c187a20e8f01a" providerId="LiveId" clId="{ECAA7777-180A-4B5D-8194-D34F96268794}" dt="2024-02-25T22:52:58.659" v="75" actId="21"/>
          <ac:spMkLst>
            <pc:docMk/>
            <pc:sldMk cId="2080604651" sldId="260"/>
            <ac:spMk id="1118" creationId="{C65C8D0D-8EAB-40F6-6A0E-D2AA3E4BF353}"/>
          </ac:spMkLst>
        </pc:spChg>
        <pc:grpChg chg="add del mod">
          <ac:chgData name="Dominik Aumann" userId="013c187a20e8f01a" providerId="LiveId" clId="{ECAA7777-180A-4B5D-8194-D34F96268794}" dt="2024-02-25T23:22:54.039" v="515" actId="478"/>
          <ac:grpSpMkLst>
            <pc:docMk/>
            <pc:sldMk cId="2080604651" sldId="260"/>
            <ac:grpSpMk id="206" creationId="{5C327AED-5C2C-4824-B873-0107FB58ED5F}"/>
          </ac:grpSpMkLst>
        </pc:grpChg>
        <pc:grpChg chg="add del mod">
          <ac:chgData name="Dominik Aumann" userId="013c187a20e8f01a" providerId="LiveId" clId="{ECAA7777-180A-4B5D-8194-D34F96268794}" dt="2024-02-25T23:23:24.594" v="527" actId="165"/>
          <ac:grpSpMkLst>
            <pc:docMk/>
            <pc:sldMk cId="2080604651" sldId="260"/>
            <ac:grpSpMk id="212" creationId="{5BEF77E6-3615-3E87-A887-11340769EC17}"/>
          </ac:grpSpMkLst>
        </pc:grpChg>
        <pc:grpChg chg="del mod topLvl">
          <ac:chgData name="Dominik Aumann" userId="013c187a20e8f01a" providerId="LiveId" clId="{ECAA7777-180A-4B5D-8194-D34F96268794}" dt="2024-02-25T23:23:36.951" v="529" actId="165"/>
          <ac:grpSpMkLst>
            <pc:docMk/>
            <pc:sldMk cId="2080604651" sldId="260"/>
            <ac:grpSpMk id="215" creationId="{D8E12AF3-F3DE-EF2B-19AD-EC43F647D70F}"/>
          </ac:grpSpMkLst>
        </pc:grpChg>
        <pc:grpChg chg="add del mod">
          <ac:chgData name="Dominik Aumann" userId="013c187a20e8f01a" providerId="LiveId" clId="{ECAA7777-180A-4B5D-8194-D34F96268794}" dt="2024-02-25T23:26:21.443" v="570" actId="165"/>
          <ac:grpSpMkLst>
            <pc:docMk/>
            <pc:sldMk cId="2080604651" sldId="260"/>
            <ac:grpSpMk id="235" creationId="{92641EC7-F2A0-4D98-BCF2-86A714CCABAF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300" creationId="{E6FD8D80-4C90-3D01-5759-471FE0D6C944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1033" creationId="{D68B5DBA-3C45-FE72-7FAC-80CB9CDDAA58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1034" creationId="{620E42B3-2EB7-5A09-AA9F-5EE8AC1176F5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1059" creationId="{555A220F-DA05-AE3E-B775-C41BBD457DCE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1084" creationId="{FB4B690E-BABB-DB54-7ED4-FAC9AE4A1E12}"/>
          </ac:grpSpMkLst>
        </pc:grpChg>
        <pc:grpChg chg="del">
          <ac:chgData name="Dominik Aumann" userId="013c187a20e8f01a" providerId="LiveId" clId="{ECAA7777-180A-4B5D-8194-D34F96268794}" dt="2024-02-25T22:51:36.522" v="72" actId="165"/>
          <ac:grpSpMkLst>
            <pc:docMk/>
            <pc:sldMk cId="2080604651" sldId="260"/>
            <ac:grpSpMk id="1093" creationId="{CE74B283-A23C-1154-1222-1363EEF65D93}"/>
          </ac:grpSpMkLst>
        </pc:grpChg>
        <pc:picChg chg="add mod">
          <ac:chgData name="Dominik Aumann" userId="013c187a20e8f01a" providerId="LiveId" clId="{ECAA7777-180A-4B5D-8194-D34F96268794}" dt="2024-02-25T22:52:28.619" v="74" actId="571"/>
          <ac:picMkLst>
            <pc:docMk/>
            <pc:sldMk cId="2080604651" sldId="260"/>
            <ac:picMk id="2" creationId="{EA4FBACC-7FB7-D697-EF9F-553AD9F8DFC8}"/>
          </ac:picMkLst>
        </pc:picChg>
        <pc:picChg chg="add mod">
          <ac:chgData name="Dominik Aumann" userId="013c187a20e8f01a" providerId="LiveId" clId="{ECAA7777-180A-4B5D-8194-D34F96268794}" dt="2024-02-25T22:52:28.619" v="74" actId="571"/>
          <ac:picMkLst>
            <pc:docMk/>
            <pc:sldMk cId="2080604651" sldId="260"/>
            <ac:picMk id="3" creationId="{B0C9E3D7-793A-0C7E-8C07-F39479368DD0}"/>
          </ac:picMkLst>
        </pc:picChg>
        <pc:picChg chg="del">
          <ac:chgData name="Dominik Aumann" userId="013c187a20e8f01a" providerId="LiveId" clId="{ECAA7777-180A-4B5D-8194-D34F96268794}" dt="2024-02-25T22:47:54.480" v="15" actId="478"/>
          <ac:picMkLst>
            <pc:docMk/>
            <pc:sldMk cId="2080604651" sldId="260"/>
            <ac:picMk id="56" creationId="{D43192BA-1B99-7118-AB93-DB815AAF05CF}"/>
          </ac:picMkLst>
        </pc:picChg>
        <pc:picChg chg="del">
          <ac:chgData name="Dominik Aumann" userId="013c187a20e8f01a" providerId="LiveId" clId="{ECAA7777-180A-4B5D-8194-D34F96268794}" dt="2024-02-25T22:52:58.659" v="75" actId="21"/>
          <ac:picMkLst>
            <pc:docMk/>
            <pc:sldMk cId="2080604651" sldId="260"/>
            <ac:picMk id="150" creationId="{70D1B608-9DA7-F92C-75D3-24BD99F409E4}"/>
          </ac:picMkLst>
        </pc:picChg>
        <pc:picChg chg="del">
          <ac:chgData name="Dominik Aumann" userId="013c187a20e8f01a" providerId="LiveId" clId="{ECAA7777-180A-4B5D-8194-D34F96268794}" dt="2024-02-25T22:52:58.659" v="75" actId="21"/>
          <ac:picMkLst>
            <pc:docMk/>
            <pc:sldMk cId="2080604651" sldId="260"/>
            <ac:picMk id="151" creationId="{02EB1210-5173-B657-C543-9E7E1EAE9430}"/>
          </ac:picMkLst>
        </pc:picChg>
        <pc:picChg chg="add del mod">
          <ac:chgData name="Dominik Aumann" userId="013c187a20e8f01a" providerId="LiveId" clId="{ECAA7777-180A-4B5D-8194-D34F96268794}" dt="2024-02-25T23:25:23.348" v="559" actId="21"/>
          <ac:picMkLst>
            <pc:docMk/>
            <pc:sldMk cId="2080604651" sldId="260"/>
            <ac:picMk id="208" creationId="{B52362AE-8722-FB33-4C2F-62A5B8DCF245}"/>
          </ac:picMkLst>
        </pc:picChg>
        <pc:picChg chg="add del mod">
          <ac:chgData name="Dominik Aumann" userId="013c187a20e8f01a" providerId="LiveId" clId="{ECAA7777-180A-4B5D-8194-D34F96268794}" dt="2024-02-25T23:24:33.453" v="545" actId="21"/>
          <ac:picMkLst>
            <pc:docMk/>
            <pc:sldMk cId="2080604651" sldId="260"/>
            <ac:picMk id="211" creationId="{D35E74EF-8253-0263-64FA-160A666451CC}"/>
          </ac:picMkLst>
        </pc:picChg>
        <pc:picChg chg="del mod topLvl">
          <ac:chgData name="Dominik Aumann" userId="013c187a20e8f01a" providerId="LiveId" clId="{ECAA7777-180A-4B5D-8194-D34F96268794}" dt="2024-02-25T23:26:14.523" v="568" actId="478"/>
          <ac:picMkLst>
            <pc:docMk/>
            <pc:sldMk cId="2080604651" sldId="260"/>
            <ac:picMk id="213" creationId="{297DF1E8-3C47-F61A-CF00-74AB5A4C724A}"/>
          </ac:picMkLst>
        </pc:picChg>
        <pc:picChg chg="del mod ord topLvl">
          <ac:chgData name="Dominik Aumann" userId="013c187a20e8f01a" providerId="LiveId" clId="{ECAA7777-180A-4B5D-8194-D34F96268794}" dt="2024-02-25T23:24:54.980" v="551" actId="478"/>
          <ac:picMkLst>
            <pc:docMk/>
            <pc:sldMk cId="2080604651" sldId="260"/>
            <ac:picMk id="214" creationId="{B5A50A1F-A508-7ACE-2E36-34D12B6C4D31}"/>
          </ac:picMkLst>
        </pc:picChg>
        <pc:picChg chg="del mod topLvl">
          <ac:chgData name="Dominik Aumann" userId="013c187a20e8f01a" providerId="LiveId" clId="{ECAA7777-180A-4B5D-8194-D34F96268794}" dt="2024-02-25T23:26:32.050" v="577" actId="478"/>
          <ac:picMkLst>
            <pc:docMk/>
            <pc:sldMk cId="2080604651" sldId="260"/>
            <ac:picMk id="236" creationId="{F833A8F1-2DBB-1F6F-66D5-4B5AA3A2B0EB}"/>
          </ac:picMkLst>
        </pc:picChg>
        <pc:picChg chg="del mod topLvl">
          <ac:chgData name="Dominik Aumann" userId="013c187a20e8f01a" providerId="LiveId" clId="{ECAA7777-180A-4B5D-8194-D34F96268794}" dt="2024-02-25T23:26:32.050" v="577" actId="478"/>
          <ac:picMkLst>
            <pc:docMk/>
            <pc:sldMk cId="2080604651" sldId="260"/>
            <ac:picMk id="237" creationId="{2F21075A-B76D-99F1-E383-6591C09E7239}"/>
          </ac:picMkLst>
        </pc:picChg>
        <pc:picChg chg="del mod topLvl">
          <ac:chgData name="Dominik Aumann" userId="013c187a20e8f01a" providerId="LiveId" clId="{ECAA7777-180A-4B5D-8194-D34F96268794}" dt="2024-02-25T23:26:32.050" v="577" actId="478"/>
          <ac:picMkLst>
            <pc:docMk/>
            <pc:sldMk cId="2080604651" sldId="260"/>
            <ac:picMk id="238" creationId="{28C5C08E-80B1-4152-75B2-AA051FA643BE}"/>
          </ac:picMkLst>
        </pc:picChg>
        <pc:picChg chg="del mod topLvl">
          <ac:chgData name="Dominik Aumann" userId="013c187a20e8f01a" providerId="LiveId" clId="{ECAA7777-180A-4B5D-8194-D34F96268794}" dt="2024-02-25T23:26:32.050" v="577" actId="478"/>
          <ac:picMkLst>
            <pc:docMk/>
            <pc:sldMk cId="2080604651" sldId="260"/>
            <ac:picMk id="239" creationId="{079D87EF-4B98-F37A-1086-CC77AC4CF983}"/>
          </ac:picMkLst>
        </pc:picChg>
        <pc:picChg chg="add del mod">
          <ac:chgData name="Dominik Aumann" userId="013c187a20e8f01a" providerId="LiveId" clId="{ECAA7777-180A-4B5D-8194-D34F96268794}" dt="2024-02-25T23:37:53.380" v="732" actId="21"/>
          <ac:picMkLst>
            <pc:docMk/>
            <pc:sldMk cId="2080604651" sldId="260"/>
            <ac:picMk id="256" creationId="{4FE48B4E-2ED1-F9D1-4E5E-EADBE8E13C4D}"/>
          </ac:picMkLst>
        </pc:picChg>
        <pc:picChg chg="add del mod">
          <ac:chgData name="Dominik Aumann" userId="013c187a20e8f01a" providerId="LiveId" clId="{ECAA7777-180A-4B5D-8194-D34F96268794}" dt="2024-02-25T23:39:36.371" v="760" actId="21"/>
          <ac:picMkLst>
            <pc:docMk/>
            <pc:sldMk cId="2080604651" sldId="260"/>
            <ac:picMk id="258" creationId="{9BD1702C-7DFF-9770-E074-D684323892B8}"/>
          </ac:picMkLst>
        </pc:picChg>
        <pc:picChg chg="add del mod">
          <ac:chgData name="Dominik Aumann" userId="013c187a20e8f01a" providerId="LiveId" clId="{ECAA7777-180A-4B5D-8194-D34F96268794}" dt="2024-02-25T23:39:22.359" v="755" actId="21"/>
          <ac:picMkLst>
            <pc:docMk/>
            <pc:sldMk cId="2080604651" sldId="260"/>
            <ac:picMk id="260" creationId="{FE9CD3A0-7755-E042-5E67-846B46E439B2}"/>
          </ac:picMkLst>
        </pc:picChg>
        <pc:picChg chg="add del mod">
          <ac:chgData name="Dominik Aumann" userId="013c187a20e8f01a" providerId="LiveId" clId="{ECAA7777-180A-4B5D-8194-D34F96268794}" dt="2024-02-25T23:37:20.654" v="723" actId="21"/>
          <ac:picMkLst>
            <pc:docMk/>
            <pc:sldMk cId="2080604651" sldId="260"/>
            <ac:picMk id="283" creationId="{4FE48B4E-2ED1-F9D1-4E5E-EADBE8E13C4D}"/>
          </ac:picMkLst>
        </pc:picChg>
        <pc:picChg chg="add del">
          <ac:chgData name="Dominik Aumann" userId="013c187a20e8f01a" providerId="LiveId" clId="{ECAA7777-180A-4B5D-8194-D34F96268794}" dt="2024-02-25T22:50:48.768" v="68" actId="478"/>
          <ac:picMkLst>
            <pc:docMk/>
            <pc:sldMk cId="2080604651" sldId="260"/>
            <ac:picMk id="302" creationId="{B9C1499C-9E03-6583-6558-300A2EC4B1F7}"/>
          </ac:picMkLst>
        </pc:picChg>
        <pc:picChg chg="del">
          <ac:chgData name="Dominik Aumann" userId="013c187a20e8f01a" providerId="LiveId" clId="{ECAA7777-180A-4B5D-8194-D34F96268794}" dt="2024-02-25T22:48:09.805" v="24" actId="478"/>
          <ac:picMkLst>
            <pc:docMk/>
            <pc:sldMk cId="2080604651" sldId="260"/>
            <ac:picMk id="303" creationId="{F6C39F6A-EEF8-7D99-4574-ECAED9501B40}"/>
          </ac:picMkLst>
        </pc:picChg>
        <pc:picChg chg="add mod">
          <ac:chgData name="Dominik Aumann" userId="013c187a20e8f01a" providerId="LiveId" clId="{ECAA7777-180A-4B5D-8194-D34F96268794}" dt="2024-02-25T23:04:46.317" v="269" actId="164"/>
          <ac:picMkLst>
            <pc:docMk/>
            <pc:sldMk cId="2080604651" sldId="260"/>
            <ac:picMk id="1027" creationId="{3F153EFE-7163-C888-9AD6-0340FFB5247C}"/>
          </ac:picMkLst>
        </pc:picChg>
        <pc:picChg chg="add mod">
          <ac:chgData name="Dominik Aumann" userId="013c187a20e8f01a" providerId="LiveId" clId="{ECAA7777-180A-4B5D-8194-D34F96268794}" dt="2024-02-25T23:04:46.317" v="269" actId="164"/>
          <ac:picMkLst>
            <pc:docMk/>
            <pc:sldMk cId="2080604651" sldId="260"/>
            <ac:picMk id="1032" creationId="{7D0B33F8-E601-A95E-11A0-EAA7530E5BD6}"/>
          </ac:picMkLst>
        </pc:picChg>
        <pc:picChg chg="add mod">
          <ac:chgData name="Dominik Aumann" userId="013c187a20e8f01a" providerId="LiveId" clId="{ECAA7777-180A-4B5D-8194-D34F96268794}" dt="2024-02-25T23:04:46.317" v="269" actId="164"/>
          <ac:picMkLst>
            <pc:docMk/>
            <pc:sldMk cId="2080604651" sldId="260"/>
            <ac:picMk id="1035" creationId="{308B920F-1DCA-95D2-C0B4-670DA40C8BAB}"/>
          </ac:picMkLst>
        </pc:picChg>
        <pc:picChg chg="add del">
          <ac:chgData name="Dominik Aumann" userId="013c187a20e8f01a" providerId="LiveId" clId="{ECAA7777-180A-4B5D-8194-D34F96268794}" dt="2024-02-25T22:50:46.518" v="67" actId="478"/>
          <ac:picMkLst>
            <pc:docMk/>
            <pc:sldMk cId="2080604651" sldId="260"/>
            <ac:picMk id="1036" creationId="{1015C73A-18F4-FB38-2180-BF7A20278454}"/>
          </ac:picMkLst>
        </pc:picChg>
        <pc:picChg chg="del">
          <ac:chgData name="Dominik Aumann" userId="013c187a20e8f01a" providerId="LiveId" clId="{ECAA7777-180A-4B5D-8194-D34F96268794}" dt="2024-02-25T22:47:55.980" v="16" actId="478"/>
          <ac:picMkLst>
            <pc:docMk/>
            <pc:sldMk cId="2080604651" sldId="260"/>
            <ac:picMk id="1037" creationId="{9EE9C492-984E-C405-F102-764DE8F228C9}"/>
          </ac:picMkLst>
        </pc:picChg>
        <pc:picChg chg="add mod">
          <ac:chgData name="Dominik Aumann" userId="013c187a20e8f01a" providerId="LiveId" clId="{ECAA7777-180A-4B5D-8194-D34F96268794}" dt="2024-02-25T23:04:46.317" v="269" actId="164"/>
          <ac:picMkLst>
            <pc:docMk/>
            <pc:sldMk cId="2080604651" sldId="260"/>
            <ac:picMk id="1058" creationId="{52724769-B63E-85AB-2105-A0C36FD6DC24}"/>
          </ac:picMkLst>
        </pc:picChg>
        <pc:picChg chg="del">
          <ac:chgData name="Dominik Aumann" userId="013c187a20e8f01a" providerId="LiveId" clId="{ECAA7777-180A-4B5D-8194-D34F96268794}" dt="2024-02-25T22:48:01.682" v="19" actId="478"/>
          <ac:picMkLst>
            <pc:docMk/>
            <pc:sldMk cId="2080604651" sldId="260"/>
            <ac:picMk id="1061" creationId="{7CAD64AA-B1EA-25DB-2CEC-32B0EC36CDC6}"/>
          </ac:picMkLst>
        </pc:picChg>
        <pc:picChg chg="del">
          <ac:chgData name="Dominik Aumann" userId="013c187a20e8f01a" providerId="LiveId" clId="{ECAA7777-180A-4B5D-8194-D34F96268794}" dt="2024-02-25T22:48:03.400" v="20" actId="478"/>
          <ac:picMkLst>
            <pc:docMk/>
            <pc:sldMk cId="2080604651" sldId="260"/>
            <ac:picMk id="1062" creationId="{241FFC1F-C8C2-7209-E953-9E1B087187D3}"/>
          </ac:picMkLst>
        </pc:picChg>
        <pc:picChg chg="del">
          <ac:chgData name="Dominik Aumann" userId="013c187a20e8f01a" providerId="LiveId" clId="{ECAA7777-180A-4B5D-8194-D34F96268794}" dt="2024-02-25T22:48:06.524" v="22" actId="478"/>
          <ac:picMkLst>
            <pc:docMk/>
            <pc:sldMk cId="2080604651" sldId="260"/>
            <ac:picMk id="1095" creationId="{7DF87D7F-D42B-0397-136D-F4927C6011CD}"/>
          </ac:picMkLst>
        </pc:picChg>
        <pc:picChg chg="del">
          <ac:chgData name="Dominik Aumann" userId="013c187a20e8f01a" providerId="LiveId" clId="{ECAA7777-180A-4B5D-8194-D34F96268794}" dt="2024-02-25T22:48:07.930" v="23" actId="478"/>
          <ac:picMkLst>
            <pc:docMk/>
            <pc:sldMk cId="2080604651" sldId="260"/>
            <ac:picMk id="1096" creationId="{0B8B7640-AF39-E589-BFDD-E30BD244727E}"/>
          </ac:picMkLst>
        </pc:picChg>
        <pc:picChg chg="add del mod">
          <ac:chgData name="Dominik Aumann" userId="013c187a20e8f01a" providerId="LiveId" clId="{ECAA7777-180A-4B5D-8194-D34F96268794}" dt="2024-02-25T23:31:26.974" v="640" actId="478"/>
          <ac:picMkLst>
            <pc:docMk/>
            <pc:sldMk cId="2080604651" sldId="260"/>
            <ac:picMk id="1119" creationId="{97C0FCAC-31B2-38AB-432F-5930C86D800D}"/>
          </ac:picMkLst>
        </pc:picChg>
        <pc:picChg chg="add del mod">
          <ac:chgData name="Dominik Aumann" userId="013c187a20e8f01a" providerId="LiveId" clId="{ECAA7777-180A-4B5D-8194-D34F96268794}" dt="2024-02-25T23:31:26.974" v="640" actId="478"/>
          <ac:picMkLst>
            <pc:docMk/>
            <pc:sldMk cId="2080604651" sldId="260"/>
            <ac:picMk id="1120" creationId="{E5D5E6AF-2EA6-DB34-1190-9512AB02B808}"/>
          </ac:picMkLst>
        </pc:picChg>
        <pc:picChg chg="del">
          <ac:chgData name="Dominik Aumann" userId="013c187a20e8f01a" providerId="LiveId" clId="{ECAA7777-180A-4B5D-8194-D34F96268794}" dt="2024-02-25T22:47:59.604" v="18" actId="478"/>
          <ac:picMkLst>
            <pc:docMk/>
            <pc:sldMk cId="2080604651" sldId="260"/>
            <ac:picMk id="1121" creationId="{29341C86-B58F-F89B-EE58-EB85B314E2FD}"/>
          </ac:picMkLst>
        </pc:picChg>
        <pc:picChg chg="add del">
          <ac:chgData name="Dominik Aumann" userId="013c187a20e8f01a" providerId="LiveId" clId="{ECAA7777-180A-4B5D-8194-D34F96268794}" dt="2024-02-25T22:50:43.671" v="66" actId="478"/>
          <ac:picMkLst>
            <pc:docMk/>
            <pc:sldMk cId="2080604651" sldId="260"/>
            <ac:picMk id="1122" creationId="{D2E20614-1268-EB73-49C6-890EEFCAD9F8}"/>
          </ac:picMkLst>
        </pc:picChg>
        <pc:picChg chg="add del mod">
          <ac:chgData name="Dominik Aumann" userId="013c187a20e8f01a" providerId="LiveId" clId="{ECAA7777-180A-4B5D-8194-D34F96268794}" dt="2024-02-25T23:28:12.176" v="598" actId="21"/>
          <ac:picMkLst>
            <pc:docMk/>
            <pc:sldMk cId="2080604651" sldId="260"/>
            <ac:picMk id="1124" creationId="{EBA584F0-2152-C0A6-6BF8-DE3BC8AF11A5}"/>
          </ac:picMkLst>
        </pc:picChg>
        <pc:picChg chg="del">
          <ac:chgData name="Dominik Aumann" userId="013c187a20e8f01a" providerId="LiveId" clId="{ECAA7777-180A-4B5D-8194-D34F96268794}" dt="2024-02-25T22:48:04.556" v="21" actId="478"/>
          <ac:picMkLst>
            <pc:docMk/>
            <pc:sldMk cId="2080604651" sldId="260"/>
            <ac:picMk id="1126" creationId="{0E304E12-A2B6-7627-CA26-9907F58AF008}"/>
          </ac:picMkLst>
        </pc:picChg>
        <pc:picChg chg="add del mod">
          <ac:chgData name="Dominik Aumann" userId="013c187a20e8f01a" providerId="LiveId" clId="{ECAA7777-180A-4B5D-8194-D34F96268794}" dt="2024-02-25T23:27:41.449" v="588" actId="21"/>
          <ac:picMkLst>
            <pc:docMk/>
            <pc:sldMk cId="2080604651" sldId="260"/>
            <ac:picMk id="1127" creationId="{D4911CF4-B249-45A2-6461-B83174A7EEDE}"/>
          </ac:picMkLst>
        </pc:picChg>
        <pc:picChg chg="add del mod">
          <ac:chgData name="Dominik Aumann" userId="013c187a20e8f01a" providerId="LiveId" clId="{ECAA7777-180A-4B5D-8194-D34F96268794}" dt="2024-02-25T23:31:31.864" v="642" actId="21"/>
          <ac:picMkLst>
            <pc:docMk/>
            <pc:sldMk cId="2080604651" sldId="260"/>
            <ac:picMk id="1128" creationId="{B107FDB0-BAA8-18EF-0A5E-CD646D0AA335}"/>
          </ac:picMkLst>
        </pc:picChg>
        <pc:picChg chg="add del mod">
          <ac:chgData name="Dominik Aumann" userId="013c187a20e8f01a" providerId="LiveId" clId="{ECAA7777-180A-4B5D-8194-D34F96268794}" dt="2024-02-25T23:32:42.207" v="664" actId="21"/>
          <ac:picMkLst>
            <pc:docMk/>
            <pc:sldMk cId="2080604651" sldId="260"/>
            <ac:picMk id="1129" creationId="{31D08368-05B5-8AAC-20B6-F3969148CCFB}"/>
          </ac:picMkLst>
        </pc:picChg>
        <pc:picChg chg="add mod">
          <ac:chgData name="Dominik Aumann" userId="013c187a20e8f01a" providerId="LiveId" clId="{ECAA7777-180A-4B5D-8194-D34F96268794}" dt="2024-02-25T23:31:17.195" v="635"/>
          <ac:picMkLst>
            <pc:docMk/>
            <pc:sldMk cId="2080604651" sldId="260"/>
            <ac:picMk id="1130" creationId="{BCF98992-4748-7771-3192-49CF96B82650}"/>
          </ac:picMkLst>
        </pc:picChg>
        <pc:picChg chg="add del mod">
          <ac:chgData name="Dominik Aumann" userId="013c187a20e8f01a" providerId="LiveId" clId="{ECAA7777-180A-4B5D-8194-D34F96268794}" dt="2024-02-25T23:32:20.649" v="658" actId="478"/>
          <ac:picMkLst>
            <pc:docMk/>
            <pc:sldMk cId="2080604651" sldId="260"/>
            <ac:picMk id="1131" creationId="{D02A10FF-6EFE-D473-5195-DB9A79D2CDDE}"/>
          </ac:picMkLst>
        </pc:picChg>
        <pc:picChg chg="add del mod">
          <ac:chgData name="Dominik Aumann" userId="013c187a20e8f01a" providerId="LiveId" clId="{ECAA7777-180A-4B5D-8194-D34F96268794}" dt="2024-02-25T23:33:07.482" v="667" actId="478"/>
          <ac:picMkLst>
            <pc:docMk/>
            <pc:sldMk cId="2080604651" sldId="260"/>
            <ac:picMk id="1132" creationId="{BCF98992-4748-7771-3192-49CF96B82650}"/>
          </ac:picMkLst>
        </pc:picChg>
        <pc:picChg chg="add del mod">
          <ac:chgData name="Dominik Aumann" userId="013c187a20e8f01a" providerId="LiveId" clId="{ECAA7777-180A-4B5D-8194-D34F96268794}" dt="2024-02-25T23:32:12.057" v="656" actId="21"/>
          <ac:picMkLst>
            <pc:docMk/>
            <pc:sldMk cId="2080604651" sldId="260"/>
            <ac:picMk id="1133" creationId="{B107FDB0-BAA8-18EF-0A5E-CD646D0AA335}"/>
          </ac:picMkLst>
        </pc:picChg>
        <pc:picChg chg="del">
          <ac:chgData name="Dominik Aumann" userId="013c187a20e8f01a" providerId="LiveId" clId="{ECAA7777-180A-4B5D-8194-D34F96268794}" dt="2024-02-25T22:47:51.528" v="14" actId="478"/>
          <ac:picMkLst>
            <pc:docMk/>
            <pc:sldMk cId="2080604651" sldId="260"/>
            <ac:picMk id="1134" creationId="{F92E059F-1FC9-F4FB-DF26-B3710458E569}"/>
          </ac:picMkLst>
        </pc:picChg>
        <pc:picChg chg="add del mod">
          <ac:chgData name="Dominik Aumann" userId="013c187a20e8f01a" providerId="LiveId" clId="{ECAA7777-180A-4B5D-8194-D34F96268794}" dt="2024-02-25T23:35:41.161" v="705" actId="478"/>
          <ac:picMkLst>
            <pc:docMk/>
            <pc:sldMk cId="2080604651" sldId="260"/>
            <ac:picMk id="1135" creationId="{FB554C28-E94A-6FAD-3E32-0F3DF8B9C563}"/>
          </ac:picMkLst>
        </pc:picChg>
        <pc:picChg chg="del">
          <ac:chgData name="Dominik Aumann" userId="013c187a20e8f01a" providerId="LiveId" clId="{ECAA7777-180A-4B5D-8194-D34F96268794}" dt="2024-02-25T22:47:57.261" v="17" actId="478"/>
          <ac:picMkLst>
            <pc:docMk/>
            <pc:sldMk cId="2080604651" sldId="260"/>
            <ac:picMk id="1136" creationId="{A410735D-9F0A-C0C2-94B5-4445F48BB523}"/>
          </ac:picMkLst>
        </pc:picChg>
        <pc:picChg chg="add del mod">
          <ac:chgData name="Dominik Aumann" userId="013c187a20e8f01a" providerId="LiveId" clId="{ECAA7777-180A-4B5D-8194-D34F96268794}" dt="2024-02-25T23:35:41.161" v="705" actId="478"/>
          <ac:picMkLst>
            <pc:docMk/>
            <pc:sldMk cId="2080604651" sldId="260"/>
            <ac:picMk id="1137" creationId="{400F9B8C-370A-5AC8-5E34-3FD2F4905495}"/>
          </ac:picMkLst>
        </pc:picChg>
        <pc:picChg chg="add del mod">
          <ac:chgData name="Dominik Aumann" userId="013c187a20e8f01a" providerId="LiveId" clId="{ECAA7777-180A-4B5D-8194-D34F96268794}" dt="2024-02-25T23:34:08.530" v="678" actId="478"/>
          <ac:picMkLst>
            <pc:docMk/>
            <pc:sldMk cId="2080604651" sldId="260"/>
            <ac:picMk id="1138" creationId="{50680350-2EC3-E123-C23A-3111ACF0D17B}"/>
          </ac:picMkLst>
        </pc:picChg>
        <pc:picChg chg="add del mod">
          <ac:chgData name="Dominik Aumann" userId="013c187a20e8f01a" providerId="LiveId" clId="{ECAA7777-180A-4B5D-8194-D34F96268794}" dt="2024-02-25T23:34:40.493" v="686" actId="478"/>
          <ac:picMkLst>
            <pc:docMk/>
            <pc:sldMk cId="2080604651" sldId="260"/>
            <ac:picMk id="1139" creationId="{FF55B0A7-7D62-CFE1-2475-06077F9E39F0}"/>
          </ac:picMkLst>
        </pc:picChg>
        <pc:picChg chg="add del mod">
          <ac:chgData name="Dominik Aumann" userId="013c187a20e8f01a" providerId="LiveId" clId="{ECAA7777-180A-4B5D-8194-D34F96268794}" dt="2024-02-25T23:33:54.955" v="676" actId="21"/>
          <ac:picMkLst>
            <pc:docMk/>
            <pc:sldMk cId="2080604651" sldId="260"/>
            <ac:picMk id="1140" creationId="{4B1BA9DB-B771-D880-4E8F-0C26DD9C757A}"/>
          </ac:picMkLst>
        </pc:picChg>
        <pc:picChg chg="add del mod">
          <ac:chgData name="Dominik Aumann" userId="013c187a20e8f01a" providerId="LiveId" clId="{ECAA7777-180A-4B5D-8194-D34F96268794}" dt="2024-02-25T23:34:34.525" v="684" actId="21"/>
          <ac:picMkLst>
            <pc:docMk/>
            <pc:sldMk cId="2080604651" sldId="260"/>
            <ac:picMk id="1141" creationId="{7936FDDC-FCFA-CA1C-5EF3-818F69D973CA}"/>
          </ac:picMkLst>
        </pc:picChg>
        <pc:picChg chg="add del mod">
          <ac:chgData name="Dominik Aumann" userId="013c187a20e8f01a" providerId="LiveId" clId="{ECAA7777-180A-4B5D-8194-D34F96268794}" dt="2024-02-25T23:35:26.774" v="702" actId="21"/>
          <ac:picMkLst>
            <pc:docMk/>
            <pc:sldMk cId="2080604651" sldId="260"/>
            <ac:picMk id="1143" creationId="{D939925E-C575-B8E4-7941-F21E64AB7CC0}"/>
          </ac:picMkLst>
        </pc:picChg>
        <pc:picChg chg="add del mod">
          <ac:chgData name="Dominik Aumann" userId="013c187a20e8f01a" providerId="LiveId" clId="{ECAA7777-180A-4B5D-8194-D34F96268794}" dt="2024-02-25T23:35:04.498" v="695" actId="21"/>
          <ac:picMkLst>
            <pc:docMk/>
            <pc:sldMk cId="2080604651" sldId="260"/>
            <ac:picMk id="1145" creationId="{8365D3CC-9537-8489-1E24-B46D895B134E}"/>
          </ac:picMkLst>
        </pc:picChg>
        <pc:picChg chg="add del mod">
          <ac:chgData name="Dominik Aumann" userId="013c187a20e8f01a" providerId="LiveId" clId="{ECAA7777-180A-4B5D-8194-D34F96268794}" dt="2024-02-25T23:38:54.350" v="743" actId="478"/>
          <ac:picMkLst>
            <pc:docMk/>
            <pc:sldMk cId="2080604651" sldId="260"/>
            <ac:picMk id="1146" creationId="{19397F73-5A57-0635-2E77-A2E7535ACD4F}"/>
          </ac:picMkLst>
        </pc:picChg>
        <pc:picChg chg="add del mod">
          <ac:chgData name="Dominik Aumann" userId="013c187a20e8f01a" providerId="LiveId" clId="{ECAA7777-180A-4B5D-8194-D34F96268794}" dt="2024-02-25T23:38:44.384" v="741" actId="21"/>
          <ac:picMkLst>
            <pc:docMk/>
            <pc:sldMk cId="2080604651" sldId="260"/>
            <ac:picMk id="1147" creationId="{F33F0FBE-EBB2-F96A-2B39-B3EB3D4EE4E3}"/>
          </ac:picMkLst>
        </pc:picChg>
        <pc:picChg chg="add del mod">
          <ac:chgData name="Dominik Aumann" userId="013c187a20e8f01a" providerId="LiveId" clId="{ECAA7777-180A-4B5D-8194-D34F96268794}" dt="2024-02-25T23:38:54.350" v="743" actId="478"/>
          <ac:picMkLst>
            <pc:docMk/>
            <pc:sldMk cId="2080604651" sldId="260"/>
            <ac:picMk id="1148" creationId="{38846134-33E2-23AB-1F0D-1D55E2ED2AC4}"/>
          </ac:picMkLst>
        </pc:picChg>
        <pc:picChg chg="add mod">
          <ac:chgData name="Dominik Aumann" userId="013c187a20e8f01a" providerId="LiveId" clId="{ECAA7777-180A-4B5D-8194-D34F96268794}" dt="2024-02-25T23:36:31.118" v="714"/>
          <ac:picMkLst>
            <pc:docMk/>
            <pc:sldMk cId="2080604651" sldId="260"/>
            <ac:picMk id="1149" creationId="{07444445-3D8C-11B1-4DAF-52CB8E571A8B}"/>
          </ac:picMkLst>
        </pc:picChg>
        <pc:picChg chg="add mod">
          <ac:chgData name="Dominik Aumann" userId="013c187a20e8f01a" providerId="LiveId" clId="{ECAA7777-180A-4B5D-8194-D34F96268794}" dt="2024-02-25T23:36:36.820" v="716"/>
          <ac:picMkLst>
            <pc:docMk/>
            <pc:sldMk cId="2080604651" sldId="260"/>
            <ac:picMk id="1150" creationId="{39FFF99A-0C44-8D49-8066-7977B06FD1C9}"/>
          </ac:picMkLst>
        </pc:picChg>
        <pc:picChg chg="add del mod">
          <ac:chgData name="Dominik Aumann" userId="013c187a20e8f01a" providerId="LiveId" clId="{ECAA7777-180A-4B5D-8194-D34F96268794}" dt="2024-02-25T23:37:50.615" v="730" actId="21"/>
          <ac:picMkLst>
            <pc:docMk/>
            <pc:sldMk cId="2080604651" sldId="260"/>
            <ac:picMk id="1151" creationId="{4FE48B4E-2ED1-F9D1-4E5E-EADBE8E13C4D}"/>
          </ac:picMkLst>
        </pc:pic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7" creationId="{4141702F-2B17-8E49-19F3-4746329EF3CD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8" creationId="{A95B0C47-CA34-F52B-058B-95805041C965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9" creationId="{5078F3B5-FADD-EF29-C1D0-242A9D19AA9C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23" creationId="{78408579-F23E-5162-0EF0-00034EF78AA6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37" creationId="{729349E1-F2CC-9913-63B3-9D876686BBBE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38" creationId="{7F77EA05-6268-38F2-81AF-0115D20ACD75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42" creationId="{38AA0C22-FD86-32E9-9134-9A8347C61C40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57" creationId="{DAE52E89-8ACF-C133-941C-3C851344B2F7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58" creationId="{9BCF4C1E-6E5F-7ED5-7E68-244C5065CC05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59" creationId="{51F3A365-6289-E8FE-EFBA-B99551100360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63" creationId="{EBD89F26-964B-26FC-A548-197193F8DA16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39" creationId="{A555686C-ECF5-C4AA-9B02-1689CA54ADD1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40" creationId="{CD077444-0139-7ACE-9B8A-892F11F11A46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44" creationId="{50C224DE-4F20-3218-2325-7F7F523ACE7F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66" creationId="{4004FDF2-0FE4-8AC3-2716-FD0047D7A99B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67" creationId="{BBDD9275-1E66-A75D-76EC-FA071CD21083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68" creationId="{CBDBCEC8-AFE3-B235-2E20-0E51C16B7E90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71" creationId="{A9235848-2297-5BAD-2BF2-7685BC8C2449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87" creationId="{B9DEAF6D-F800-A0AF-D8A9-1F9977494799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88" creationId="{F9704790-B6A0-21CE-524A-D2EE7650B629}"/>
          </ac:cxnSpMkLst>
        </pc:cxnChg>
        <pc:cxnChg chg="add mod">
          <ac:chgData name="Dominik Aumann" userId="013c187a20e8f01a" providerId="LiveId" clId="{ECAA7777-180A-4B5D-8194-D34F96268794}" dt="2024-02-25T22:52:28.619" v="74" actId="571"/>
          <ac:cxnSpMkLst>
            <pc:docMk/>
            <pc:sldMk cId="2080604651" sldId="260"/>
            <ac:cxnSpMk id="189" creationId="{B468AC75-97B1-1C16-77C0-BFD1F7AB0093}"/>
          </ac:cxnSpMkLst>
        </pc:cxnChg>
        <pc:cxnChg chg="add mod">
          <ac:chgData name="Dominik Aumann" userId="013c187a20e8f01a" providerId="LiveId" clId="{ECAA7777-180A-4B5D-8194-D34F96268794}" dt="2024-02-25T23:04:46.317" v="269" actId="164"/>
          <ac:cxnSpMkLst>
            <pc:docMk/>
            <pc:sldMk cId="2080604651" sldId="260"/>
            <ac:cxnSpMk id="200" creationId="{9CC6BEC4-2B82-1ACB-0635-4EABE41BE6EC}"/>
          </ac:cxnSpMkLst>
        </pc:cxnChg>
        <pc:cxnChg chg="add mod">
          <ac:chgData name="Dominik Aumann" userId="013c187a20e8f01a" providerId="LiveId" clId="{ECAA7777-180A-4B5D-8194-D34F96268794}" dt="2024-02-25T23:04:46.317" v="269" actId="164"/>
          <ac:cxnSpMkLst>
            <pc:docMk/>
            <pc:sldMk cId="2080604651" sldId="260"/>
            <ac:cxnSpMk id="201" creationId="{8CA4CBEA-3F8B-FDF5-04F0-0680C953B262}"/>
          </ac:cxnSpMkLst>
        </pc:cxnChg>
        <pc:cxnChg chg="add mod">
          <ac:chgData name="Dominik Aumann" userId="013c187a20e8f01a" providerId="LiveId" clId="{ECAA7777-180A-4B5D-8194-D34F96268794}" dt="2024-02-25T23:04:46.317" v="269" actId="164"/>
          <ac:cxnSpMkLst>
            <pc:docMk/>
            <pc:sldMk cId="2080604651" sldId="260"/>
            <ac:cxnSpMk id="202" creationId="{2A8F580E-769D-478C-7B63-6C0A0AEE58F2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227" creationId="{DAE6F01C-95D8-8C28-BA68-CB11AC8AFA49}"/>
          </ac:cxnSpMkLst>
        </pc:cxnChg>
        <pc:cxnChg chg="del mod topLvl">
          <ac:chgData name="Dominik Aumann" userId="013c187a20e8f01a" providerId="LiveId" clId="{ECAA7777-180A-4B5D-8194-D34F96268794}" dt="2024-02-25T23:24:33.453" v="545" actId="21"/>
          <ac:cxnSpMkLst>
            <pc:docMk/>
            <pc:sldMk cId="2080604651" sldId="260"/>
            <ac:cxnSpMk id="229" creationId="{0F464932-0C5E-C410-703D-BCCBB93B96A8}"/>
          </ac:cxnSpMkLst>
        </pc:cxnChg>
        <pc:cxnChg chg="add del mod topLvl">
          <ac:chgData name="Dominik Aumann" userId="013c187a20e8f01a" providerId="LiveId" clId="{ECAA7777-180A-4B5D-8194-D34F96268794}" dt="2024-02-25T23:25:23.348" v="559" actId="21"/>
          <ac:cxnSpMkLst>
            <pc:docMk/>
            <pc:sldMk cId="2080604651" sldId="260"/>
            <ac:cxnSpMk id="230" creationId="{200FCF69-6B0C-BD31-3A5D-430B66D96BE2}"/>
          </ac:cxnSpMkLst>
        </pc:cxnChg>
        <pc:cxnChg chg="add del mod topLvl">
          <ac:chgData name="Dominik Aumann" userId="013c187a20e8f01a" providerId="LiveId" clId="{ECAA7777-180A-4B5D-8194-D34F96268794}" dt="2024-02-25T23:25:23.348" v="559" actId="21"/>
          <ac:cxnSpMkLst>
            <pc:docMk/>
            <pc:sldMk cId="2080604651" sldId="260"/>
            <ac:cxnSpMk id="231" creationId="{93EEBFBE-CF54-4DF5-8DF4-D0CFA210121B}"/>
          </ac:cxnSpMkLst>
        </pc:cxnChg>
        <pc:cxnChg chg="del mod topLvl">
          <ac:chgData name="Dominik Aumann" userId="013c187a20e8f01a" providerId="LiveId" clId="{ECAA7777-180A-4B5D-8194-D34F96268794}" dt="2024-02-25T23:26:32.050" v="577" actId="478"/>
          <ac:cxnSpMkLst>
            <pc:docMk/>
            <pc:sldMk cId="2080604651" sldId="260"/>
            <ac:cxnSpMk id="253" creationId="{7690BC98-F720-1DB8-15B6-283EDADDCF59}"/>
          </ac:cxnSpMkLst>
        </pc:cxnChg>
        <pc:cxnChg chg="del mod topLvl">
          <ac:chgData name="Dominik Aumann" userId="013c187a20e8f01a" providerId="LiveId" clId="{ECAA7777-180A-4B5D-8194-D34F96268794}" dt="2024-02-25T23:26:32.050" v="577" actId="478"/>
          <ac:cxnSpMkLst>
            <pc:docMk/>
            <pc:sldMk cId="2080604651" sldId="260"/>
            <ac:cxnSpMk id="254" creationId="{E407F60A-6884-19E5-A7FE-C195B55415D7}"/>
          </ac:cxnSpMkLst>
        </pc:cxnChg>
        <pc:cxnChg chg="del mod topLvl">
          <ac:chgData name="Dominik Aumann" userId="013c187a20e8f01a" providerId="LiveId" clId="{ECAA7777-180A-4B5D-8194-D34F96268794}" dt="2024-02-25T23:26:32.050" v="577" actId="478"/>
          <ac:cxnSpMkLst>
            <pc:docMk/>
            <pc:sldMk cId="2080604651" sldId="260"/>
            <ac:cxnSpMk id="255" creationId="{A4969A47-4643-971C-A1E1-293D3C2DCE24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296" creationId="{3A5665D0-B416-3204-0C1B-949B307C1AA9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297" creationId="{C20AD987-C957-040C-262F-171C76084CDE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306" creationId="{81B6B84B-53E9-F3E6-2FCA-898C345E1EFA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28" creationId="{2806A679-DA77-9C08-B044-FACE8BA4C5F7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29" creationId="{98B4BCA8-3E5A-1A6C-D5A8-55FBB908F8C5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30" creationId="{2BA8CB4A-E00D-5EFF-7808-49FB9D19B02F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40" creationId="{17E343D1-0657-6B60-0CB5-21553682BE5C}"/>
          </ac:cxnSpMkLst>
        </pc:cxnChg>
        <pc:cxnChg chg="del">
          <ac:chgData name="Dominik Aumann" userId="013c187a20e8f01a" providerId="LiveId" clId="{ECAA7777-180A-4B5D-8194-D34F96268794}" dt="2024-02-25T22:51:19.245" v="71" actId="478"/>
          <ac:cxnSpMkLst>
            <pc:docMk/>
            <pc:sldMk cId="2080604651" sldId="260"/>
            <ac:cxnSpMk id="1054" creationId="{E311DA5B-DF6E-4ED2-D43E-7B84B6C33315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55" creationId="{689A7EC5-1122-F3B7-3F01-6E49912F11FF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56" creationId="{ACA0B173-C71F-4061-B929-FC20FD0EB321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65" creationId="{59FE11E2-476B-DA6F-D08B-77EC02F63A99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79" creationId="{C3B41241-359A-397D-90D6-73A292BC1C8C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80" creationId="{D13B8A96-EF25-0A88-A505-9C35E13E12FF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81" creationId="{226C2976-AE47-0C5A-0EBF-E3E977BD1D68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88" creationId="{8680B737-D994-E711-2A0B-78C97E6FB0D5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89" creationId="{58B1DA7D-4692-D82A-453B-D4D9B4178C5C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90" creationId="{7A4C8C6A-03B2-64DF-868E-2A3DFB8D22B4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099" creationId="{BA05C7A2-C418-65CE-6E4D-152AE171F74F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113" creationId="{12DC199E-9C3F-0353-C459-2C7F65F5604A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114" creationId="{6E493BEA-9000-B148-D1BD-26511CDD147E}"/>
          </ac:cxnSpMkLst>
        </pc:cxnChg>
        <pc:cxnChg chg="del mod topLvl">
          <ac:chgData name="Dominik Aumann" userId="013c187a20e8f01a" providerId="LiveId" clId="{ECAA7777-180A-4B5D-8194-D34F96268794}" dt="2024-02-25T22:52:58.659" v="75" actId="21"/>
          <ac:cxnSpMkLst>
            <pc:docMk/>
            <pc:sldMk cId="2080604651" sldId="260"/>
            <ac:cxnSpMk id="1115" creationId="{6FC18991-E9F7-A9DF-1ED8-228EA54D8A7B}"/>
          </ac:cxnSpMkLst>
        </pc:cxnChg>
      </pc:sldChg>
      <pc:sldChg chg="addSp modSp add del">
        <pc:chgData name="Dominik Aumann" userId="013c187a20e8f01a" providerId="LiveId" clId="{ECAA7777-180A-4B5D-8194-D34F96268794}" dt="2024-02-25T22:53:26.059" v="77" actId="47"/>
        <pc:sldMkLst>
          <pc:docMk/>
          <pc:sldMk cId="1357368825" sldId="261"/>
        </pc:sldMkLst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52" creationId="{C4D5BE2D-D0C3-5C3E-EE21-F7F5C999DEA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54" creationId="{A9F25FF4-1F74-FA40-3ED1-4BBDC80A7BF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56" creationId="{B343AF55-636F-4FCB-1D17-693ACC6F9FA0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62" creationId="{7FEF71F8-819C-A49E-D437-0833864B15E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63" creationId="{21DD025F-AB5A-C05A-A621-6BA873D719FF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64" creationId="{36C7DE49-B143-E20D-6E4A-28502107704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65" creationId="{E0EB279C-AB8B-0BAA-5830-0CB3A83501D0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74" creationId="{D2C9532C-A077-5D7E-1A2B-A099E0277A8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83" creationId="{081D6E68-3EA4-9314-FC96-B5BD11D553B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84" creationId="{359BD2E5-62EF-7392-F2F7-2FBDBE9CB46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93" creationId="{30C94AA8-5D89-75B9-EABD-45467A985EC6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10" creationId="{FC14CC69-871D-2C34-A03F-1389BD29BB52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44" creationId="{FF27F8ED-1645-7CB3-87C6-9DBF72FC94D2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2" creationId="{889049F8-10A9-0255-8A87-8B8F2EBD549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3" creationId="{691FCD08-08F3-1606-BA93-918BA59FB82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4" creationId="{DBB84D6C-C30C-E1C5-D616-35DF7850F8A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5" creationId="{08EBCF42-778F-D012-AD38-95FFE03D244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6" creationId="{B31BCB92-E6E4-F339-8C08-04BBEC39202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7" creationId="{7A92C428-662D-B157-44CE-1E1F63AEBFD6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8" creationId="{7AD8FEB6-C653-EB80-852E-6EBA5F6B86D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79" creationId="{B210DD91-A725-84D6-0A53-B47277B8020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80" creationId="{E37C60F6-4DC7-7E81-FB9D-DF604E026E17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281" creationId="{76EE3191-54DF-3C60-3377-62FB9D8C85A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04" creationId="{3FFCAE77-D3AF-A3FA-5B0C-0CB3EF6AFC35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05" creationId="{D8E84565-E841-D5F6-D44F-0AC396DF7D8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07" creationId="{F9E7F699-6A10-E826-FEDE-0549F24FC3D0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0" creationId="{11E3E2BA-F208-1B4B-CE51-F0B85587E46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1" creationId="{4ED32AE9-F69C-0FFD-4FB1-E46683224CC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2" creationId="{5D5A07D5-96CE-CBA3-8A57-DD1E3AEC36C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3" creationId="{5BAD791D-0A74-61BE-B55E-0E930510C4F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4" creationId="{4BF6ED26-97F5-3FAB-EADB-2E744CB51995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5" creationId="{F85B05EA-A88F-6AC4-0432-70199A6B622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6" creationId="{C7FE6576-F1F1-CA9F-9AF1-C2A27C8D6B21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7" creationId="{4CF6C694-EF25-FD73-D28E-955C2FE32DE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318" creationId="{CD6B0239-675A-A6E2-0734-503AE5338AED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24" creationId="{5EF5474E-EAC9-F447-B24B-E8066E76B90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25" creationId="{179AFAB3-F173-DB47-2FDA-C2EEA4B71098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38" creationId="{130D8F73-1752-5EFB-2D6B-253388B6EAA5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39" creationId="{F49463AA-FDAA-89DE-A874-1A4CFC8EAE5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1" creationId="{0196F1CC-0199-0780-24E8-F7399B24D252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4" creationId="{42AF30E7-F31D-FD5E-EE01-E4026488EDF8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5" creationId="{42763ABB-B222-F663-BBF5-594ECD7695F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6" creationId="{2D8E1F0D-5248-6018-1F52-1D007AB4F4AF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7" creationId="{03EA5C65-1522-8C0F-E4EB-E70CC4D1C73D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8" creationId="{DA26ED67-C1DB-4911-32D1-4A73C2285AE8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49" creationId="{3FE51211-9034-BDEA-7450-2E334F17B516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50" creationId="{56AB3D6F-2C73-EF9D-C34D-72CF0F074138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51" creationId="{A282A5A7-1CC3-493B-43BB-0647C61702FD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52" creationId="{708F623F-B6DF-2CBB-5627-B5B221DCDA7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53" creationId="{F19222F7-9854-FF10-F358-2BBF76A031D8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63" creationId="{1C5D5332-1989-D44D-AF9A-8CEAE2970FF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64" creationId="{D1036944-3CCD-486E-7A44-5C6B44A82E0A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66" creationId="{169F43CB-E4DB-88A8-C302-E908EBB1FEF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69" creationId="{2CF4F75C-8E97-4276-5276-37F449A5DCA5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0" creationId="{A94F96A9-AD77-F86C-FDC1-41A6CE0300FC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1" creationId="{F8B20533-3B5D-68DC-8C44-C5228B77FF8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2" creationId="{2596FD70-F91A-AD0D-A764-08EB194C920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3" creationId="{F4AC8F15-2956-79A8-08CF-61FCD2B18443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4" creationId="{74A737D8-56E0-9A2B-CFD5-D6339375DE0F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5" creationId="{12A36279-10FB-8CC7-4935-30DAADDA60A0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6" creationId="{D63620FC-21B6-B506-F83F-09139C61AB39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77" creationId="{EB6C514D-419D-7BAF-0F83-09ADF9F1E47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97" creationId="{7CD85EE0-AF7C-2DFC-7708-50DF87104C02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098" creationId="{A272A752-8B4C-6149-6CEC-CF7564EF3AA6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0" creationId="{0F2CCF47-FA7E-1BDD-FAAA-DBD49B3B639E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3" creationId="{E44C2EAB-A5B7-8384-3446-AA0B17FD450F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4" creationId="{4AFBE7FA-2FBE-E21E-E530-5C63296EBB17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5" creationId="{DB781014-F516-2D76-6C52-92A0A266E62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6" creationId="{82FC73A1-DF39-FEE1-66F7-BC372A64FE14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7" creationId="{E92C04B2-B451-22F6-6F99-C80DE968B156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8" creationId="{DC0CA4FE-AF9F-AC9B-3E58-D7100C5FD967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09" creationId="{9A31CD27-5542-1A4D-3B3E-67B310DAD9BD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10" creationId="{01883266-197D-C203-4201-1382A8BB7F1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11" creationId="{3EE97462-74B0-44DC-3E81-761F4D370A5B}"/>
          </ac:spMkLst>
        </pc:spChg>
        <pc:spChg chg="add mod">
          <ac:chgData name="Dominik Aumann" userId="013c187a20e8f01a" providerId="LiveId" clId="{ECAA7777-180A-4B5D-8194-D34F96268794}" dt="2024-02-25T22:53:08.703" v="76"/>
          <ac:spMkLst>
            <pc:docMk/>
            <pc:sldMk cId="1357368825" sldId="261"/>
            <ac:spMk id="1118" creationId="{C65C8D0D-8EAB-40F6-6A0E-D2AA3E4BF353}"/>
          </ac:spMkLst>
        </pc:spChg>
        <pc:picChg chg="add mod">
          <ac:chgData name="Dominik Aumann" userId="013c187a20e8f01a" providerId="LiveId" clId="{ECAA7777-180A-4B5D-8194-D34F96268794}" dt="2024-02-25T22:53:08.703" v="76"/>
          <ac:picMkLst>
            <pc:docMk/>
            <pc:sldMk cId="1357368825" sldId="261"/>
            <ac:picMk id="150" creationId="{70D1B608-9DA7-F92C-75D3-24BD99F409E4}"/>
          </ac:picMkLst>
        </pc:picChg>
        <pc:picChg chg="add mod">
          <ac:chgData name="Dominik Aumann" userId="013c187a20e8f01a" providerId="LiveId" clId="{ECAA7777-180A-4B5D-8194-D34F96268794}" dt="2024-02-25T22:53:08.703" v="76"/>
          <ac:picMkLst>
            <pc:docMk/>
            <pc:sldMk cId="1357368825" sldId="261"/>
            <ac:picMk id="151" creationId="{02EB1210-5173-B657-C543-9E7E1EAE9430}"/>
          </ac:picMkLst>
        </pc:pic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2" creationId="{2806A679-DA77-9C08-B044-FACE8BA4C5F7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227" creationId="{DAE6F01C-95D8-8C28-BA68-CB11AC8AFA49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296" creationId="{3A5665D0-B416-3204-0C1B-949B307C1AA9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297" creationId="{C20AD987-C957-040C-262F-171C76084CDE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306" creationId="{81B6B84B-53E9-F3E6-2FCA-898C345E1EFA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29" creationId="{98B4BCA8-3E5A-1A6C-D5A8-55FBB908F8C5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30" creationId="{2BA8CB4A-E00D-5EFF-7808-49FB9D19B02F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40" creationId="{17E343D1-0657-6B60-0CB5-21553682BE5C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55" creationId="{689A7EC5-1122-F3B7-3F01-6E49912F11FF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56" creationId="{ACA0B173-C71F-4061-B929-FC20FD0EB321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65" creationId="{59FE11E2-476B-DA6F-D08B-77EC02F63A99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79" creationId="{C3B41241-359A-397D-90D6-73A292BC1C8C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80" creationId="{D13B8A96-EF25-0A88-A505-9C35E13E12FF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81" creationId="{226C2976-AE47-0C5A-0EBF-E3E977BD1D68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88" creationId="{8680B737-D994-E711-2A0B-78C97E6FB0D5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89" creationId="{58B1DA7D-4692-D82A-453B-D4D9B4178C5C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90" creationId="{7A4C8C6A-03B2-64DF-868E-2A3DFB8D22B4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099" creationId="{BA05C7A2-C418-65CE-6E4D-152AE171F74F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113" creationId="{12DC199E-9C3F-0353-C459-2C7F65F5604A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114" creationId="{6E493BEA-9000-B148-D1BD-26511CDD147E}"/>
          </ac:cxnSpMkLst>
        </pc:cxnChg>
        <pc:cxnChg chg="add mod">
          <ac:chgData name="Dominik Aumann" userId="013c187a20e8f01a" providerId="LiveId" clId="{ECAA7777-180A-4B5D-8194-D34F96268794}" dt="2024-02-25T22:53:08.703" v="76"/>
          <ac:cxnSpMkLst>
            <pc:docMk/>
            <pc:sldMk cId="1357368825" sldId="261"/>
            <ac:cxnSpMk id="1115" creationId="{6FC18991-E9F7-A9DF-1ED8-228EA54D8A7B}"/>
          </ac:cxnSpMkLst>
        </pc:cxnChg>
      </pc:sldChg>
      <pc:sldChg chg="add del">
        <pc:chgData name="Dominik Aumann" userId="013c187a20e8f01a" providerId="LiveId" clId="{ECAA7777-180A-4B5D-8194-D34F96268794}" dt="2024-02-25T22:53:27.418" v="78" actId="47"/>
        <pc:sldMkLst>
          <pc:docMk/>
          <pc:sldMk cId="1257316189" sldId="262"/>
        </pc:sldMkLst>
      </pc:sldChg>
      <pc:sldChg chg="addSp delSp modSp add del mod">
        <pc:chgData name="Dominik Aumann" userId="013c187a20e8f01a" providerId="LiveId" clId="{ECAA7777-180A-4B5D-8194-D34F96268794}" dt="2024-02-25T22:53:28.152" v="79" actId="47"/>
        <pc:sldMkLst>
          <pc:docMk/>
          <pc:sldMk cId="2231081603" sldId="263"/>
        </pc:sldMkLst>
        <pc:picChg chg="add del mod">
          <ac:chgData name="Dominik Aumann" userId="013c187a20e8f01a" providerId="LiveId" clId="{ECAA7777-180A-4B5D-8194-D34F96268794}" dt="2024-02-25T22:46:56.478" v="4" actId="21"/>
          <ac:picMkLst>
            <pc:docMk/>
            <pc:sldMk cId="2231081603" sldId="263"/>
            <ac:picMk id="2" creationId="{7B88C27A-ED44-32F4-C764-FA8E89D65629}"/>
          </ac:picMkLst>
        </pc:picChg>
      </pc:sldChg>
      <pc:sldChg chg="addSp delSp modSp add del mod">
        <pc:chgData name="Dominik Aumann" userId="013c187a20e8f01a" providerId="LiveId" clId="{ECAA7777-180A-4B5D-8194-D34F96268794}" dt="2024-02-25T22:53:29.105" v="80" actId="47"/>
        <pc:sldMkLst>
          <pc:docMk/>
          <pc:sldMk cId="140880234" sldId="264"/>
        </pc:sldMkLst>
        <pc:picChg chg="add del mod">
          <ac:chgData name="Dominik Aumann" userId="013c187a20e8f01a" providerId="LiveId" clId="{ECAA7777-180A-4B5D-8194-D34F96268794}" dt="2024-02-25T22:47:37.531" v="12" actId="21"/>
          <ac:picMkLst>
            <pc:docMk/>
            <pc:sldMk cId="140880234" sldId="264"/>
            <ac:picMk id="2" creationId="{C90A8DA9-093C-471D-8687-74D89C28458D}"/>
          </ac:picMkLst>
        </pc:picChg>
      </pc:sldChg>
      <pc:sldChg chg="addSp delSp modSp del mod">
        <pc:chgData name="Dominik Aumann" userId="013c187a20e8f01a" providerId="LiveId" clId="{ECAA7777-180A-4B5D-8194-D34F96268794}" dt="2024-02-25T23:43:58.630" v="799" actId="47"/>
        <pc:sldMkLst>
          <pc:docMk/>
          <pc:sldMk cId="3278863017" sldId="265"/>
        </pc:sldMkLst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5" creationId="{75121066-9E2E-68F3-FCF4-139E7C6475D0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6" creationId="{8C592018-C68A-1876-F76D-330DCA1F52A7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7" creationId="{BA82E034-F9EE-7123-D6D0-538346A9B8E1}"/>
          </ac:spMkLst>
        </pc:spChg>
        <pc:spChg chg="add del mod">
          <ac:chgData name="Dominik Aumann" userId="013c187a20e8f01a" providerId="LiveId" clId="{ECAA7777-180A-4B5D-8194-D34F96268794}" dt="2024-02-25T22:50:18.150" v="50" actId="478"/>
          <ac:spMkLst>
            <pc:docMk/>
            <pc:sldMk cId="3278863017" sldId="265"/>
            <ac:spMk id="8" creationId="{EB958B05-2025-810E-B36D-3471A79F2B8D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9" creationId="{FA0DE562-9B1A-DEDD-0D4F-8F0644A8D153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0" creationId="{6DAE4F84-345A-4FA0-BEC7-0D7BBAED84D0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1" creationId="{DD2AECCA-4DCF-AAB4-4007-2E90350073FC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2" creationId="{26F2F944-A0F7-F692-F290-216F803EB47F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3" creationId="{66613099-7C54-0D97-A57E-C089D0FB2811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4" creationId="{3098E7E6-4000-0508-63D8-A3AFE56EE2A9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5" creationId="{BE6AD3F7-97E8-4AC4-4BBB-8FD86D31B5A0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6" creationId="{A420C074-B5CF-9E53-15C2-6C9E9D13040C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7" creationId="{BF4B2FA0-5093-4C57-E922-BA8B4492000B}"/>
          </ac:spMkLst>
        </pc:spChg>
        <pc:spChg chg="mod topLvl">
          <ac:chgData name="Dominik Aumann" userId="013c187a20e8f01a" providerId="LiveId" clId="{ECAA7777-180A-4B5D-8194-D34F96268794}" dt="2024-02-25T22:50:17.401" v="49" actId="165"/>
          <ac:spMkLst>
            <pc:docMk/>
            <pc:sldMk cId="3278863017" sldId="265"/>
            <ac:spMk id="18" creationId="{30408DF6-0943-2590-6F7C-AC9E48608ECB}"/>
          </ac:spMkLst>
        </pc:spChg>
        <pc:spChg chg="add del mod">
          <ac:chgData name="Dominik Aumann" userId="013c187a20e8f01a" providerId="LiveId" clId="{ECAA7777-180A-4B5D-8194-D34F96268794}" dt="2024-02-25T22:50:18.150" v="50" actId="478"/>
          <ac:spMkLst>
            <pc:docMk/>
            <pc:sldMk cId="3278863017" sldId="265"/>
            <ac:spMk id="19" creationId="{BDB288DF-6274-1E85-63D4-7822C899A222}"/>
          </ac:spMkLst>
        </pc:spChg>
        <pc:spChg chg="add del mod">
          <ac:chgData name="Dominik Aumann" userId="013c187a20e8f01a" providerId="LiveId" clId="{ECAA7777-180A-4B5D-8194-D34F96268794}" dt="2024-02-25T22:50:18.150" v="50" actId="478"/>
          <ac:spMkLst>
            <pc:docMk/>
            <pc:sldMk cId="3278863017" sldId="265"/>
            <ac:spMk id="23" creationId="{8380B5C1-F59A-188E-DE8E-CFFB2D70622F}"/>
          </ac:spMkLst>
        </pc:spChg>
        <pc:spChg chg="add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31" creationId="{7583FCDB-22F1-711F-B25A-7563C3F9B95C}"/>
          </ac:spMkLst>
        </pc:spChg>
        <pc:spChg chg="add del mod">
          <ac:chgData name="Dominik Aumann" userId="013c187a20e8f01a" providerId="LiveId" clId="{ECAA7777-180A-4B5D-8194-D34F96268794}" dt="2024-02-25T22:56:20.654" v="100" actId="478"/>
          <ac:spMkLst>
            <pc:docMk/>
            <pc:sldMk cId="3278863017" sldId="265"/>
            <ac:spMk id="32" creationId="{AD77E76F-9DFF-48E0-CC56-D48AD010915F}"/>
          </ac:spMkLst>
        </pc:spChg>
        <pc:spChg chg="add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33" creationId="{B55EDAED-145F-5A86-6AB4-3244D96CDE3E}"/>
          </ac:spMkLst>
        </pc:spChg>
        <pc:spChg chg="add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34" creationId="{B5326138-BC3D-C5D4-D741-7D392B8EE837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48" creationId="{71F6B42B-BBF9-DFF9-3613-7B2FEB2CAE9B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49" creationId="{E1B5DDE2-6BC3-E818-016F-089BA7346056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0" creationId="{268D760B-0DDE-2603-F18C-C7B983DDEBC8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1" creationId="{8A9A08B9-CD94-D103-D757-AD0F018075AD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2" creationId="{12979A86-D7A1-3250-AD48-1C9332EFE21E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3" creationId="{A3065A17-567F-DF36-A6B6-204C813DB442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4" creationId="{AEDE1372-E916-3B5B-99A4-BC68FE4B9095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5" creationId="{CEB6084C-EB35-A646-15B1-520620DB1ED0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6" creationId="{9BE154BC-6219-039F-0263-E93D01D170A7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7" creationId="{A795A569-D946-0567-7B86-0CB02F362110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8" creationId="{726B37C7-6192-2FBF-4CA3-8E7240E19520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59" creationId="{2D0AB5FA-545D-B79C-D2C1-F5EE4F4DCE72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63" creationId="{53F01908-5DD6-5BA9-5102-7319CD3BAA54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128" creationId="{C98CDF09-E4BD-107A-A81C-FE0360552DFA}"/>
          </ac:spMkLst>
        </pc:spChg>
        <pc:spChg chg="mod">
          <ac:chgData name="Dominik Aumann" userId="013c187a20e8f01a" providerId="LiveId" clId="{ECAA7777-180A-4B5D-8194-D34F96268794}" dt="2024-02-25T23:06:17.739" v="287"/>
          <ac:spMkLst>
            <pc:docMk/>
            <pc:sldMk cId="3278863017" sldId="265"/>
            <ac:spMk id="129" creationId="{BD4FDBA0-2EC3-6A98-2827-8DC01188F255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52" creationId="{C04E1C38-12DD-7D58-6532-E72E883E7A4B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54" creationId="{BABBFB0A-B3C3-1165-4FB0-65D22AC2F9A3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56" creationId="{1291C6D1-7A0B-1B84-649B-D518F2B334B8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58" creationId="{F2DAA048-FB35-660A-10F6-BBF9D9CF2D69}"/>
          </ac:spMkLst>
        </pc:spChg>
        <pc:spChg chg="add del">
          <ac:chgData name="Dominik Aumann" userId="013c187a20e8f01a" providerId="LiveId" clId="{ECAA7777-180A-4B5D-8194-D34F96268794}" dt="2024-02-25T22:56:28.371" v="101" actId="478"/>
          <ac:spMkLst>
            <pc:docMk/>
            <pc:sldMk cId="3278863017" sldId="265"/>
            <ac:spMk id="159" creationId="{C337C77E-6A98-18E0-5610-3C417682B082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62" creationId="{FAD1D61F-332D-CB59-D077-F8C47B90A59D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63" creationId="{50F455C5-D601-619E-F3B8-08FA364C9924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64" creationId="{158EE63C-8F64-4FE6-E5C0-47810BAD3B72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65" creationId="{1522B321-75C3-391D-FF0B-B1F626E68846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66" creationId="{1687A8F7-5A6A-BF43-5AD2-49446EB6896E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67" creationId="{4FBCA21D-0C5B-0A4F-DF27-F906423C37E0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68" creationId="{7D10E136-732D-6CD5-9D65-25D3CA14C633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69" creationId="{289BA347-94B2-64ED-9A62-193D9BC16B9D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0" creationId="{A8605E92-E267-5B49-F260-C58562C96755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1" creationId="{28F16DC1-2CF6-26E9-6D75-7AAD7EDE825E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2" creationId="{698451A4-0BA6-2763-3548-BCF156E766DD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3" creationId="{C7E821D1-8118-2148-590B-9C800878448F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74" creationId="{596D6E7C-8DB1-9378-8A92-31385800F952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5" creationId="{5B3D870F-A85F-D074-FE93-1470DC831092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6" creationId="{3C09B7A2-D54D-34E9-E7E9-FA430085DFFC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77" creationId="{749F7BD2-1D93-FF34-D76C-AEAB41ABA66B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81" creationId="{1E6D19CC-85FC-E06B-F657-4F84DC4B1E52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82" creationId="{DB9361CD-D7FA-DDB3-C2C9-62A0632EED4F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83" creationId="{BE3EEEF7-0AF7-023D-A876-1F0F7987A0C1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84" creationId="{9E076708-B64B-2E18-92B7-EE5088483A05}"/>
          </ac:spMkLst>
        </pc:spChg>
        <pc:spChg chg="mod topLvl">
          <ac:chgData name="Dominik Aumann" userId="013c187a20e8f01a" providerId="LiveId" clId="{ECAA7777-180A-4B5D-8194-D34F96268794}" dt="2024-02-25T23:25:47.326" v="567" actId="164"/>
          <ac:spMkLst>
            <pc:docMk/>
            <pc:sldMk cId="3278863017" sldId="265"/>
            <ac:spMk id="185" creationId="{7017319D-2A34-7A92-CB29-F47F9116B2FB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24" creationId="{27F4B3CF-3249-A9C6-D73A-34596CDCA801}"/>
          </ac:spMkLst>
        </pc:spChg>
        <pc:spChg chg="add del 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25" creationId="{DF3E29F1-344C-BBB8-ECA2-1173C8F25289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2" creationId="{18757C57-8F4C-C26F-11CF-85E5D598C739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3" creationId="{ED77EB81-4BA2-5D8F-6059-01B713890565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4" creationId="{CC604AD2-E81F-FDF5-114C-6B0754338F17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5" creationId="{58B7FC72-0F7E-1450-F586-C7ABB87EF12F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6" creationId="{D637F83B-7595-AF5E-29C0-7FFDF24BA34E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7" creationId="{4F756541-E003-55F3-F8DD-D284CBB5DFA6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8" creationId="{39019086-3400-32FF-3D90-EB459AA1A7C8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39" creationId="{446ABBBB-F8FA-8998-C13D-7C03604C6757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0" creationId="{A97D03D7-6348-E589-09DF-ECB39D88768C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1" creationId="{B67A09C7-B814-5D00-322C-C8798EFB0A94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2" creationId="{469BC084-D7BC-0711-131A-9AF6ED6F2019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3" creationId="{FEC6020F-38ED-2642-ED8A-8D62EB8210D7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7" creationId="{33EA8151-A1A9-5865-E6FC-1528DC11F2E9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8" creationId="{B65E9017-B8F2-3ED0-5E3E-8897802E48AE}"/>
          </ac:spMkLst>
        </pc:spChg>
        <pc:spChg chg="mod">
          <ac:chgData name="Dominik Aumann" userId="013c187a20e8f01a" providerId="LiveId" clId="{ECAA7777-180A-4B5D-8194-D34F96268794}" dt="2024-02-25T23:22:31.523" v="514" actId="165"/>
          <ac:spMkLst>
            <pc:docMk/>
            <pc:sldMk cId="3278863017" sldId="265"/>
            <ac:spMk id="1049" creationId="{2B87D727-2DA6-FBB1-1A59-30B8E54ADAEB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56" creationId="{66042E77-6193-3984-14C9-F4635989E6A6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57" creationId="{42930C09-C666-7FA1-1DEF-74E57C59D842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58" creationId="{13CF7F48-0F11-C349-B6A7-1E494E683D6B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59" creationId="{4C616044-0EFF-1FCC-93DB-EAC096B5F351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0" creationId="{2A17AB45-04DB-682A-C385-26A02F496DC5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1" creationId="{6D61F9F7-B370-28B9-A517-B56778C4993F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2" creationId="{B666992D-9BBF-8E18-1818-10F65826F60C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3" creationId="{89384DE2-48E3-ABAA-FD5B-E5F9420DF337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4" creationId="{8D012805-B32A-CB02-812A-419BEEFE516A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5" creationId="{88D56023-EB8A-3D10-3599-CD0865C11A98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6" creationId="{4FBC83E2-148E-A243-7ED8-FD2B7B345A6E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067" creationId="{F981F66C-C26C-DA3D-5183-FE6D8B3499F6}"/>
          </ac:spMkLst>
        </pc:spChg>
        <pc:spChg chg="mod">
          <ac:chgData name="Dominik Aumann" userId="013c187a20e8f01a" providerId="LiveId" clId="{ECAA7777-180A-4B5D-8194-D34F96268794}" dt="2024-02-25T23:22:08.875" v="511"/>
          <ac:spMkLst>
            <pc:docMk/>
            <pc:sldMk cId="3278863017" sldId="265"/>
            <ac:spMk id="1071" creationId="{333CD9A1-1FE3-F7EF-0C70-CC88E41EE4B1}"/>
          </ac:spMkLst>
        </pc:spChg>
        <pc:spChg chg="mod">
          <ac:chgData name="Dominik Aumann" userId="013c187a20e8f01a" providerId="LiveId" clId="{ECAA7777-180A-4B5D-8194-D34F96268794}" dt="2024-02-25T23:29:04.523" v="614"/>
          <ac:spMkLst>
            <pc:docMk/>
            <pc:sldMk cId="3278863017" sldId="265"/>
            <ac:spMk id="1072" creationId="{620B7189-E753-6B83-EC02-2AE2B1BA8712}"/>
          </ac:spMkLst>
        </pc:spChg>
        <pc:spChg chg="mod">
          <ac:chgData name="Dominik Aumann" userId="013c187a20e8f01a" providerId="LiveId" clId="{ECAA7777-180A-4B5D-8194-D34F96268794}" dt="2024-02-25T23:28:57.790" v="612"/>
          <ac:spMkLst>
            <pc:docMk/>
            <pc:sldMk cId="3278863017" sldId="265"/>
            <ac:spMk id="1073" creationId="{48A521DD-E7CE-186F-1F48-7275C89CB815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78" creationId="{33D28AD1-E0B3-D50D-6278-94736E5531E4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79" creationId="{F28E5D77-98DA-91FB-DA7E-7CA03BA5D013}"/>
          </ac:spMkLst>
        </pc:spChg>
        <pc:spChg chg="del mod topLvl">
          <ac:chgData name="Dominik Aumann" userId="013c187a20e8f01a" providerId="LiveId" clId="{ECAA7777-180A-4B5D-8194-D34F96268794}" dt="2024-02-25T23:43:19.702" v="783" actId="478"/>
          <ac:spMkLst>
            <pc:docMk/>
            <pc:sldMk cId="3278863017" sldId="265"/>
            <ac:spMk id="1080" creationId="{89296C60-912A-B5DC-88D9-3F5ED590233A}"/>
          </ac:spMkLst>
        </pc:spChg>
        <pc:spChg chg="del mod topLvl">
          <ac:chgData name="Dominik Aumann" userId="013c187a20e8f01a" providerId="LiveId" clId="{ECAA7777-180A-4B5D-8194-D34F96268794}" dt="2024-02-25T23:43:19.702" v="783" actId="478"/>
          <ac:spMkLst>
            <pc:docMk/>
            <pc:sldMk cId="3278863017" sldId="265"/>
            <ac:spMk id="1081" creationId="{ED794FC6-B3C2-D123-454A-4B6BA702B833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82" creationId="{7888E6B5-8A79-8BA9-E1F2-F7044812F373}"/>
          </ac:spMkLst>
        </pc:spChg>
        <pc:spChg chg="del mod topLvl">
          <ac:chgData name="Dominik Aumann" userId="013c187a20e8f01a" providerId="LiveId" clId="{ECAA7777-180A-4B5D-8194-D34F96268794}" dt="2024-02-25T23:43:19.702" v="783" actId="478"/>
          <ac:spMkLst>
            <pc:docMk/>
            <pc:sldMk cId="3278863017" sldId="265"/>
            <ac:spMk id="1083" creationId="{E797A613-087B-DE01-1AFF-BA8D54F7F115}"/>
          </ac:spMkLst>
        </pc:spChg>
        <pc:spChg chg="del mod topLvl">
          <ac:chgData name="Dominik Aumann" userId="013c187a20e8f01a" providerId="LiveId" clId="{ECAA7777-180A-4B5D-8194-D34F96268794}" dt="2024-02-25T23:43:21.561" v="784" actId="478"/>
          <ac:spMkLst>
            <pc:docMk/>
            <pc:sldMk cId="3278863017" sldId="265"/>
            <ac:spMk id="1084" creationId="{6133A2E1-976A-A608-8245-08B9D26FCC88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85" creationId="{0B50B1E9-53C2-AED8-10D2-1551DFADB517}"/>
          </ac:spMkLst>
        </pc:spChg>
        <pc:spChg chg="del mod topLvl">
          <ac:chgData name="Dominik Aumann" userId="013c187a20e8f01a" providerId="LiveId" clId="{ECAA7777-180A-4B5D-8194-D34F96268794}" dt="2024-02-25T23:43:38.291" v="788" actId="478"/>
          <ac:spMkLst>
            <pc:docMk/>
            <pc:sldMk cId="3278863017" sldId="265"/>
            <ac:spMk id="1086" creationId="{221ED262-9778-DE28-0F7E-9F92025E82F0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87" creationId="{C5D33F1D-80AB-35B0-241D-6C20BEB4A841}"/>
          </ac:spMkLst>
        </pc:spChg>
        <pc:spChg chg="del mod topLvl">
          <ac:chgData name="Dominik Aumann" userId="013c187a20e8f01a" providerId="LiveId" clId="{ECAA7777-180A-4B5D-8194-D34F96268794}" dt="2024-02-25T23:43:16.202" v="782" actId="478"/>
          <ac:spMkLst>
            <pc:docMk/>
            <pc:sldMk cId="3278863017" sldId="265"/>
            <ac:spMk id="1088" creationId="{1A822697-EE5A-C3D1-1A8D-BBD7E76F35DE}"/>
          </ac:spMkLst>
        </pc:spChg>
        <pc:spChg chg="del mod topLvl">
          <ac:chgData name="Dominik Aumann" userId="013c187a20e8f01a" providerId="LiveId" clId="{ECAA7777-180A-4B5D-8194-D34F96268794}" dt="2024-02-25T23:43:21.561" v="784" actId="478"/>
          <ac:spMkLst>
            <pc:docMk/>
            <pc:sldMk cId="3278863017" sldId="265"/>
            <ac:spMk id="1089" creationId="{82042FD1-1298-2074-4ACB-CE090581261F}"/>
          </ac:spMkLst>
        </pc:spChg>
        <pc:spChg chg="del mod">
          <ac:chgData name="Dominik Aumann" userId="013c187a20e8f01a" providerId="LiveId" clId="{ECAA7777-180A-4B5D-8194-D34F96268794}" dt="2024-02-25T23:43:07.814" v="779" actId="478"/>
          <ac:spMkLst>
            <pc:docMk/>
            <pc:sldMk cId="3278863017" sldId="265"/>
            <ac:spMk id="1093" creationId="{23F2EDF5-34A5-AFE8-D215-BADDD5783321}"/>
          </ac:spMkLst>
        </pc:spChg>
        <pc:spChg chg="del mod topLvl">
          <ac:chgData name="Dominik Aumann" userId="013c187a20e8f01a" providerId="LiveId" clId="{ECAA7777-180A-4B5D-8194-D34F96268794}" dt="2024-02-25T23:43:19.702" v="783" actId="478"/>
          <ac:spMkLst>
            <pc:docMk/>
            <pc:sldMk cId="3278863017" sldId="265"/>
            <ac:spMk id="1094" creationId="{C990E908-9024-7EC4-A17B-FD31849E0CD0}"/>
          </ac:spMkLst>
        </pc:spChg>
        <pc:spChg chg="del mod">
          <ac:chgData name="Dominik Aumann" userId="013c187a20e8f01a" providerId="LiveId" clId="{ECAA7777-180A-4B5D-8194-D34F96268794}" dt="2024-02-25T23:43:09.579" v="780" actId="478"/>
          <ac:spMkLst>
            <pc:docMk/>
            <pc:sldMk cId="3278863017" sldId="265"/>
            <ac:spMk id="1095" creationId="{EB855470-3D5C-97CA-5A0F-0846CF7F5244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3" creationId="{5D10ECD1-60F6-9DE9-E8EE-9BC8EEF68FBE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4" creationId="{183A16DE-7C93-BA38-2B00-F08269099F4C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5" creationId="{83C5EF66-D619-303E-51A2-6240997E9117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6" creationId="{B9695A20-DBB3-955D-13E9-BF0C0EEC0DD8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7" creationId="{EE0F0BAB-9AE0-ACBF-1A95-1868D41B234D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8" creationId="{A18DF542-5C3F-DB1A-2FAF-5F4833DA64AB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09" creationId="{3BC72083-662E-4B7F-7AB6-71CDA0FDA675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10" creationId="{2E45D088-470B-8BEE-0CA7-A73E17D3FCDB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11" creationId="{877F370E-0781-E716-AFD4-1CB9468E6E10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12" creationId="{5F3C65EE-8219-B69D-60A2-CC2D66EF964C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13" creationId="{989AAADC-412E-73C8-73F3-7567426A5E2C}"/>
          </ac:spMkLst>
        </pc:spChg>
        <pc:spChg chg="mod">
          <ac:chgData name="Dominik Aumann" userId="013c187a20e8f01a" providerId="LiveId" clId="{ECAA7777-180A-4B5D-8194-D34F96268794}" dt="2024-02-25T23:21:22.116" v="505"/>
          <ac:spMkLst>
            <pc:docMk/>
            <pc:sldMk cId="3278863017" sldId="265"/>
            <ac:spMk id="1114" creationId="{3CCEEBC9-3591-698D-3BDA-80C945BC5A0B}"/>
          </ac:spMkLst>
        </pc:spChg>
        <pc:spChg chg="mod">
          <ac:chgData name="Dominik Aumann" userId="013c187a20e8f01a" providerId="LiveId" clId="{ECAA7777-180A-4B5D-8194-D34F96268794}" dt="2024-02-25T23:22:01.970" v="509"/>
          <ac:spMkLst>
            <pc:docMk/>
            <pc:sldMk cId="3278863017" sldId="265"/>
            <ac:spMk id="1118" creationId="{864102C0-4EE2-AF68-9EDA-8D9D170B0519}"/>
          </ac:spMkLst>
        </pc:spChg>
        <pc:spChg chg="mod">
          <ac:chgData name="Dominik Aumann" userId="013c187a20e8f01a" providerId="LiveId" clId="{ECAA7777-180A-4B5D-8194-D34F96268794}" dt="2024-02-25T23:28:49.667" v="610"/>
          <ac:spMkLst>
            <pc:docMk/>
            <pc:sldMk cId="3278863017" sldId="265"/>
            <ac:spMk id="1119" creationId="{6E49C6CD-43FE-7D75-7DC1-760958CEF643}"/>
          </ac:spMkLst>
        </pc:spChg>
        <pc:spChg chg="mod">
          <ac:chgData name="Dominik Aumann" userId="013c187a20e8f01a" providerId="LiveId" clId="{ECAA7777-180A-4B5D-8194-D34F96268794}" dt="2024-02-25T23:28:44.091" v="608"/>
          <ac:spMkLst>
            <pc:docMk/>
            <pc:sldMk cId="3278863017" sldId="265"/>
            <ac:spMk id="1120" creationId="{0E43846D-AFC4-C402-5F5C-F40A83466CF8}"/>
          </ac:spMkLst>
        </pc:spChg>
        <pc:spChg chg="add del mod">
          <ac:chgData name="Dominik Aumann" userId="013c187a20e8f01a" providerId="LiveId" clId="{ECAA7777-180A-4B5D-8194-D34F96268794}" dt="2024-02-25T23:43:01.925" v="777" actId="478"/>
          <ac:spMkLst>
            <pc:docMk/>
            <pc:sldMk cId="3278863017" sldId="265"/>
            <ac:spMk id="1131" creationId="{DB39C730-B8FB-F77A-859F-BB2708A55AF0}"/>
          </ac:spMkLst>
        </pc:spChg>
        <pc:grpChg chg="add del mod">
          <ac:chgData name="Dominik Aumann" userId="013c187a20e8f01a" providerId="LiveId" clId="{ECAA7777-180A-4B5D-8194-D34F96268794}" dt="2024-02-25T22:50:17.401" v="49" actId="165"/>
          <ac:grpSpMkLst>
            <pc:docMk/>
            <pc:sldMk cId="3278863017" sldId="265"/>
            <ac:grpSpMk id="4" creationId="{8837FD47-A317-A7A4-018B-666D59D1D9C4}"/>
          </ac:grpSpMkLst>
        </pc:grpChg>
        <pc:grpChg chg="add mod">
          <ac:chgData name="Dominik Aumann" userId="013c187a20e8f01a" providerId="LiveId" clId="{ECAA7777-180A-4B5D-8194-D34F96268794}" dt="2024-02-25T23:22:31.523" v="514" actId="165"/>
          <ac:grpSpMkLst>
            <pc:docMk/>
            <pc:sldMk cId="3278863017" sldId="265"/>
            <ac:grpSpMk id="42" creationId="{8B06892B-5B90-6763-B739-693CCF1A027E}"/>
          </ac:grpSpMkLst>
        </pc:grpChg>
        <pc:grpChg chg="add del mod">
          <ac:chgData name="Dominik Aumann" userId="013c187a20e8f01a" providerId="LiveId" clId="{ECAA7777-180A-4B5D-8194-D34F96268794}" dt="2024-02-25T23:20:04.316" v="499" actId="478"/>
          <ac:grpSpMkLst>
            <pc:docMk/>
            <pc:sldMk cId="3278863017" sldId="265"/>
            <ac:grpSpMk id="43" creationId="{A98C93DE-590A-8E79-0C2F-2F955BC15C75}"/>
          </ac:grpSpMkLst>
        </pc:grpChg>
        <pc:grpChg chg="add del mod topLvl">
          <ac:chgData name="Dominik Aumann" userId="013c187a20e8f01a" providerId="LiveId" clId="{ECAA7777-180A-4B5D-8194-D34F96268794}" dt="2024-02-25T23:43:01.925" v="777" actId="478"/>
          <ac:grpSpMkLst>
            <pc:docMk/>
            <pc:sldMk cId="3278863017" sldId="265"/>
            <ac:grpSpMk id="146" creationId="{E2689B00-08B6-0A16-9940-B0CA152B0A38}"/>
          </ac:grpSpMkLst>
        </pc:grpChg>
        <pc:grpChg chg="add del mod topLvl">
          <ac:chgData name="Dominik Aumann" userId="013c187a20e8f01a" providerId="LiveId" clId="{ECAA7777-180A-4B5D-8194-D34F96268794}" dt="2024-02-25T23:25:26.613" v="560" actId="478"/>
          <ac:grpSpMkLst>
            <pc:docMk/>
            <pc:sldMk cId="3278863017" sldId="265"/>
            <ac:grpSpMk id="147" creationId="{CCD8C6B5-838F-9CA9-5D5F-97EFAEE1BF11}"/>
          </ac:grpSpMkLst>
        </pc:grpChg>
        <pc:grpChg chg="add del mod topLvl">
          <ac:chgData name="Dominik Aumann" userId="013c187a20e8f01a" providerId="LiveId" clId="{ECAA7777-180A-4B5D-8194-D34F96268794}" dt="2024-02-25T23:25:33.767" v="563" actId="165"/>
          <ac:grpSpMkLst>
            <pc:docMk/>
            <pc:sldMk cId="3278863017" sldId="265"/>
            <ac:grpSpMk id="153" creationId="{4B2FDBA9-E0C5-957D-7C2A-64DB6832C8BF}"/>
          </ac:grpSpMkLst>
        </pc:grpChg>
        <pc:grpChg chg="add del mod topLvl">
          <ac:chgData name="Dominik Aumann" userId="013c187a20e8f01a" providerId="LiveId" clId="{ECAA7777-180A-4B5D-8194-D34F96268794}" dt="2024-02-25T23:43:01.925" v="777" actId="478"/>
          <ac:grpSpMkLst>
            <pc:docMk/>
            <pc:sldMk cId="3278863017" sldId="265"/>
            <ac:grpSpMk id="190" creationId="{B5D20B84-A0C5-AC02-CCB7-DA66CCC8B0CA}"/>
          </ac:grpSpMkLst>
        </pc:grpChg>
        <pc:grpChg chg="add del mod">
          <ac:chgData name="Dominik Aumann" userId="013c187a20e8f01a" providerId="LiveId" clId="{ECAA7777-180A-4B5D-8194-D34F96268794}" dt="2024-02-25T23:33:04.092" v="666" actId="21"/>
          <ac:grpSpMkLst>
            <pc:docMk/>
            <pc:sldMk cId="3278863017" sldId="265"/>
            <ac:grpSpMk id="1050" creationId="{AF1293A5-DFBD-58C2-822C-967A2301FA07}"/>
          </ac:grpSpMkLst>
        </pc:grpChg>
        <pc:grpChg chg="del mod topLvl">
          <ac:chgData name="Dominik Aumann" userId="013c187a20e8f01a" providerId="LiveId" clId="{ECAA7777-180A-4B5D-8194-D34F96268794}" dt="2024-02-25T23:43:01.925" v="777" actId="478"/>
          <ac:grpSpMkLst>
            <pc:docMk/>
            <pc:sldMk cId="3278863017" sldId="265"/>
            <ac:grpSpMk id="1053" creationId="{CC6565F6-2151-0675-4B35-5B59FFB6A7D6}"/>
          </ac:grpSpMkLst>
        </pc:grpChg>
        <pc:grpChg chg="add del mod">
          <ac:chgData name="Dominik Aumann" userId="013c187a20e8f01a" providerId="LiveId" clId="{ECAA7777-180A-4B5D-8194-D34F96268794}" dt="2024-02-25T23:36:34.430" v="715" actId="21"/>
          <ac:grpSpMkLst>
            <pc:docMk/>
            <pc:sldMk cId="3278863017" sldId="265"/>
            <ac:grpSpMk id="1074" creationId="{E15FF9CD-0591-37E8-1073-4040A65276CD}"/>
          </ac:grpSpMkLst>
        </pc:grpChg>
        <pc:grpChg chg="del mod topLvl">
          <ac:chgData name="Dominik Aumann" userId="013c187a20e8f01a" providerId="LiveId" clId="{ECAA7777-180A-4B5D-8194-D34F96268794}" dt="2024-02-25T23:43:13.891" v="781" actId="165"/>
          <ac:grpSpMkLst>
            <pc:docMk/>
            <pc:sldMk cId="3278863017" sldId="265"/>
            <ac:grpSpMk id="1077" creationId="{B3413BCB-09A4-F0D1-3370-BAA58C8D0191}"/>
          </ac:grpSpMkLst>
        </pc:grpChg>
        <pc:grpChg chg="add del mod">
          <ac:chgData name="Dominik Aumann" userId="013c187a20e8f01a" providerId="LiveId" clId="{ECAA7777-180A-4B5D-8194-D34F96268794}" dt="2024-02-25T23:43:01.925" v="777" actId="478"/>
          <ac:grpSpMkLst>
            <pc:docMk/>
            <pc:sldMk cId="3278863017" sldId="265"/>
            <ac:grpSpMk id="1098" creationId="{F6D6EE09-8D36-F0EA-867C-605E8302785F}"/>
          </ac:grpSpMkLst>
        </pc:grpChg>
        <pc:grpChg chg="add del mod">
          <ac:chgData name="Dominik Aumann" userId="013c187a20e8f01a" providerId="LiveId" clId="{ECAA7777-180A-4B5D-8194-D34F96268794}" dt="2024-02-25T23:22:31.523" v="514" actId="165"/>
          <ac:grpSpMkLst>
            <pc:docMk/>
            <pc:sldMk cId="3278863017" sldId="265"/>
            <ac:grpSpMk id="1121" creationId="{611DC2C0-4B94-E21E-6561-F2A58DBB7357}"/>
          </ac:grpSpMkLst>
        </pc:grpChg>
        <pc:grpChg chg="add del mod">
          <ac:chgData name="Dominik Aumann" userId="013c187a20e8f01a" providerId="LiveId" clId="{ECAA7777-180A-4B5D-8194-D34F96268794}" dt="2024-02-25T23:43:05.652" v="778" actId="478"/>
          <ac:grpSpMkLst>
            <pc:docMk/>
            <pc:sldMk cId="3278863017" sldId="265"/>
            <ac:grpSpMk id="1127" creationId="{7C68455D-85FD-D522-6497-6A7EF60D785F}"/>
          </ac:grpSpMkLst>
        </pc:grpChg>
        <pc:picChg chg="add del mod">
          <ac:chgData name="Dominik Aumann" userId="013c187a20e8f01a" providerId="LiveId" clId="{ECAA7777-180A-4B5D-8194-D34F96268794}" dt="2024-02-25T22:53:51.350" v="81" actId="478"/>
          <ac:picMkLst>
            <pc:docMk/>
            <pc:sldMk cId="3278863017" sldId="265"/>
            <ac:picMk id="2" creationId="{7B88C27A-ED44-32F4-C764-FA8E89D65629}"/>
          </ac:picMkLst>
        </pc:picChg>
        <pc:picChg chg="add del mod">
          <ac:chgData name="Dominik Aumann" userId="013c187a20e8f01a" providerId="LiveId" clId="{ECAA7777-180A-4B5D-8194-D34F96268794}" dt="2024-02-25T22:53:52.100" v="82" actId="478"/>
          <ac:picMkLst>
            <pc:docMk/>
            <pc:sldMk cId="3278863017" sldId="265"/>
            <ac:picMk id="3" creationId="{C90A8DA9-093C-471D-8687-74D89C28458D}"/>
          </ac:picMkLst>
        </pc:picChg>
        <pc:picChg chg="add mod ord">
          <ac:chgData name="Dominik Aumann" userId="013c187a20e8f01a" providerId="LiveId" clId="{ECAA7777-180A-4B5D-8194-D34F96268794}" dt="2024-02-25T22:50:16.229" v="47" actId="167"/>
          <ac:picMkLst>
            <pc:docMk/>
            <pc:sldMk cId="3278863017" sldId="265"/>
            <ac:picMk id="24" creationId="{00000000-0000-0000-0000-000000000000}"/>
          </ac:picMkLst>
        </pc:picChg>
        <pc:picChg chg="add mod ord">
          <ac:chgData name="Dominik Aumann" userId="013c187a20e8f01a" providerId="LiveId" clId="{ECAA7777-180A-4B5D-8194-D34F96268794}" dt="2024-02-25T22:50:16.229" v="47" actId="167"/>
          <ac:picMkLst>
            <pc:docMk/>
            <pc:sldMk cId="3278863017" sldId="265"/>
            <ac:picMk id="25" creationId="{00000000-0000-0000-0000-000000000000}"/>
          </ac:picMkLst>
        </pc:picChg>
        <pc:picChg chg="add mod ord">
          <ac:chgData name="Dominik Aumann" userId="013c187a20e8f01a" providerId="LiveId" clId="{ECAA7777-180A-4B5D-8194-D34F96268794}" dt="2024-02-25T22:50:16.229" v="47" actId="167"/>
          <ac:picMkLst>
            <pc:docMk/>
            <pc:sldMk cId="3278863017" sldId="265"/>
            <ac:picMk id="26" creationId="{00000000-0000-0000-0000-000000000000}"/>
          </ac:picMkLst>
        </pc:picChg>
        <pc:picChg chg="add del mod ord">
          <ac:chgData name="Dominik Aumann" userId="013c187a20e8f01a" providerId="LiveId" clId="{ECAA7777-180A-4B5D-8194-D34F96268794}" dt="2024-02-25T23:11:06.707" v="347" actId="478"/>
          <ac:picMkLst>
            <pc:docMk/>
            <pc:sldMk cId="3278863017" sldId="265"/>
            <ac:picMk id="27" creationId="{55CED0B3-C86A-FC1D-A655-F553BB64CF81}"/>
          </ac:picMkLst>
        </pc:picChg>
        <pc:picChg chg="add del mod ord">
          <ac:chgData name="Dominik Aumann" userId="013c187a20e8f01a" providerId="LiveId" clId="{ECAA7777-180A-4B5D-8194-D34F96268794}" dt="2024-02-25T22:54:11.907" v="86" actId="478"/>
          <ac:picMkLst>
            <pc:docMk/>
            <pc:sldMk cId="3278863017" sldId="265"/>
            <ac:picMk id="28" creationId="{C2ED2BEB-0E74-D4C1-C689-42D468E8E6FE}"/>
          </ac:picMkLst>
        </pc:picChg>
        <pc:picChg chg="add del mod ord">
          <ac:chgData name="Dominik Aumann" userId="013c187a20e8f01a" providerId="LiveId" clId="{ECAA7777-180A-4B5D-8194-D34F96268794}" dt="2024-02-25T22:54:13.063" v="87" actId="478"/>
          <ac:picMkLst>
            <pc:docMk/>
            <pc:sldMk cId="3278863017" sldId="265"/>
            <ac:picMk id="29" creationId="{E13E59E0-E6FF-1EB2-C1A4-50CF1BA211D9}"/>
          </ac:picMkLst>
        </pc:picChg>
        <pc:picChg chg="add del mod ord">
          <ac:chgData name="Dominik Aumann" userId="013c187a20e8f01a" providerId="LiveId" clId="{ECAA7777-180A-4B5D-8194-D34F96268794}" dt="2024-02-25T23:11:52.259" v="356" actId="478"/>
          <ac:picMkLst>
            <pc:docMk/>
            <pc:sldMk cId="3278863017" sldId="265"/>
            <ac:picMk id="30" creationId="{8F6B41DF-24EC-69B1-B681-CDC7364BC9DE}"/>
          </ac:picMkLst>
        </pc:picChg>
        <pc:picChg chg="add del mod ord">
          <ac:chgData name="Dominik Aumann" userId="013c187a20e8f01a" providerId="LiveId" clId="{ECAA7777-180A-4B5D-8194-D34F96268794}" dt="2024-02-25T23:09:08.187" v="326" actId="478"/>
          <ac:picMkLst>
            <pc:docMk/>
            <pc:sldMk cId="3278863017" sldId="265"/>
            <ac:picMk id="36" creationId="{AFC74FBF-249F-BF09-8013-52E4722A3E67}"/>
          </ac:picMkLst>
        </pc:picChg>
        <pc:picChg chg="add del mod ord">
          <ac:chgData name="Dominik Aumann" userId="013c187a20e8f01a" providerId="LiveId" clId="{ECAA7777-180A-4B5D-8194-D34F96268794}" dt="2024-02-25T23:08:39.663" v="322" actId="478"/>
          <ac:picMkLst>
            <pc:docMk/>
            <pc:sldMk cId="3278863017" sldId="265"/>
            <ac:picMk id="38" creationId="{06023DFB-7500-9627-0979-5C6C2E18BAD7}"/>
          </ac:picMkLst>
        </pc:picChg>
        <pc:picChg chg="add del mod">
          <ac:chgData name="Dominik Aumann" userId="013c187a20e8f01a" providerId="LiveId" clId="{ECAA7777-180A-4B5D-8194-D34F96268794}" dt="2024-02-25T23:07:32.783" v="300" actId="478"/>
          <ac:picMkLst>
            <pc:docMk/>
            <pc:sldMk cId="3278863017" sldId="265"/>
            <ac:picMk id="39" creationId="{6678E9BE-BF64-2A15-FC94-0AA256A6138F}"/>
          </ac:picMkLst>
        </pc:picChg>
        <pc:picChg chg="add del mod">
          <ac:chgData name="Dominik Aumann" userId="013c187a20e8f01a" providerId="LiveId" clId="{ECAA7777-180A-4B5D-8194-D34F96268794}" dt="2024-02-25T23:07:28.957" v="299" actId="478"/>
          <ac:picMkLst>
            <pc:docMk/>
            <pc:sldMk cId="3278863017" sldId="265"/>
            <ac:picMk id="40" creationId="{645D5178-804D-22A9-3C96-84563FE48D05}"/>
          </ac:picMkLst>
        </pc:picChg>
        <pc:picChg chg="add del mod">
          <ac:chgData name="Dominik Aumann" userId="013c187a20e8f01a" providerId="LiveId" clId="{ECAA7777-180A-4B5D-8194-D34F96268794}" dt="2024-02-25T23:11:44.932" v="353" actId="21"/>
          <ac:picMkLst>
            <pc:docMk/>
            <pc:sldMk cId="3278863017" sldId="265"/>
            <ac:picMk id="41" creationId="{6D8B0020-51F6-7AA4-9134-28FD710EA023}"/>
          </ac:picMkLst>
        </pc:picChg>
        <pc:picChg chg="mod">
          <ac:chgData name="Dominik Aumann" userId="013c187a20e8f01a" providerId="LiveId" clId="{ECAA7777-180A-4B5D-8194-D34F96268794}" dt="2024-02-25T23:06:17.739" v="287"/>
          <ac:picMkLst>
            <pc:docMk/>
            <pc:sldMk cId="3278863017" sldId="265"/>
            <ac:picMk id="44" creationId="{7453CBB0-4AE7-3528-69FD-B32C8A2A4D0C}"/>
          </ac:picMkLst>
        </pc:picChg>
        <pc:picChg chg="mod">
          <ac:chgData name="Dominik Aumann" userId="013c187a20e8f01a" providerId="LiveId" clId="{ECAA7777-180A-4B5D-8194-D34F96268794}" dt="2024-02-25T23:06:17.739" v="287"/>
          <ac:picMkLst>
            <pc:docMk/>
            <pc:sldMk cId="3278863017" sldId="265"/>
            <ac:picMk id="45" creationId="{77C6DFA7-D646-14A6-AD94-ECF9529E505C}"/>
          </ac:picMkLst>
        </pc:picChg>
        <pc:picChg chg="mod">
          <ac:chgData name="Dominik Aumann" userId="013c187a20e8f01a" providerId="LiveId" clId="{ECAA7777-180A-4B5D-8194-D34F96268794}" dt="2024-02-25T23:06:17.739" v="287"/>
          <ac:picMkLst>
            <pc:docMk/>
            <pc:sldMk cId="3278863017" sldId="265"/>
            <ac:picMk id="46" creationId="{D1A3A8A4-5822-B1DB-F2A5-83CE5D4D61F0}"/>
          </ac:picMkLst>
        </pc:picChg>
        <pc:picChg chg="mod">
          <ac:chgData name="Dominik Aumann" userId="013c187a20e8f01a" providerId="LiveId" clId="{ECAA7777-180A-4B5D-8194-D34F96268794}" dt="2024-02-25T23:06:17.739" v="287"/>
          <ac:picMkLst>
            <pc:docMk/>
            <pc:sldMk cId="3278863017" sldId="265"/>
            <ac:picMk id="47" creationId="{C17ECD5B-C34B-31F1-6512-F73E5AB915A8}"/>
          </ac:picMkLst>
        </pc:picChg>
        <pc:picChg chg="add del mod">
          <ac:chgData name="Dominik Aumann" userId="013c187a20e8f01a" providerId="LiveId" clId="{ECAA7777-180A-4B5D-8194-D34F96268794}" dt="2024-02-25T23:07:51.456" v="307" actId="478"/>
          <ac:picMkLst>
            <pc:docMk/>
            <pc:sldMk cId="3278863017" sldId="265"/>
            <ac:picMk id="131" creationId="{3C8BE22E-70EC-2277-A1DC-B724B48BA9A3}"/>
          </ac:picMkLst>
        </pc:picChg>
        <pc:picChg chg="add del mod">
          <ac:chgData name="Dominik Aumann" userId="013c187a20e8f01a" providerId="LiveId" clId="{ECAA7777-180A-4B5D-8194-D34F96268794}" dt="2024-02-25T23:07:50.768" v="306" actId="478"/>
          <ac:picMkLst>
            <pc:docMk/>
            <pc:sldMk cId="3278863017" sldId="265"/>
            <ac:picMk id="133" creationId="{C94C3ACD-BD8D-0A22-7F46-D39AAA166CFE}"/>
          </ac:picMkLst>
        </pc:picChg>
        <pc:picChg chg="add mod or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35" creationId="{66471B98-EFF4-6329-A64E-DAE3AF0C3070}"/>
          </ac:picMkLst>
        </pc:picChg>
        <pc:picChg chg="add del mod">
          <ac:chgData name="Dominik Aumann" userId="013c187a20e8f01a" providerId="LiveId" clId="{ECAA7777-180A-4B5D-8194-D34F96268794}" dt="2024-02-25T23:08:28.744" v="317" actId="21"/>
          <ac:picMkLst>
            <pc:docMk/>
            <pc:sldMk cId="3278863017" sldId="265"/>
            <ac:picMk id="137" creationId="{F3DFB92A-B788-EF3E-4DCF-D06EF9F44F17}"/>
          </ac:picMkLst>
        </pc:picChg>
        <pc:picChg chg="add del mod">
          <ac:chgData name="Dominik Aumann" userId="013c187a20e8f01a" providerId="LiveId" clId="{ECAA7777-180A-4B5D-8194-D34F96268794}" dt="2024-02-25T23:08:32.087" v="319" actId="21"/>
          <ac:picMkLst>
            <pc:docMk/>
            <pc:sldMk cId="3278863017" sldId="265"/>
            <ac:picMk id="138" creationId="{F3DFB92A-B788-EF3E-4DCF-D06EF9F44F17}"/>
          </ac:picMkLst>
        </pc:picChg>
        <pc:picChg chg="add mod or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39" creationId="{F3DFB92A-B788-EF3E-4DCF-D06EF9F44F17}"/>
          </ac:picMkLst>
        </pc:picChg>
        <pc:picChg chg="add del mod">
          <ac:chgData name="Dominik Aumann" userId="013c187a20e8f01a" providerId="LiveId" clId="{ECAA7777-180A-4B5D-8194-D34F96268794}" dt="2024-02-25T23:09:53.021" v="334" actId="21"/>
          <ac:picMkLst>
            <pc:docMk/>
            <pc:sldMk cId="3278863017" sldId="265"/>
            <ac:picMk id="140" creationId="{1394D757-7C40-63D1-4B2E-C2DB1AF64077}"/>
          </ac:picMkLst>
        </pc:picChg>
        <pc:picChg chg="add del mod">
          <ac:chgData name="Dominik Aumann" userId="013c187a20e8f01a" providerId="LiveId" clId="{ECAA7777-180A-4B5D-8194-D34F96268794}" dt="2024-02-25T23:09:55.067" v="336" actId="21"/>
          <ac:picMkLst>
            <pc:docMk/>
            <pc:sldMk cId="3278863017" sldId="265"/>
            <ac:picMk id="141" creationId="{1394D757-7C40-63D1-4B2E-C2DB1AF64077}"/>
          </ac:picMkLst>
        </pc:picChg>
        <pc:picChg chg="add del mod">
          <ac:chgData name="Dominik Aumann" userId="013c187a20e8f01a" providerId="LiveId" clId="{ECAA7777-180A-4B5D-8194-D34F96268794}" dt="2024-02-25T23:11:04.488" v="346" actId="21"/>
          <ac:picMkLst>
            <pc:docMk/>
            <pc:sldMk cId="3278863017" sldId="265"/>
            <ac:picMk id="142" creationId="{1394D757-7C40-63D1-4B2E-C2DB1AF64077}"/>
          </ac:picMkLst>
        </pc:picChg>
        <pc:picChg chg="add mo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43" creationId="{1394D757-7C40-63D1-4B2E-C2DB1AF64077}"/>
          </ac:picMkLst>
        </pc:picChg>
        <pc:picChg chg="add del mod">
          <ac:chgData name="Dominik Aumann" userId="013c187a20e8f01a" providerId="LiveId" clId="{ECAA7777-180A-4B5D-8194-D34F96268794}" dt="2024-02-25T23:11:49.790" v="355" actId="21"/>
          <ac:picMkLst>
            <pc:docMk/>
            <pc:sldMk cId="3278863017" sldId="265"/>
            <ac:picMk id="144" creationId="{6D8B0020-51F6-7AA4-9134-28FD710EA023}"/>
          </ac:picMkLst>
        </pc:picChg>
        <pc:picChg chg="add mo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45" creationId="{6D8B0020-51F6-7AA4-9134-28FD710EA023}"/>
          </ac:picMkLst>
        </pc:picChg>
        <pc:picChg chg="del mod topLvl">
          <ac:chgData name="Dominik Aumann" userId="013c187a20e8f01a" providerId="LiveId" clId="{ECAA7777-180A-4B5D-8194-D34F96268794}" dt="2024-02-25T23:25:26.613" v="560" actId="478"/>
          <ac:picMkLst>
            <pc:docMk/>
            <pc:sldMk cId="3278863017" sldId="265"/>
            <ac:picMk id="148" creationId="{2571012E-408E-65BE-AA4A-E864133CB905}"/>
          </ac:picMkLst>
        </pc:picChg>
        <pc:picChg chg="del mod">
          <ac:chgData name="Dominik Aumann" userId="013c187a20e8f01a" providerId="LiveId" clId="{ECAA7777-180A-4B5D-8194-D34F96268794}" dt="2024-02-25T23:24:40.967" v="548" actId="478"/>
          <ac:picMkLst>
            <pc:docMk/>
            <pc:sldMk cId="3278863017" sldId="265"/>
            <ac:picMk id="149" creationId="{7C625D6E-E57D-DFC2-6453-4E505A32BEDC}"/>
          </ac:picMkLst>
        </pc:picChg>
        <pc:picChg chg="add del mod">
          <ac:chgData name="Dominik Aumann" userId="013c187a20e8f01a" providerId="LiveId" clId="{ECAA7777-180A-4B5D-8194-D34F96268794}" dt="2024-02-25T23:36:43.943" v="718" actId="478"/>
          <ac:picMkLst>
            <pc:docMk/>
            <pc:sldMk cId="3278863017" sldId="265"/>
            <ac:picMk id="150" creationId="{54364B0A-BFB5-CD7B-AEF5-30BCFC61EDC9}"/>
          </ac:picMkLst>
        </pc:picChg>
        <pc:picChg chg="add del mod">
          <ac:chgData name="Dominik Aumann" userId="013c187a20e8f01a" providerId="LiveId" clId="{ECAA7777-180A-4B5D-8194-D34F96268794}" dt="2024-02-25T23:36:43.943" v="718" actId="478"/>
          <ac:picMkLst>
            <pc:docMk/>
            <pc:sldMk cId="3278863017" sldId="265"/>
            <ac:picMk id="151" creationId="{0D6283DE-E693-1FC5-E692-ECC59247560B}"/>
          </ac:picMkLst>
        </pc:picChg>
        <pc:picChg chg="del mod">
          <ac:chgData name="Dominik Aumann" userId="013c187a20e8f01a" providerId="LiveId" clId="{ECAA7777-180A-4B5D-8194-D34F96268794}" dt="2024-02-25T23:19:17.249" v="495" actId="478"/>
          <ac:picMkLst>
            <pc:docMk/>
            <pc:sldMk cId="3278863017" sldId="265"/>
            <ac:picMk id="155" creationId="{A4A52114-A24B-6973-804A-568C2878EB64}"/>
          </ac:picMkLst>
        </pc:picChg>
        <pc:picChg chg="del mod">
          <ac:chgData name="Dominik Aumann" userId="013c187a20e8f01a" providerId="LiveId" clId="{ECAA7777-180A-4B5D-8194-D34F96268794}" dt="2024-02-25T23:16:39.317" v="484" actId="478"/>
          <ac:picMkLst>
            <pc:docMk/>
            <pc:sldMk cId="3278863017" sldId="265"/>
            <ac:picMk id="157" creationId="{FF2C530D-8E94-72C3-A1CE-55C21D32B833}"/>
          </ac:picMkLst>
        </pc:picChg>
        <pc:picChg chg="add mod ord">
          <ac:chgData name="Dominik Aumann" userId="013c187a20e8f01a" providerId="LiveId" clId="{ECAA7777-180A-4B5D-8194-D34F96268794}" dt="2024-02-25T22:50:16.229" v="47" actId="167"/>
          <ac:picMkLst>
            <pc:docMk/>
            <pc:sldMk cId="3278863017" sldId="265"/>
            <ac:picMk id="160" creationId="{00000000-0000-0000-0000-000000000000}"/>
          </ac:picMkLst>
        </pc:picChg>
        <pc:picChg chg="add del mod">
          <ac:chgData name="Dominik Aumann" userId="013c187a20e8f01a" providerId="LiveId" clId="{ECAA7777-180A-4B5D-8194-D34F96268794}" dt="2024-02-25T23:09:50.131" v="332" actId="21"/>
          <ac:picMkLst>
            <pc:docMk/>
            <pc:sldMk cId="3278863017" sldId="265"/>
            <ac:picMk id="161" creationId="{1394D757-7C40-63D1-4B2E-C2DB1AF64077}"/>
          </ac:picMkLst>
        </pc:picChg>
        <pc:picChg chg="add del mod">
          <ac:chgData name="Dominik Aumann" userId="013c187a20e8f01a" providerId="LiveId" clId="{ECAA7777-180A-4B5D-8194-D34F96268794}" dt="2024-02-25T23:19:14.109" v="494" actId="21"/>
          <ac:picMkLst>
            <pc:docMk/>
            <pc:sldMk cId="3278863017" sldId="265"/>
            <ac:picMk id="186" creationId="{D5A50096-ACF3-D527-802C-47D38FE58728}"/>
          </ac:picMkLst>
        </pc:picChg>
        <pc:picChg chg="add del mod">
          <ac:chgData name="Dominik Aumann" userId="013c187a20e8f01a" providerId="LiveId" clId="{ECAA7777-180A-4B5D-8194-D34F96268794}" dt="2024-02-25T23:16:36.224" v="483" actId="21"/>
          <ac:picMkLst>
            <pc:docMk/>
            <pc:sldMk cId="3278863017" sldId="265"/>
            <ac:picMk id="187" creationId="{1D5DA54D-1340-F707-9894-DB1D0EF5F5C2}"/>
          </ac:picMkLst>
        </pc:picChg>
        <pc:picChg chg="add mod topLvl">
          <ac:chgData name="Dominik Aumann" userId="013c187a20e8f01a" providerId="LiveId" clId="{ECAA7777-180A-4B5D-8194-D34F96268794}" dt="2024-02-25T23:25:47.326" v="567" actId="164"/>
          <ac:picMkLst>
            <pc:docMk/>
            <pc:sldMk cId="3278863017" sldId="265"/>
            <ac:picMk id="188" creationId="{1D5DA54D-1340-F707-9894-DB1D0EF5F5C2}"/>
          </ac:picMkLst>
        </pc:picChg>
        <pc:picChg chg="add mod topLvl">
          <ac:chgData name="Dominik Aumann" userId="013c187a20e8f01a" providerId="LiveId" clId="{ECAA7777-180A-4B5D-8194-D34F96268794}" dt="2024-02-25T23:25:47.326" v="567" actId="164"/>
          <ac:picMkLst>
            <pc:docMk/>
            <pc:sldMk cId="3278863017" sldId="265"/>
            <ac:picMk id="189" creationId="{D5A50096-ACF3-D527-802C-47D38FE58728}"/>
          </ac:picMkLst>
        </pc:picChg>
        <pc:picChg chg="mo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91" creationId="{39900A31-DEBC-06E9-4501-C93BF67225D2}"/>
          </ac:picMkLst>
        </pc:picChg>
        <pc:picChg chg="add mod">
          <ac:chgData name="Dominik Aumann" userId="013c187a20e8f01a" providerId="LiveId" clId="{ECAA7777-180A-4B5D-8194-D34F96268794}" dt="2024-02-25T23:25:19.317" v="557" actId="1076"/>
          <ac:picMkLst>
            <pc:docMk/>
            <pc:sldMk cId="3278863017" sldId="265"/>
            <ac:picMk id="208" creationId="{B52362AE-8722-FB33-4C2F-62A5B8DCF245}"/>
          </ac:picMkLst>
        </pc:picChg>
        <pc:picChg chg="add del mod">
          <ac:chgData name="Dominik Aumann" userId="013c187a20e8f01a" providerId="LiveId" clId="{ECAA7777-180A-4B5D-8194-D34F96268794}" dt="2024-02-25T23:43:16.202" v="782" actId="478"/>
          <ac:picMkLst>
            <pc:docMk/>
            <pc:sldMk cId="3278863017" sldId="265"/>
            <ac:picMk id="256" creationId="{4FE48B4E-2ED1-F9D1-4E5E-EADBE8E13C4D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258" creationId="{9BD1702C-7DFF-9770-E074-D684323892B8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260" creationId="{FE9CD3A0-7755-E042-5E67-846B46E439B2}"/>
          </ac:picMkLst>
        </pc:picChg>
        <pc:picChg chg="mod">
          <ac:chgData name="Dominik Aumann" userId="013c187a20e8f01a" providerId="LiveId" clId="{ECAA7777-180A-4B5D-8194-D34F96268794}" dt="2024-02-25T23:40:34.655" v="766"/>
          <ac:picMkLst>
            <pc:docMk/>
            <pc:sldMk cId="3278863017" sldId="265"/>
            <ac:picMk id="1026" creationId="{C410F14F-1148-0801-3C4A-C5C3B8AFCFCC}"/>
          </ac:picMkLst>
        </pc:picChg>
        <pc:picChg chg="mo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027" creationId="{CEBAF491-B1F0-2728-95FC-5D452CB6E3A0}"/>
          </ac:picMkLst>
        </pc:picChg>
        <pc:picChg chg="mod">
          <ac:chgData name="Dominik Aumann" userId="013c187a20e8f01a" providerId="LiveId" clId="{ECAA7777-180A-4B5D-8194-D34F96268794}" dt="2024-02-25T23:22:31.523" v="514" actId="165"/>
          <ac:picMkLst>
            <pc:docMk/>
            <pc:sldMk cId="3278863017" sldId="265"/>
            <ac:picMk id="1031" creationId="{74C8CB48-1D9E-EE88-DBE1-C8F3A3A1AD91}"/>
          </ac:picMkLst>
        </pc:picChg>
        <pc:picChg chg="del mod">
          <ac:chgData name="Dominik Aumann" userId="013c187a20e8f01a" providerId="LiveId" clId="{ECAA7777-180A-4B5D-8194-D34F96268794}" dt="2024-02-25T23:33:04.092" v="666" actId="21"/>
          <ac:picMkLst>
            <pc:docMk/>
            <pc:sldMk cId="3278863017" sldId="265"/>
            <ac:picMk id="1051" creationId="{FB554C28-E94A-6FAD-3E32-0F3DF8B9C563}"/>
          </ac:picMkLst>
        </pc:picChg>
        <pc:picChg chg="del mod">
          <ac:chgData name="Dominik Aumann" userId="013c187a20e8f01a" providerId="LiveId" clId="{ECAA7777-180A-4B5D-8194-D34F96268794}" dt="2024-02-25T23:33:04.092" v="666" actId="21"/>
          <ac:picMkLst>
            <pc:docMk/>
            <pc:sldMk cId="3278863017" sldId="265"/>
            <ac:picMk id="1052" creationId="{400F9B8C-370A-5AC8-5E34-3FD2F4905495}"/>
          </ac:picMkLst>
        </pc:picChg>
        <pc:picChg chg="del mod topLvl">
          <ac:chgData name="Dominik Aumann" userId="013c187a20e8f01a" providerId="LiveId" clId="{ECAA7777-180A-4B5D-8194-D34F96268794}" dt="2024-02-25T23:33:04.092" v="666" actId="21"/>
          <ac:picMkLst>
            <pc:docMk/>
            <pc:sldMk cId="3278863017" sldId="265"/>
            <ac:picMk id="1054" creationId="{50680350-2EC3-E123-C23A-3111ACF0D17B}"/>
          </ac:picMkLst>
        </pc:picChg>
        <pc:picChg chg="del mod">
          <ac:chgData name="Dominik Aumann" userId="013c187a20e8f01a" providerId="LiveId" clId="{ECAA7777-180A-4B5D-8194-D34F96268794}" dt="2024-02-25T23:33:04.092" v="666" actId="21"/>
          <ac:picMkLst>
            <pc:docMk/>
            <pc:sldMk cId="3278863017" sldId="265"/>
            <ac:picMk id="1055" creationId="{FF55B0A7-7D62-CFE1-2475-06077F9E39F0}"/>
          </ac:picMkLst>
        </pc:picChg>
        <pc:picChg chg="del mod topLvl">
          <ac:chgData name="Dominik Aumann" userId="013c187a20e8f01a" providerId="LiveId" clId="{ECAA7777-180A-4B5D-8194-D34F96268794}" dt="2024-02-25T23:36:34.430" v="715" actId="21"/>
          <ac:picMkLst>
            <pc:docMk/>
            <pc:sldMk cId="3278863017" sldId="265"/>
            <ac:picMk id="1075" creationId="{39FFF99A-0C44-8D49-8066-7977B06FD1C9}"/>
          </ac:picMkLst>
        </pc:picChg>
        <pc:picChg chg="del mod">
          <ac:chgData name="Dominik Aumann" userId="013c187a20e8f01a" providerId="LiveId" clId="{ECAA7777-180A-4B5D-8194-D34F96268794}" dt="2024-02-25T23:36:28.790" v="713" actId="21"/>
          <ac:picMkLst>
            <pc:docMk/>
            <pc:sldMk cId="3278863017" sldId="265"/>
            <ac:picMk id="1076" creationId="{07444445-3D8C-11B1-4DAF-52CB8E571A8B}"/>
          </ac:picMkLst>
        </pc:picChg>
        <pc:picChg chg="add del mod">
          <ac:chgData name="Dominik Aumann" userId="013c187a20e8f01a" providerId="LiveId" clId="{ECAA7777-180A-4B5D-8194-D34F96268794}" dt="2024-02-25T23:36:22.229" v="711" actId="21"/>
          <ac:picMkLst>
            <pc:docMk/>
            <pc:sldMk cId="3278863017" sldId="265"/>
            <ac:picMk id="1096" creationId="{F33F0FBE-EBB2-F96A-2B39-B3EB3D4EE4E3}"/>
          </ac:picMkLst>
        </pc:picChg>
        <pc:picChg chg="add del mod">
          <ac:chgData name="Dominik Aumann" userId="013c187a20e8f01a" providerId="LiveId" clId="{ECAA7777-180A-4B5D-8194-D34F96268794}" dt="2024-02-25T23:36:22.229" v="711" actId="21"/>
          <ac:picMkLst>
            <pc:docMk/>
            <pc:sldMk cId="3278863017" sldId="265"/>
            <ac:picMk id="1097" creationId="{38846134-33E2-23AB-1F0D-1D55E2ED2AC4}"/>
          </ac:picMkLst>
        </pc:picChg>
        <pc:picChg chg="del mod">
          <ac:chgData name="Dominik Aumann" userId="013c187a20e8f01a" providerId="LiveId" clId="{ECAA7777-180A-4B5D-8194-D34F96268794}" dt="2024-02-25T23:28:20.565" v="601" actId="478"/>
          <ac:picMkLst>
            <pc:docMk/>
            <pc:sldMk cId="3278863017" sldId="265"/>
            <ac:picMk id="1099" creationId="{FB65145F-E546-7A38-613B-F6F5B57FF50F}"/>
          </ac:picMkLst>
        </pc:picChg>
        <pc:picChg chg="del mod">
          <ac:chgData name="Dominik Aumann" userId="013c187a20e8f01a" providerId="LiveId" clId="{ECAA7777-180A-4B5D-8194-D34F96268794}" dt="2024-02-25T23:27:50.432" v="592" actId="478"/>
          <ac:picMkLst>
            <pc:docMk/>
            <pc:sldMk cId="3278863017" sldId="265"/>
            <ac:picMk id="1100" creationId="{45966614-16F2-9AC3-C62A-6E1251CC9DE3}"/>
          </ac:picMkLst>
        </pc:picChg>
        <pc:picChg chg="add del mod">
          <ac:chgData name="Dominik Aumann" userId="013c187a20e8f01a" providerId="LiveId" clId="{ECAA7777-180A-4B5D-8194-D34F96268794}" dt="2024-02-25T23:31:23.209" v="638" actId="21"/>
          <ac:picMkLst>
            <pc:docMk/>
            <pc:sldMk cId="3278863017" sldId="265"/>
            <ac:picMk id="1101" creationId="{D02A10FF-6EFE-D473-5195-DB9A79D2CDDE}"/>
          </ac:picMkLst>
        </pc:picChg>
        <pc:picChg chg="add del mod">
          <ac:chgData name="Dominik Aumann" userId="013c187a20e8f01a" providerId="LiveId" clId="{ECAA7777-180A-4B5D-8194-D34F96268794}" dt="2024-02-25T23:31:23.209" v="638" actId="21"/>
          <ac:picMkLst>
            <pc:docMk/>
            <pc:sldMk cId="3278863017" sldId="265"/>
            <ac:picMk id="1102" creationId="{BCF98992-4748-7771-3192-49CF96B82650}"/>
          </ac:picMkLst>
        </pc:picChg>
        <pc:picChg chg="add mod">
          <ac:chgData name="Dominik Aumann" userId="013c187a20e8f01a" providerId="LiveId" clId="{ECAA7777-180A-4B5D-8194-D34F96268794}" dt="2024-02-25T23:25:47.326" v="567" actId="164"/>
          <ac:picMkLst>
            <pc:docMk/>
            <pc:sldMk cId="3278863017" sldId="265"/>
            <ac:picMk id="1122" creationId="{08C6F451-364C-42A1-33E9-7DBD9643D9DF}"/>
          </ac:picMkLst>
        </pc:picChg>
        <pc:picChg chg="add mod">
          <ac:chgData name="Dominik Aumann" userId="013c187a20e8f01a" providerId="LiveId" clId="{ECAA7777-180A-4B5D-8194-D34F96268794}" dt="2024-02-25T23:25:47.326" v="567" actId="164"/>
          <ac:picMkLst>
            <pc:docMk/>
            <pc:sldMk cId="3278863017" sldId="265"/>
            <ac:picMk id="1124" creationId="{B52362AE-8722-FB33-4C2F-62A5B8DCF245}"/>
          </ac:picMkLst>
        </pc:picChg>
        <pc:picChg chg="add del mod ord">
          <ac:chgData name="Dominik Aumann" userId="013c187a20e8f01a" providerId="LiveId" clId="{ECAA7777-180A-4B5D-8194-D34F96268794}" dt="2024-02-25T23:27:48.369" v="591" actId="21"/>
          <ac:picMkLst>
            <pc:docMk/>
            <pc:sldMk cId="3278863017" sldId="265"/>
            <ac:picMk id="1128" creationId="{D4911CF4-B249-45A2-6461-B83174A7EEDE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29" creationId="{D4911CF4-B249-45A2-6461-B83174A7EEDE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30" creationId="{EBA584F0-2152-C0A6-6BF8-DE3BC8AF11A5}"/>
          </ac:picMkLst>
        </pc:picChg>
        <pc:picChg chg="add mod">
          <ac:chgData name="Dominik Aumann" userId="013c187a20e8f01a" providerId="LiveId" clId="{ECAA7777-180A-4B5D-8194-D34F96268794}" dt="2024-02-25T23:30:57.028" v="630"/>
          <ac:picMkLst>
            <pc:docMk/>
            <pc:sldMk cId="3278863017" sldId="265"/>
            <ac:picMk id="1132" creationId="{AE8931EB-8D3D-BEE2-4159-79A8C8D8B6B3}"/>
          </ac:picMkLst>
        </pc:picChg>
        <pc:picChg chg="add mod">
          <ac:chgData name="Dominik Aumann" userId="013c187a20e8f01a" providerId="LiveId" clId="{ECAA7777-180A-4B5D-8194-D34F96268794}" dt="2024-02-25T23:30:57.028" v="630"/>
          <ac:picMkLst>
            <pc:docMk/>
            <pc:sldMk cId="3278863017" sldId="265"/>
            <ac:picMk id="1133" creationId="{EFCFAAF2-CA08-3DAF-9B81-E54F6C560996}"/>
          </ac:picMkLst>
        </pc:picChg>
        <pc:picChg chg="add del mo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34" creationId="{B107FDB0-BAA8-18EF-0A5E-CD646D0AA335}"/>
          </ac:picMkLst>
        </pc:picChg>
        <pc:picChg chg="add del mo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35" creationId="{31D08368-05B5-8AAC-20B6-F3969148CCFB}"/>
          </ac:picMkLst>
        </pc:picChg>
        <pc:picChg chg="add mod">
          <ac:chgData name="Dominik Aumann" userId="013c187a20e8f01a" providerId="LiveId" clId="{ECAA7777-180A-4B5D-8194-D34F96268794}" dt="2024-02-25T23:36:45.021" v="719"/>
          <ac:picMkLst>
            <pc:docMk/>
            <pc:sldMk cId="3278863017" sldId="265"/>
            <ac:picMk id="1136" creationId="{D8272031-C8DC-B23F-394F-6CB0606F45C4}"/>
          </ac:picMkLst>
        </pc:picChg>
        <pc:picChg chg="add mod">
          <ac:chgData name="Dominik Aumann" userId="013c187a20e8f01a" providerId="LiveId" clId="{ECAA7777-180A-4B5D-8194-D34F96268794}" dt="2024-02-25T23:36:45.021" v="719"/>
          <ac:picMkLst>
            <pc:docMk/>
            <pc:sldMk cId="3278863017" sldId="265"/>
            <ac:picMk id="1137" creationId="{F54CED45-2645-D248-09AE-35AF6EF52928}"/>
          </ac:picMkLst>
        </pc:picChg>
        <pc:picChg chg="add del mod">
          <ac:chgData name="Dominik Aumann" userId="013c187a20e8f01a" providerId="LiveId" clId="{ECAA7777-180A-4B5D-8194-D34F96268794}" dt="2024-02-25T23:42:45.976" v="771" actId="21"/>
          <ac:picMkLst>
            <pc:docMk/>
            <pc:sldMk cId="3278863017" sldId="265"/>
            <ac:picMk id="1138" creationId="{628E773B-A9F4-87F3-84AB-EF722F9844C4}"/>
          </ac:picMkLst>
        </pc:picChg>
        <pc:picChg chg="add del mod">
          <ac:chgData name="Dominik Aumann" userId="013c187a20e8f01a" providerId="LiveId" clId="{ECAA7777-180A-4B5D-8194-D34F96268794}" dt="2024-02-25T23:42:48.225" v="773" actId="21"/>
          <ac:picMkLst>
            <pc:docMk/>
            <pc:sldMk cId="3278863017" sldId="265"/>
            <ac:picMk id="1139" creationId="{628E773B-A9F4-87F3-84AB-EF722F9844C4}"/>
          </ac:picMkLst>
        </pc:picChg>
        <pc:picChg chg="add del mo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40" creationId="{4B1BA9DB-B771-D880-4E8F-0C26DD9C757A}"/>
          </ac:picMkLst>
        </pc:picChg>
        <pc:picChg chg="add del mo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41" creationId="{7936FDDC-FCFA-CA1C-5EF3-818F69D973CA}"/>
          </ac:picMkLst>
        </pc:picChg>
        <pc:picChg chg="add del mod">
          <ac:chgData name="Dominik Aumann" userId="013c187a20e8f01a" providerId="LiveId" clId="{ECAA7777-180A-4B5D-8194-D34F96268794}" dt="2024-02-25T23:43:40.369" v="789" actId="21"/>
          <ac:picMkLst>
            <pc:docMk/>
            <pc:sldMk cId="3278863017" sldId="265"/>
            <ac:picMk id="1142" creationId="{628E773B-A9F4-87F3-84AB-EF722F9844C4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43" creationId="{D939925E-C575-B8E4-7941-F21E64AB7CC0}"/>
          </ac:picMkLst>
        </pc:picChg>
        <pc:picChg chg="add del mod">
          <ac:chgData name="Dominik Aumann" userId="013c187a20e8f01a" providerId="LiveId" clId="{ECAA7777-180A-4B5D-8194-D34F96268794}" dt="2024-02-25T23:43:42.025" v="791" actId="21"/>
          <ac:picMkLst>
            <pc:docMk/>
            <pc:sldMk cId="3278863017" sldId="265"/>
            <ac:picMk id="1144" creationId="{628E773B-A9F4-87F3-84AB-EF722F9844C4}"/>
          </ac:picMkLst>
        </pc:picChg>
        <pc:picChg chg="add del mod ord">
          <ac:chgData name="Dominik Aumann" userId="013c187a20e8f01a" providerId="LiveId" clId="{ECAA7777-180A-4B5D-8194-D34F96268794}" dt="2024-02-25T23:43:01.925" v="777" actId="478"/>
          <ac:picMkLst>
            <pc:docMk/>
            <pc:sldMk cId="3278863017" sldId="265"/>
            <ac:picMk id="1145" creationId="{8365D3CC-9537-8489-1E24-B46D895B134E}"/>
          </ac:picMkLst>
        </pc:picChg>
        <pc:picChg chg="add del mod">
          <ac:chgData name="Dominik Aumann" userId="013c187a20e8f01a" providerId="LiveId" clId="{ECAA7777-180A-4B5D-8194-D34F96268794}" dt="2024-02-25T23:43:44.368" v="793" actId="21"/>
          <ac:picMkLst>
            <pc:docMk/>
            <pc:sldMk cId="3278863017" sldId="265"/>
            <ac:picMk id="1146" creationId="{628E773B-A9F4-87F3-84AB-EF722F9844C4}"/>
          </ac:picMkLst>
        </pc:picChg>
        <pc:picChg chg="add mod">
          <ac:chgData name="Dominik Aumann" userId="013c187a20e8f01a" providerId="LiveId" clId="{ECAA7777-180A-4B5D-8194-D34F96268794}" dt="2024-02-25T23:38:46.711" v="742"/>
          <ac:picMkLst>
            <pc:docMk/>
            <pc:sldMk cId="3278863017" sldId="265"/>
            <ac:picMk id="1147" creationId="{F33F0FBE-EBB2-F96A-2B39-B3EB3D4EE4E3}"/>
          </ac:picMkLst>
        </pc:picChg>
        <pc:cxnChg chg="mod topLvl">
          <ac:chgData name="Dominik Aumann" userId="013c187a20e8f01a" providerId="LiveId" clId="{ECAA7777-180A-4B5D-8194-D34F96268794}" dt="2024-02-25T22:50:17.401" v="49" actId="165"/>
          <ac:cxnSpMkLst>
            <pc:docMk/>
            <pc:sldMk cId="3278863017" sldId="265"/>
            <ac:cxnSpMk id="20" creationId="{F6753DB3-7084-EF84-97DC-363A32D90A27}"/>
          </ac:cxnSpMkLst>
        </pc:cxnChg>
        <pc:cxnChg chg="mod topLvl">
          <ac:chgData name="Dominik Aumann" userId="013c187a20e8f01a" providerId="LiveId" clId="{ECAA7777-180A-4B5D-8194-D34F96268794}" dt="2024-02-25T22:50:17.401" v="49" actId="165"/>
          <ac:cxnSpMkLst>
            <pc:docMk/>
            <pc:sldMk cId="3278863017" sldId="265"/>
            <ac:cxnSpMk id="21" creationId="{0774FF28-31C4-FB34-150B-107AA66BA158}"/>
          </ac:cxnSpMkLst>
        </pc:cxnChg>
        <pc:cxnChg chg="mod topLvl">
          <ac:chgData name="Dominik Aumann" userId="013c187a20e8f01a" providerId="LiveId" clId="{ECAA7777-180A-4B5D-8194-D34F96268794}" dt="2024-02-25T22:50:17.401" v="49" actId="165"/>
          <ac:cxnSpMkLst>
            <pc:docMk/>
            <pc:sldMk cId="3278863017" sldId="265"/>
            <ac:cxnSpMk id="22" creationId="{84CF1A25-ED39-74C9-2A38-5787272762CB}"/>
          </ac:cxnSpMkLst>
        </pc:cxnChg>
        <pc:cxnChg chg="mod">
          <ac:chgData name="Dominik Aumann" userId="013c187a20e8f01a" providerId="LiveId" clId="{ECAA7777-180A-4B5D-8194-D34F96268794}" dt="2024-02-25T23:06:17.739" v="287"/>
          <ac:cxnSpMkLst>
            <pc:docMk/>
            <pc:sldMk cId="3278863017" sldId="265"/>
            <ac:cxnSpMk id="60" creationId="{2468FF53-5D9E-D38F-4890-2F799ACDAEE9}"/>
          </ac:cxnSpMkLst>
        </pc:cxnChg>
        <pc:cxnChg chg="mod">
          <ac:chgData name="Dominik Aumann" userId="013c187a20e8f01a" providerId="LiveId" clId="{ECAA7777-180A-4B5D-8194-D34F96268794}" dt="2024-02-25T23:06:17.739" v="287"/>
          <ac:cxnSpMkLst>
            <pc:docMk/>
            <pc:sldMk cId="3278863017" sldId="265"/>
            <ac:cxnSpMk id="61" creationId="{9F796DB9-DDAD-2BEB-C6FB-EBA198A81086}"/>
          </ac:cxnSpMkLst>
        </pc:cxnChg>
        <pc:cxnChg chg="mod">
          <ac:chgData name="Dominik Aumann" userId="013c187a20e8f01a" providerId="LiveId" clId="{ECAA7777-180A-4B5D-8194-D34F96268794}" dt="2024-02-25T23:06:17.739" v="287"/>
          <ac:cxnSpMkLst>
            <pc:docMk/>
            <pc:sldMk cId="3278863017" sldId="265"/>
            <ac:cxnSpMk id="62" creationId="{B25E72E3-1535-07F0-1C61-C8D39E693EB9}"/>
          </ac:cxnSpMkLst>
        </pc:cxnChg>
        <pc:cxnChg chg="del mod">
          <ac:chgData name="Dominik Aumann" userId="013c187a20e8f01a" providerId="LiveId" clId="{ECAA7777-180A-4B5D-8194-D34F96268794}" dt="2024-02-25T23:24:39.608" v="547" actId="478"/>
          <ac:cxnSpMkLst>
            <pc:docMk/>
            <pc:sldMk cId="3278863017" sldId="265"/>
            <ac:cxnSpMk id="178" creationId="{18B9CFCC-78D5-5832-9EF3-549971C0C988}"/>
          </ac:cxnSpMkLst>
        </pc:cxnChg>
        <pc:cxnChg chg="del mod topLvl">
          <ac:chgData name="Dominik Aumann" userId="013c187a20e8f01a" providerId="LiveId" clId="{ECAA7777-180A-4B5D-8194-D34F96268794}" dt="2024-02-25T23:25:36.642" v="565" actId="478"/>
          <ac:cxnSpMkLst>
            <pc:docMk/>
            <pc:sldMk cId="3278863017" sldId="265"/>
            <ac:cxnSpMk id="179" creationId="{694441C8-00B9-D601-24ED-C1648B51396C}"/>
          </ac:cxnSpMkLst>
        </pc:cxnChg>
        <pc:cxnChg chg="del mod topLvl">
          <ac:chgData name="Dominik Aumann" userId="013c187a20e8f01a" providerId="LiveId" clId="{ECAA7777-180A-4B5D-8194-D34F96268794}" dt="2024-02-25T23:25:35.860" v="564" actId="478"/>
          <ac:cxnSpMkLst>
            <pc:docMk/>
            <pc:sldMk cId="3278863017" sldId="265"/>
            <ac:cxnSpMk id="180" creationId="{A3F9B015-F9FB-E546-89E5-FCC2BAE6A3F2}"/>
          </ac:cxnSpMkLst>
        </pc:cxnChg>
        <pc:cxnChg chg="add mod">
          <ac:chgData name="Dominik Aumann" userId="013c187a20e8f01a" providerId="LiveId" clId="{ECAA7777-180A-4B5D-8194-D34F96268794}" dt="2024-02-25T23:25:19.317" v="557" actId="1076"/>
          <ac:cxnSpMkLst>
            <pc:docMk/>
            <pc:sldMk cId="3278863017" sldId="265"/>
            <ac:cxnSpMk id="230" creationId="{200FCF69-6B0C-BD31-3A5D-430B66D96BE2}"/>
          </ac:cxnSpMkLst>
        </pc:cxnChg>
        <pc:cxnChg chg="add mod">
          <ac:chgData name="Dominik Aumann" userId="013c187a20e8f01a" providerId="LiveId" clId="{ECAA7777-180A-4B5D-8194-D34F96268794}" dt="2024-02-25T23:25:19.317" v="557" actId="1076"/>
          <ac:cxnSpMkLst>
            <pc:docMk/>
            <pc:sldMk cId="3278863017" sldId="265"/>
            <ac:cxnSpMk id="231" creationId="{93EEBFBE-CF54-4DF5-8DF4-D0CFA210121B}"/>
          </ac:cxnSpMkLst>
        </pc:cxnChg>
        <pc:cxnChg chg="add del 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28" creationId="{7447C5E2-C36B-7167-EB69-EAB0EA9712A0}"/>
          </ac:cxnSpMkLst>
        </pc:cxnChg>
        <pc:cxnChg chg="add del 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29" creationId="{814FDDF8-D4AE-26D1-4049-878776A468FA}"/>
          </ac:cxnSpMkLst>
        </pc:cxnChg>
        <pc:cxnChg chg="add del 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30" creationId="{0D9F5EB2-F795-A4BF-6D5A-CB2780182EF4}"/>
          </ac:cxnSpMkLst>
        </pc:cxnChg>
        <pc:cxnChg chg="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44" creationId="{063EC570-34D1-3ECB-037C-BBF555B715FB}"/>
          </ac:cxnSpMkLst>
        </pc:cxnChg>
        <pc:cxnChg chg="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45" creationId="{F74DF13D-C2ED-D2BD-03BE-9709777EB412}"/>
          </ac:cxnSpMkLst>
        </pc:cxnChg>
        <pc:cxnChg chg="mod">
          <ac:chgData name="Dominik Aumann" userId="013c187a20e8f01a" providerId="LiveId" clId="{ECAA7777-180A-4B5D-8194-D34F96268794}" dt="2024-02-25T23:22:31.523" v="514" actId="165"/>
          <ac:cxnSpMkLst>
            <pc:docMk/>
            <pc:sldMk cId="3278863017" sldId="265"/>
            <ac:cxnSpMk id="1046" creationId="{16961408-C98B-3645-61E6-232032625988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068" creationId="{F9B9E21C-7BFC-47B9-7BB3-04CE572B9C12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069" creationId="{9CB70B09-D62D-49B3-30EE-7659B8311D77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070" creationId="{AF19F853-7763-A655-F9DB-DBD421144542}"/>
          </ac:cxnSpMkLst>
        </pc:cxnChg>
        <pc:cxnChg chg="del mod topLvl">
          <ac:chgData name="Dominik Aumann" userId="013c187a20e8f01a" providerId="LiveId" clId="{ECAA7777-180A-4B5D-8194-D34F96268794}" dt="2024-02-25T23:43:16.202" v="782" actId="478"/>
          <ac:cxnSpMkLst>
            <pc:docMk/>
            <pc:sldMk cId="3278863017" sldId="265"/>
            <ac:cxnSpMk id="1090" creationId="{78671DE7-6E07-09A7-992E-5FC9068D8327}"/>
          </ac:cxnSpMkLst>
        </pc:cxnChg>
        <pc:cxnChg chg="del mod topLvl">
          <ac:chgData name="Dominik Aumann" userId="013c187a20e8f01a" providerId="LiveId" clId="{ECAA7777-180A-4B5D-8194-D34F96268794}" dt="2024-02-25T23:43:19.702" v="783" actId="478"/>
          <ac:cxnSpMkLst>
            <pc:docMk/>
            <pc:sldMk cId="3278863017" sldId="265"/>
            <ac:cxnSpMk id="1091" creationId="{EC3416FD-8EBA-57FE-88A2-30C5C0D725F3}"/>
          </ac:cxnSpMkLst>
        </pc:cxnChg>
        <pc:cxnChg chg="del mod topLvl">
          <ac:chgData name="Dominik Aumann" userId="013c187a20e8f01a" providerId="LiveId" clId="{ECAA7777-180A-4B5D-8194-D34F96268794}" dt="2024-02-25T23:43:19.702" v="783" actId="478"/>
          <ac:cxnSpMkLst>
            <pc:docMk/>
            <pc:sldMk cId="3278863017" sldId="265"/>
            <ac:cxnSpMk id="1092" creationId="{7907FB5B-33F3-58E1-AE14-EF177E0B199D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115" creationId="{32C94BEF-608B-217D-6C83-A11356131A02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116" creationId="{D93F29DA-437E-5477-6194-409183F2C0E6}"/>
          </ac:cxnSpMkLst>
        </pc:cxnChg>
        <pc:cxnChg chg="mod">
          <ac:chgData name="Dominik Aumann" userId="013c187a20e8f01a" providerId="LiveId" clId="{ECAA7777-180A-4B5D-8194-D34F96268794}" dt="2024-02-25T23:21:22.116" v="505"/>
          <ac:cxnSpMkLst>
            <pc:docMk/>
            <pc:sldMk cId="3278863017" sldId="265"/>
            <ac:cxnSpMk id="1117" creationId="{03B3FB97-C8CC-DC68-9E04-2F940CEE30D5}"/>
          </ac:cxnSpMkLst>
        </pc:cxnChg>
        <pc:cxnChg chg="add mod">
          <ac:chgData name="Dominik Aumann" userId="013c187a20e8f01a" providerId="LiveId" clId="{ECAA7777-180A-4B5D-8194-D34F96268794}" dt="2024-02-25T23:25:47.326" v="567" actId="164"/>
          <ac:cxnSpMkLst>
            <pc:docMk/>
            <pc:sldMk cId="3278863017" sldId="265"/>
            <ac:cxnSpMk id="1123" creationId="{22681791-9121-B6FE-9C98-699BF2C40EFC}"/>
          </ac:cxnSpMkLst>
        </pc:cxnChg>
        <pc:cxnChg chg="add mod">
          <ac:chgData name="Dominik Aumann" userId="013c187a20e8f01a" providerId="LiveId" clId="{ECAA7777-180A-4B5D-8194-D34F96268794}" dt="2024-02-25T23:25:47.326" v="567" actId="164"/>
          <ac:cxnSpMkLst>
            <pc:docMk/>
            <pc:sldMk cId="3278863017" sldId="265"/>
            <ac:cxnSpMk id="1125" creationId="{200FCF69-6B0C-BD31-3A5D-430B66D96BE2}"/>
          </ac:cxnSpMkLst>
        </pc:cxnChg>
        <pc:cxnChg chg="add mod">
          <ac:chgData name="Dominik Aumann" userId="013c187a20e8f01a" providerId="LiveId" clId="{ECAA7777-180A-4B5D-8194-D34F96268794}" dt="2024-02-25T23:25:47.326" v="567" actId="164"/>
          <ac:cxnSpMkLst>
            <pc:docMk/>
            <pc:sldMk cId="3278863017" sldId="265"/>
            <ac:cxnSpMk id="1126" creationId="{93EEBFBE-CF54-4DF5-8DF4-D0CFA210121B}"/>
          </ac:cxnSpMkLst>
        </pc:cxnChg>
      </pc:sldChg>
      <pc:sldChg chg="addSp delSp modSp add del mod ord">
        <pc:chgData name="Dominik Aumann" userId="013c187a20e8f01a" providerId="LiveId" clId="{ECAA7777-180A-4B5D-8194-D34F96268794}" dt="2024-02-25T23:36:56.815" v="720" actId="47"/>
        <pc:sldMkLst>
          <pc:docMk/>
          <pc:sldMk cId="573917548" sldId="266"/>
        </pc:sldMkLst>
        <pc:spChg chg="del">
          <ac:chgData name="Dominik Aumann" userId="013c187a20e8f01a" providerId="LiveId" clId="{ECAA7777-180A-4B5D-8194-D34F96268794}" dt="2024-02-25T23:29:46.076" v="624" actId="21"/>
          <ac:spMkLst>
            <pc:docMk/>
            <pc:sldMk cId="573917548" sldId="266"/>
            <ac:spMk id="142" creationId="{DB39C730-B8FB-F77A-859F-BB2708A55AF0}"/>
          </ac:spMkLst>
        </pc:spChg>
        <pc:spChg chg="del mod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145" creationId="{36EFA931-C14F-4331-262C-FF8A51B11A07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66" creationId="{F8709962-E54B-E003-3950-7A88347F23E1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67" creationId="{A22BA541-F355-CF81-635F-48946D5424A7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69" creationId="{E0B01641-2D78-4947-027E-30CBAB14CF9F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0" creationId="{866273C7-5564-AFFA-4D11-375E4A53512F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1" creationId="{57E9CC42-3409-7DC6-FB91-B339198A3DB7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2" creationId="{928B0346-2B5E-D8E8-E459-ACD37566489E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3" creationId="{9DFDCB2B-A802-A205-C523-7F65610775FE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4" creationId="{810B6235-1131-520D-9601-420A6382C142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5" creationId="{CF5C4C5E-0873-400F-A9CE-A04986DEE7FC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6" creationId="{E64B50D9-21B1-CB56-A27A-3C84B5B311A8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7" creationId="{4DECACD3-F1BB-1EE2-664D-32AAF4CF76CC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8" creationId="{408E868E-98EF-0770-9B39-C1954980F42B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79" creationId="{FCF4ED2E-E910-1DB8-2ECD-B23DECADC665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80" creationId="{89724508-7A2E-315E-78BF-65043DDD2F3C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81" creationId="{74D78EAF-87EB-A5E3-6723-E5914BCEA894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182" creationId="{54B044EA-A9C9-5A59-C89F-9960C319A124}"/>
          </ac:spMkLst>
        </pc:spChg>
        <pc:spChg chg="del">
          <ac:chgData name="Dominik Aumann" userId="013c187a20e8f01a" providerId="LiveId" clId="{ECAA7777-180A-4B5D-8194-D34F96268794}" dt="2024-02-25T23:28:34.749" v="604" actId="478"/>
          <ac:spMkLst>
            <pc:docMk/>
            <pc:sldMk cId="573917548" sldId="266"/>
            <ac:spMk id="185" creationId="{E0759D85-81E0-DA4A-1DF9-95A08CC1E366}"/>
          </ac:spMkLst>
        </pc:spChg>
        <pc:spChg chg="del">
          <ac:chgData name="Dominik Aumann" userId="013c187a20e8f01a" providerId="LiveId" clId="{ECAA7777-180A-4B5D-8194-D34F96268794}" dt="2024-02-25T23:29:42.483" v="623" actId="478"/>
          <ac:spMkLst>
            <pc:docMk/>
            <pc:sldMk cId="573917548" sldId="266"/>
            <ac:spMk id="186" creationId="{E72E386E-A269-1CDB-41BD-AD45F2EFD475}"/>
          </ac:spMkLst>
        </pc:spChg>
        <pc:spChg chg="del">
          <ac:chgData name="Dominik Aumann" userId="013c187a20e8f01a" providerId="LiveId" clId="{ECAA7777-180A-4B5D-8194-D34F96268794}" dt="2024-02-25T23:29:42.483" v="623" actId="478"/>
          <ac:spMkLst>
            <pc:docMk/>
            <pc:sldMk cId="573917548" sldId="266"/>
            <ac:spMk id="188" creationId="{37E751CD-6C7E-672B-313E-9927041DD762}"/>
          </ac:spMkLst>
        </pc:spChg>
        <pc:spChg chg="mod">
          <ac:chgData name="Dominik Aumann" userId="013c187a20e8f01a" providerId="LiveId" clId="{ECAA7777-180A-4B5D-8194-D34F96268794}" dt="2024-02-25T23:21:57.268" v="508" actId="21"/>
          <ac:spMkLst>
            <pc:docMk/>
            <pc:sldMk cId="573917548" sldId="266"/>
            <ac:spMk id="189" creationId="{B6C83C7F-15AC-323D-6FE3-0D58CC34618E}"/>
          </ac:spMkLst>
        </pc:spChg>
        <pc:spChg chg="add del mod">
          <ac:chgData name="Dominik Aumann" userId="013c187a20e8f01a" providerId="LiveId" clId="{ECAA7777-180A-4B5D-8194-D34F96268794}" dt="2024-02-25T23:28:40.466" v="607" actId="21"/>
          <ac:spMkLst>
            <pc:docMk/>
            <pc:sldMk cId="573917548" sldId="266"/>
            <ac:spMk id="190" creationId="{745B84A2-87A9-EBFD-E3D9-4C6179B12765}"/>
          </ac:spMkLst>
        </pc:spChg>
        <pc:spChg chg="del">
          <ac:chgData name="Dominik Aumann" userId="013c187a20e8f01a" providerId="LiveId" clId="{ECAA7777-180A-4B5D-8194-D34F96268794}" dt="2024-02-25T23:28:34.749" v="604" actId="478"/>
          <ac:spMkLst>
            <pc:docMk/>
            <pc:sldMk cId="573917548" sldId="266"/>
            <ac:spMk id="191" creationId="{78CB9E75-8929-32D0-F32F-89FB4B640E54}"/>
          </ac:spMkLst>
        </pc:spChg>
        <pc:spChg chg="del">
          <ac:chgData name="Dominik Aumann" userId="013c187a20e8f01a" providerId="LiveId" clId="{ECAA7777-180A-4B5D-8194-D34F96268794}" dt="2024-02-25T23:28:34.749" v="604" actId="478"/>
          <ac:spMkLst>
            <pc:docMk/>
            <pc:sldMk cId="573917548" sldId="266"/>
            <ac:spMk id="192" creationId="{7B3406C1-1716-ED25-F7F6-EC41C8039684}"/>
          </ac:spMkLst>
        </pc:spChg>
        <pc:spChg chg="del">
          <ac:chgData name="Dominik Aumann" userId="013c187a20e8f01a" providerId="LiveId" clId="{ECAA7777-180A-4B5D-8194-D34F96268794}" dt="2024-02-25T23:28:34.749" v="604" actId="478"/>
          <ac:spMkLst>
            <pc:docMk/>
            <pc:sldMk cId="573917548" sldId="266"/>
            <ac:spMk id="193" creationId="{B921195F-5360-7417-D074-8966C1A970D4}"/>
          </ac:spMkLst>
        </pc:spChg>
        <pc:spChg chg="del">
          <ac:chgData name="Dominik Aumann" userId="013c187a20e8f01a" providerId="LiveId" clId="{ECAA7777-180A-4B5D-8194-D34F96268794}" dt="2024-02-25T23:28:34.749" v="604" actId="478"/>
          <ac:spMkLst>
            <pc:docMk/>
            <pc:sldMk cId="573917548" sldId="266"/>
            <ac:spMk id="194" creationId="{F80135DB-5BA2-341A-913D-F8B1118DB4B8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195" creationId="{B034A743-09C8-8152-0846-BC4D34256321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196" creationId="{98984231-6AA0-FDE2-F6E4-CE93225E5A7A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197" creationId="{FCB6819A-DE73-839D-32B3-14B7C6A19CC7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198" creationId="{A964CF12-A111-7A8B-2D12-5796773DF0A6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199" creationId="{5ED78A52-DB7D-E8F2-9BA2-D3A154116FDC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00" creationId="{159480C0-3A75-1BEE-6A60-CC2602F868C8}"/>
          </ac:spMkLst>
        </pc:spChg>
        <pc:spChg chg="del mod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01" creationId="{193533B6-D65C-FF0B-9C82-E221530002D6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2" creationId="{F51DDD2F-E2D2-D905-FFA5-F2195D4E0B77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3" creationId="{A81FACB1-F778-0FA3-4355-66CE217052C2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5" creationId="{6A1293BF-1A79-F3D4-D8B9-59648821641C}"/>
          </ac:spMkLst>
        </pc:spChg>
        <pc:spChg chg="del mod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6" creationId="{FF58BD78-C797-F39F-E692-AF3ACF3545D5}"/>
          </ac:spMkLst>
        </pc:spChg>
        <pc:spChg chg="del mod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7" creationId="{5061BF25-20F0-2029-B547-6A063AFFB691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8" creationId="{160FF318-5B5E-75E0-DC48-FA3095373074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09" creationId="{50076323-C37B-618B-E98D-A100D7B41A42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0" creationId="{11A1E198-45F6-9CE7-E134-260E110D0257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1" creationId="{A0F974BD-6AC4-F9A3-0A5C-610A2E55238B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2" creationId="{0A6B72AC-5A47-FA79-DFAB-BBA9871A78BF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3" creationId="{A84AF9B5-F8B4-B01D-5DBE-5E0A967F948F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4" creationId="{BDC3EB54-CD42-0D89-439A-94A1D21FCC15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5" creationId="{10553CB5-5187-E8B7-7BBE-B939B0E2D345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6" creationId="{90BCE5B7-BF20-AA6F-E2DC-EE6BE99FA6C2}"/>
          </ac:spMkLst>
        </pc:spChg>
        <pc:spChg chg="del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7" creationId="{FFC7B15B-E548-4873-4158-E207C8C5ED53}"/>
          </ac:spMkLst>
        </pc:spChg>
        <pc:spChg chg="del mod">
          <ac:chgData name="Dominik Aumann" userId="013c187a20e8f01a" providerId="LiveId" clId="{ECAA7777-180A-4B5D-8194-D34F96268794}" dt="2024-02-25T23:06:04.273" v="285" actId="478"/>
          <ac:spMkLst>
            <pc:docMk/>
            <pc:sldMk cId="573917548" sldId="266"/>
            <ac:spMk id="218" creationId="{6C020536-5E1B-AAA0-C50A-3333742784F5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19" creationId="{1FBE0AA8-A312-92D1-5124-55029EC38739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0" creationId="{352DDC6E-1B05-CCA0-4625-D98864CDA6BB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2" creationId="{69F369CE-536E-6202-7383-445B09F0F168}"/>
          </ac:spMkLst>
        </pc:spChg>
        <pc:spChg chg="del mod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3" creationId="{4D854F73-9596-C3A9-9606-5AFA743F89A5}"/>
          </ac:spMkLst>
        </pc:spChg>
        <pc:spChg chg="del mod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4" creationId="{ED3CB690-C211-1839-F31E-06FD1C5F1299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5" creationId="{8D6D59B8-FDFD-EF7A-D2FC-9CEF6110CD81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6" creationId="{5EEC36C0-89AC-C675-3ABA-AE563E30D0C5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7" creationId="{99FEB332-AA2E-4D36-5747-53107BC7AFA6}"/>
          </ac:spMkLst>
        </pc:spChg>
        <pc:spChg chg="del">
          <ac:chgData name="Dominik Aumann" userId="013c187a20e8f01a" providerId="LiveId" clId="{ECAA7777-180A-4B5D-8194-D34F96268794}" dt="2024-02-25T23:30:06.056" v="627" actId="478"/>
          <ac:spMkLst>
            <pc:docMk/>
            <pc:sldMk cId="573917548" sldId="266"/>
            <ac:spMk id="228" creationId="{1D9FDDC4-BAD8-55F3-C767-315F444C84BB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29" creationId="{7C3D9C46-3EFA-33DE-9576-A754870C304C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0" creationId="{DABEB094-E798-4DBB-504A-6DFC19011EFC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1" creationId="{86B9ED5B-CA61-C0F9-1D99-226E9A08493E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2" creationId="{9516B0AA-1237-6D41-8338-189D1DC2B0CA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3" creationId="{4B1B1B9C-B20B-CFEB-ADCD-5D2A045F5D3E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4" creationId="{9E03055C-E4F2-10DA-FD99-3FE20A0E7A9C}"/>
          </ac:spMkLst>
        </pc:spChg>
        <pc:spChg chg="del mod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35" creationId="{646367D1-6020-8957-5457-97DFCCB4CCD2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36" creationId="{5FC087E7-085D-7242-A6FB-3F74B8C97078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37" creationId="{BC27B0DE-ACC0-6C56-16DD-4C30550BF2E7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39" creationId="{53A9C2CE-F833-41FF-97D9-FE8F74A60573}"/>
          </ac:spMkLst>
        </pc:spChg>
        <pc:spChg chg="del mod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0" creationId="{E5459789-8A77-8756-1161-9A357EAF676A}"/>
          </ac:spMkLst>
        </pc:spChg>
        <pc:spChg chg="del mod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1" creationId="{C6D88B05-DD48-5343-A29A-C175B32A2BE2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2" creationId="{80A7034A-04DF-E41E-C879-66333E9B9992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3" creationId="{8010908C-0187-C7D8-DBC5-DF2F542F47A3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4" creationId="{EC96DAB6-6684-6B5C-BFFD-059D7E6046B8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5" creationId="{D32E4706-AC93-4CB2-69E8-B91EB2242AD7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6" creationId="{F53DBC60-F5FC-26E6-6106-7F7CD97AEE02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7" creationId="{8B908148-FCF6-3CF0-FC5B-2D818D3DB045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8" creationId="{71B30008-8785-D01C-C21A-650298C6B865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49" creationId="{89F943EE-7F7B-4B29-6EE1-048E754934C5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50" creationId="{F0A0FB72-B2E2-4FFB-2FA8-93C1FB19B8A8}"/>
          </ac:spMkLst>
        </pc:spChg>
        <pc:spChg chg="del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51" creationId="{C62DA9B4-97D0-1E25-38ED-D108F96F489D}"/>
          </ac:spMkLst>
        </pc:spChg>
        <pc:spChg chg="del mod">
          <ac:chgData name="Dominik Aumann" userId="013c187a20e8f01a" providerId="LiveId" clId="{ECAA7777-180A-4B5D-8194-D34F96268794}" dt="2024-02-25T23:15:54.953" v="476" actId="478"/>
          <ac:spMkLst>
            <pc:docMk/>
            <pc:sldMk cId="573917548" sldId="266"/>
            <ac:spMk id="252" creationId="{47C9747A-E8C4-6156-6880-EB6D3485D968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3" creationId="{8EF071C5-F786-39E1-0E15-30DAD9384FC1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4" creationId="{0FABD23A-BBEA-CA78-3A1D-BD7DA5573845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6" creationId="{0FC71553-3A5A-7F09-A866-5C4BC7EDD2A8}"/>
          </ac:spMkLst>
        </pc:spChg>
        <pc:spChg chg="del mod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7" creationId="{3BA108D6-4122-C06A-03E1-02AEE5CA3A37}"/>
          </ac:spMkLst>
        </pc:spChg>
        <pc:spChg chg="del mod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8" creationId="{1212316B-69C1-8005-9FA4-4D29B478959C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59" creationId="{A58FDB34-3DB0-553B-E782-78E24E977EF2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60" creationId="{87555FCB-AA60-77F1-DF50-F08A410B2DFC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61" creationId="{07E7861F-1DFD-6B9E-E539-AA8C3A152205}"/>
          </ac:spMkLst>
        </pc:spChg>
        <pc:spChg chg="del">
          <ac:chgData name="Dominik Aumann" userId="013c187a20e8f01a" providerId="LiveId" clId="{ECAA7777-180A-4B5D-8194-D34F96268794}" dt="2024-02-25T23:30:08.290" v="628" actId="478"/>
          <ac:spMkLst>
            <pc:docMk/>
            <pc:sldMk cId="573917548" sldId="266"/>
            <ac:spMk id="262" creationId="{74075CEB-93C8-9FE4-8EB7-CDB424318CCC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3" creationId="{46F92513-4F78-AFD6-0B56-A687834EEA1E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4" creationId="{3C57EC84-478D-69D6-7052-941042B94B38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5" creationId="{3AAD7A51-6AC5-5F3E-F088-95FD0A3566C9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6" creationId="{7F24C8AB-1BF4-D32E-562C-BF2C555F4262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7" creationId="{1BE45C9A-2072-9E78-806C-930B168719D8}"/>
          </ac:spMkLst>
        </pc:spChg>
        <pc:spChg chg="del">
          <ac:chgData name="Dominik Aumann" userId="013c187a20e8f01a" providerId="LiveId" clId="{ECAA7777-180A-4B5D-8194-D34F96268794}" dt="2024-02-25T23:35:49.472" v="707" actId="478"/>
          <ac:spMkLst>
            <pc:docMk/>
            <pc:sldMk cId="573917548" sldId="266"/>
            <ac:spMk id="268" creationId="{F726E649-3C7A-2FA3-DD86-F3C09E2CFCEE}"/>
          </ac:spMkLst>
        </pc:spChg>
        <pc:spChg chg="del">
          <ac:chgData name="Dominik Aumann" userId="013c187a20e8f01a" providerId="LiveId" clId="{ECAA7777-180A-4B5D-8194-D34F96268794}" dt="2024-02-25T23:05:05.750" v="274" actId="478"/>
          <ac:spMkLst>
            <pc:docMk/>
            <pc:sldMk cId="573917548" sldId="266"/>
            <ac:spMk id="295" creationId="{79DCC11A-AAA8-10CA-5D9C-8849811D229B}"/>
          </ac:spMkLst>
        </pc:spChg>
        <pc:picChg chg="add del mod">
          <ac:chgData name="Dominik Aumann" userId="013c187a20e8f01a" providerId="LiveId" clId="{ECAA7777-180A-4B5D-8194-D34F96268794}" dt="2024-02-25T23:29:37.031" v="621" actId="478"/>
          <ac:picMkLst>
            <pc:docMk/>
            <pc:sldMk cId="573917548" sldId="266"/>
            <ac:picMk id="2" creationId="{D35E74EF-8253-0263-64FA-160A666451CC}"/>
          </ac:picMkLst>
        </pc:picChg>
        <pc:picChg chg="del">
          <ac:chgData name="Dominik Aumann" userId="013c187a20e8f01a" providerId="LiveId" clId="{ECAA7777-180A-4B5D-8194-D34F96268794}" dt="2024-02-25T23:05:05.750" v="274" actId="478"/>
          <ac:picMkLst>
            <pc:docMk/>
            <pc:sldMk cId="573917548" sldId="266"/>
            <ac:picMk id="9" creationId="{8AD99D3A-FEF6-1F4C-C5AA-5BF4EE6CF819}"/>
          </ac:picMkLst>
        </pc:picChg>
        <pc:picChg chg="del">
          <ac:chgData name="Dominik Aumann" userId="013c187a20e8f01a" providerId="LiveId" clId="{ECAA7777-180A-4B5D-8194-D34F96268794}" dt="2024-02-25T23:05:57.728" v="283" actId="21"/>
          <ac:picMkLst>
            <pc:docMk/>
            <pc:sldMk cId="573917548" sldId="266"/>
            <ac:picMk id="10" creationId="{6D8B0020-51F6-7AA4-9134-28FD710EA023}"/>
          </ac:picMkLst>
        </pc:picChg>
        <pc:picChg chg="del">
          <ac:chgData name="Dominik Aumann" userId="013c187a20e8f01a" providerId="LiveId" clId="{ECAA7777-180A-4B5D-8194-D34F96268794}" dt="2024-02-25T23:15:47.501" v="472" actId="21"/>
          <ac:picMkLst>
            <pc:docMk/>
            <pc:sldMk cId="573917548" sldId="266"/>
            <ac:picMk id="11" creationId="{1D5DA54D-1340-F707-9894-DB1D0EF5F5C2}"/>
          </ac:picMkLst>
        </pc:picChg>
        <pc:picChg chg="del">
          <ac:chgData name="Dominik Aumann" userId="013c187a20e8f01a" providerId="LiveId" clId="{ECAA7777-180A-4B5D-8194-D34F96268794}" dt="2024-02-25T23:30:54.732" v="629" actId="21"/>
          <ac:picMkLst>
            <pc:docMk/>
            <pc:sldMk cId="573917548" sldId="266"/>
            <ac:picMk id="12" creationId="{EFCFAAF2-CA08-3DAF-9B81-E54F6C560996}"/>
          </ac:picMkLst>
        </pc:picChg>
        <pc:picChg chg="del">
          <ac:chgData name="Dominik Aumann" userId="013c187a20e8f01a" providerId="LiveId" clId="{ECAA7777-180A-4B5D-8194-D34F96268794}" dt="2024-02-25T23:33:13.168" v="669" actId="21"/>
          <ac:picMkLst>
            <pc:docMk/>
            <pc:sldMk cId="573917548" sldId="266"/>
            <ac:picMk id="13" creationId="{7936FDDC-FCFA-CA1C-5EF3-818F69D973CA}"/>
          </ac:picMkLst>
        </pc:picChg>
        <pc:picChg chg="del">
          <ac:chgData name="Dominik Aumann" userId="013c187a20e8f01a" providerId="LiveId" clId="{ECAA7777-180A-4B5D-8194-D34F96268794}" dt="2024-02-25T23:35:47.691" v="706" actId="21"/>
          <ac:picMkLst>
            <pc:docMk/>
            <pc:sldMk cId="573917548" sldId="266"/>
            <ac:picMk id="14" creationId="{19397F73-5A57-0635-2E77-A2E7535ACD4F}"/>
          </ac:picMkLst>
        </pc:picChg>
        <pc:picChg chg="del">
          <ac:chgData name="Dominik Aumann" userId="013c187a20e8f01a" providerId="LiveId" clId="{ECAA7777-180A-4B5D-8194-D34F96268794}" dt="2024-02-25T23:36:41.131" v="717" actId="21"/>
          <ac:picMkLst>
            <pc:docMk/>
            <pc:sldMk cId="573917548" sldId="266"/>
            <ac:picMk id="143" creationId="{D8272031-C8DC-B23F-394F-6CB0606F45C4}"/>
          </ac:picMkLst>
        </pc:picChg>
        <pc:picChg chg="del">
          <ac:chgData name="Dominik Aumann" userId="013c187a20e8f01a" providerId="LiveId" clId="{ECAA7777-180A-4B5D-8194-D34F96268794}" dt="2024-02-25T23:30:08.290" v="628" actId="478"/>
          <ac:picMkLst>
            <pc:docMk/>
            <pc:sldMk cId="573917548" sldId="266"/>
            <ac:picMk id="148" creationId="{49B5FA7D-2BF9-0636-67B3-70E63F3563FB}"/>
          </ac:picMkLst>
        </pc:picChg>
        <pc:picChg chg="del">
          <ac:chgData name="Dominik Aumann" userId="013c187a20e8f01a" providerId="LiveId" clId="{ECAA7777-180A-4B5D-8194-D34F96268794}" dt="2024-02-25T23:15:47.501" v="472" actId="21"/>
          <ac:picMkLst>
            <pc:docMk/>
            <pc:sldMk cId="573917548" sldId="266"/>
            <ac:picMk id="149" creationId="{D5A50096-ACF3-D527-802C-47D38FE58728}"/>
          </ac:picMkLst>
        </pc:picChg>
        <pc:picChg chg="del">
          <ac:chgData name="Dominik Aumann" userId="013c187a20e8f01a" providerId="LiveId" clId="{ECAA7777-180A-4B5D-8194-D34F96268794}" dt="2024-02-25T23:15:51.391" v="475" actId="478"/>
          <ac:picMkLst>
            <pc:docMk/>
            <pc:sldMk cId="573917548" sldId="266"/>
            <ac:picMk id="150" creationId="{CC12DEA6-5799-842D-9465-F156CD88F804}"/>
          </ac:picMkLst>
        </pc:picChg>
        <pc:picChg chg="del">
          <ac:chgData name="Dominik Aumann" userId="013c187a20e8f01a" providerId="LiveId" clId="{ECAA7777-180A-4B5D-8194-D34F96268794}" dt="2024-02-25T23:15:50.032" v="473" actId="478"/>
          <ac:picMkLst>
            <pc:docMk/>
            <pc:sldMk cId="573917548" sldId="266"/>
            <ac:picMk id="151" creationId="{60FE523F-222D-8C43-353A-7F53EF83E730}"/>
          </ac:picMkLst>
        </pc:picChg>
        <pc:picChg chg="del">
          <ac:chgData name="Dominik Aumann" userId="013c187a20e8f01a" providerId="LiveId" clId="{ECAA7777-180A-4B5D-8194-D34F96268794}" dt="2024-02-25T23:33:13.168" v="669" actId="21"/>
          <ac:picMkLst>
            <pc:docMk/>
            <pc:sldMk cId="573917548" sldId="266"/>
            <ac:picMk id="153" creationId="{4B1BA9DB-B771-D880-4E8F-0C26DD9C757A}"/>
          </ac:picMkLst>
        </pc:picChg>
        <pc:picChg chg="del">
          <ac:chgData name="Dominik Aumann" userId="013c187a20e8f01a" providerId="LiveId" clId="{ECAA7777-180A-4B5D-8194-D34F96268794}" dt="2024-02-25T23:30:06.056" v="627" actId="478"/>
          <ac:picMkLst>
            <pc:docMk/>
            <pc:sldMk cId="573917548" sldId="266"/>
            <ac:picMk id="154" creationId="{BE40975F-E43A-FF67-6DF7-7996959BC043}"/>
          </ac:picMkLst>
        </pc:picChg>
        <pc:picChg chg="del">
          <ac:chgData name="Dominik Aumann" userId="013c187a20e8f01a" providerId="LiveId" clId="{ECAA7777-180A-4B5D-8194-D34F96268794}" dt="2024-02-25T23:30:06.056" v="627" actId="478"/>
          <ac:picMkLst>
            <pc:docMk/>
            <pc:sldMk cId="573917548" sldId="266"/>
            <ac:picMk id="155" creationId="{3616F684-8FA9-005C-66F2-C752F56D5242}"/>
          </ac:picMkLst>
        </pc:picChg>
        <pc:picChg chg="del">
          <ac:chgData name="Dominik Aumann" userId="013c187a20e8f01a" providerId="LiveId" clId="{ECAA7777-180A-4B5D-8194-D34F96268794}" dt="2024-02-25T23:30:54.732" v="629" actId="21"/>
          <ac:picMkLst>
            <pc:docMk/>
            <pc:sldMk cId="573917548" sldId="266"/>
            <ac:picMk id="158" creationId="{AE8931EB-8D3D-BEE2-4159-79A8C8D8B6B3}"/>
          </ac:picMkLst>
        </pc:picChg>
        <pc:picChg chg="del">
          <ac:chgData name="Dominik Aumann" userId="013c187a20e8f01a" providerId="LiveId" clId="{ECAA7777-180A-4B5D-8194-D34F96268794}" dt="2024-02-25T23:05:05.750" v="274" actId="478"/>
          <ac:picMkLst>
            <pc:docMk/>
            <pc:sldMk cId="573917548" sldId="266"/>
            <ac:picMk id="160" creationId="{4E7B75C4-0A0F-5172-C8EE-39071352D86B}"/>
          </ac:picMkLst>
        </pc:picChg>
        <pc:picChg chg="del">
          <ac:chgData name="Dominik Aumann" userId="013c187a20e8f01a" providerId="LiveId" clId="{ECAA7777-180A-4B5D-8194-D34F96268794}" dt="2024-02-25T23:05:57.728" v="283" actId="21"/>
          <ac:picMkLst>
            <pc:docMk/>
            <pc:sldMk cId="573917548" sldId="266"/>
            <ac:picMk id="161" creationId="{1394D757-7C40-63D1-4B2E-C2DB1AF64077}"/>
          </ac:picMkLst>
        </pc:picChg>
        <pc:picChg chg="del">
          <ac:chgData name="Dominik Aumann" userId="013c187a20e8f01a" providerId="LiveId" clId="{ECAA7777-180A-4B5D-8194-D34F96268794}" dt="2024-02-25T23:05:57.728" v="283" actId="21"/>
          <ac:picMkLst>
            <pc:docMk/>
            <pc:sldMk cId="573917548" sldId="266"/>
            <ac:picMk id="162" creationId="{6678E9BE-BF64-2A15-FC94-0AA256A6138F}"/>
          </ac:picMkLst>
        </pc:picChg>
        <pc:picChg chg="del">
          <ac:chgData name="Dominik Aumann" userId="013c187a20e8f01a" providerId="LiveId" clId="{ECAA7777-180A-4B5D-8194-D34F96268794}" dt="2024-02-25T23:05:57.728" v="283" actId="21"/>
          <ac:picMkLst>
            <pc:docMk/>
            <pc:sldMk cId="573917548" sldId="266"/>
            <ac:picMk id="163" creationId="{645D5178-804D-22A9-3C96-84563FE48D05}"/>
          </ac:picMkLst>
        </pc:picChg>
        <pc:picChg chg="del">
          <ac:chgData name="Dominik Aumann" userId="013c187a20e8f01a" providerId="LiveId" clId="{ECAA7777-180A-4B5D-8194-D34F96268794}" dt="2024-02-25T23:28:30.922" v="603" actId="478"/>
          <ac:picMkLst>
            <pc:docMk/>
            <pc:sldMk cId="573917548" sldId="266"/>
            <ac:picMk id="164" creationId="{FA11C258-3BB1-F64E-8600-115417B8EC0C}"/>
          </ac:picMkLst>
        </pc:picChg>
        <pc:picChg chg="del">
          <ac:chgData name="Dominik Aumann" userId="013c187a20e8f01a" providerId="LiveId" clId="{ECAA7777-180A-4B5D-8194-D34F96268794}" dt="2024-02-25T23:28:29.938" v="602" actId="478"/>
          <ac:picMkLst>
            <pc:docMk/>
            <pc:sldMk cId="573917548" sldId="266"/>
            <ac:picMk id="165" creationId="{2B1FD774-7B71-5D5B-1EAE-F502B8897E47}"/>
          </ac:picMkLst>
        </pc:picChg>
        <pc:picChg chg="del">
          <ac:chgData name="Dominik Aumann" userId="013c187a20e8f01a" providerId="LiveId" clId="{ECAA7777-180A-4B5D-8194-D34F96268794}" dt="2024-02-25T23:05:05.750" v="274" actId="478"/>
          <ac:picMkLst>
            <pc:docMk/>
            <pc:sldMk cId="573917548" sldId="266"/>
            <ac:picMk id="183" creationId="{5B633839-AAE6-D2B9-0E40-F6CFAF678ED8}"/>
          </ac:picMkLst>
        </pc:picChg>
        <pc:picChg chg="del">
          <ac:chgData name="Dominik Aumann" userId="013c187a20e8f01a" providerId="LiveId" clId="{ECAA7777-180A-4B5D-8194-D34F96268794}" dt="2024-02-25T23:05:05.750" v="274" actId="478"/>
          <ac:picMkLst>
            <pc:docMk/>
            <pc:sldMk cId="573917548" sldId="266"/>
            <ac:picMk id="184" creationId="{B85B4654-F6DB-14CD-BDD2-1EF2676AEAD6}"/>
          </ac:picMkLst>
        </pc:picChg>
        <pc:picChg chg="del">
          <ac:chgData name="Dominik Aumann" userId="013c187a20e8f01a" providerId="LiveId" clId="{ECAA7777-180A-4B5D-8194-D34F96268794}" dt="2024-02-25T23:35:47.691" v="706" actId="21"/>
          <ac:picMkLst>
            <pc:docMk/>
            <pc:sldMk cId="573917548" sldId="266"/>
            <ac:picMk id="283" creationId="{4FE48B4E-2ED1-F9D1-4E5E-EADBE8E13C4D}"/>
          </ac:picMkLst>
        </pc:picChg>
        <pc:picChg chg="del">
          <ac:chgData name="Dominik Aumann" userId="013c187a20e8f01a" providerId="LiveId" clId="{ECAA7777-180A-4B5D-8194-D34F96268794}" dt="2024-02-25T23:30:08.290" v="628" actId="478"/>
          <ac:picMkLst>
            <pc:docMk/>
            <pc:sldMk cId="573917548" sldId="266"/>
            <ac:picMk id="284" creationId="{6BBB7426-6133-43AA-EAFB-7F55C39A6110}"/>
          </ac:picMkLst>
        </pc:picChg>
        <pc:picChg chg="del">
          <ac:chgData name="Dominik Aumann" userId="013c187a20e8f01a" providerId="LiveId" clId="{ECAA7777-180A-4B5D-8194-D34F96268794}" dt="2024-02-25T23:36:41.131" v="717" actId="21"/>
          <ac:picMkLst>
            <pc:docMk/>
            <pc:sldMk cId="573917548" sldId="266"/>
            <ac:picMk id="1027" creationId="{F54CED45-2645-D248-09AE-35AF6EF52928}"/>
          </ac:picMkLst>
        </pc:picChg>
        <pc:cxnChg chg="add del mod">
          <ac:chgData name="Dominik Aumann" userId="013c187a20e8f01a" providerId="LiveId" clId="{ECAA7777-180A-4B5D-8194-D34F96268794}" dt="2024-02-25T23:29:38.219" v="622" actId="478"/>
          <ac:cxnSpMkLst>
            <pc:docMk/>
            <pc:sldMk cId="573917548" sldId="266"/>
            <ac:cxnSpMk id="3" creationId="{0F464932-0C5E-C410-703D-BCCBB93B96A8}"/>
          </ac:cxnSpMkLst>
        </pc:cxnChg>
        <pc:cxnChg chg="del">
          <ac:chgData name="Dominik Aumann" userId="013c187a20e8f01a" providerId="LiveId" clId="{ECAA7777-180A-4B5D-8194-D34F96268794}" dt="2024-02-25T23:15:54.953" v="476" actId="478"/>
          <ac:cxnSpMkLst>
            <pc:docMk/>
            <pc:sldMk cId="573917548" sldId="266"/>
            <ac:cxnSpMk id="146" creationId="{AC3B5B1F-2109-C9E0-E267-C341295FA82D}"/>
          </ac:cxnSpMkLst>
        </pc:cxnChg>
        <pc:cxnChg chg="del">
          <ac:chgData name="Dominik Aumann" userId="013c187a20e8f01a" providerId="LiveId" clId="{ECAA7777-180A-4B5D-8194-D34F96268794}" dt="2024-02-25T23:15:50.735" v="474" actId="478"/>
          <ac:cxnSpMkLst>
            <pc:docMk/>
            <pc:sldMk cId="573917548" sldId="266"/>
            <ac:cxnSpMk id="147" creationId="{062E01C4-18A7-CEE2-D392-EE3C5EB50CC2}"/>
          </ac:cxnSpMkLst>
        </pc:cxnChg>
        <pc:cxnChg chg="del">
          <ac:chgData name="Dominik Aumann" userId="013c187a20e8f01a" providerId="LiveId" clId="{ECAA7777-180A-4B5D-8194-D34F96268794}" dt="2024-02-25T23:05:05.750" v="274" actId="478"/>
          <ac:cxnSpMkLst>
            <pc:docMk/>
            <pc:sldMk cId="573917548" sldId="266"/>
            <ac:cxnSpMk id="168" creationId="{CE8E362E-D16F-D5D9-07DA-58A4EB74F0B7}"/>
          </ac:cxnSpMkLst>
        </pc:cxnChg>
        <pc:cxnChg chg="del">
          <ac:chgData name="Dominik Aumann" userId="013c187a20e8f01a" providerId="LiveId" clId="{ECAA7777-180A-4B5D-8194-D34F96268794}" dt="2024-02-25T23:28:34.749" v="604" actId="478"/>
          <ac:cxnSpMkLst>
            <pc:docMk/>
            <pc:sldMk cId="573917548" sldId="266"/>
            <ac:cxnSpMk id="187" creationId="{4C188738-B75C-123B-8617-17F8BC7C9E6B}"/>
          </ac:cxnSpMkLst>
        </pc:cxnChg>
        <pc:cxnChg chg="del">
          <ac:chgData name="Dominik Aumann" userId="013c187a20e8f01a" providerId="LiveId" clId="{ECAA7777-180A-4B5D-8194-D34F96268794}" dt="2024-02-25T23:06:04.273" v="285" actId="478"/>
          <ac:cxnSpMkLst>
            <pc:docMk/>
            <pc:sldMk cId="573917548" sldId="266"/>
            <ac:cxnSpMk id="204" creationId="{EE26F356-6BB1-8E70-605E-3601E6BB7E87}"/>
          </ac:cxnSpMkLst>
        </pc:cxnChg>
        <pc:cxnChg chg="del">
          <ac:chgData name="Dominik Aumann" userId="013c187a20e8f01a" providerId="LiveId" clId="{ECAA7777-180A-4B5D-8194-D34F96268794}" dt="2024-02-25T23:30:06.056" v="627" actId="478"/>
          <ac:cxnSpMkLst>
            <pc:docMk/>
            <pc:sldMk cId="573917548" sldId="266"/>
            <ac:cxnSpMk id="221" creationId="{E0296A7D-84B6-0F9C-EF79-7EB5BBBCA859}"/>
          </ac:cxnSpMkLst>
        </pc:cxnChg>
        <pc:cxnChg chg="del">
          <ac:chgData name="Dominik Aumann" userId="013c187a20e8f01a" providerId="LiveId" clId="{ECAA7777-180A-4B5D-8194-D34F96268794}" dt="2024-02-25T23:15:54.953" v="476" actId="478"/>
          <ac:cxnSpMkLst>
            <pc:docMk/>
            <pc:sldMk cId="573917548" sldId="266"/>
            <ac:cxnSpMk id="238" creationId="{EADCC32C-164C-7B58-7194-9C66AA8DBB40}"/>
          </ac:cxnSpMkLst>
        </pc:cxnChg>
        <pc:cxnChg chg="del">
          <ac:chgData name="Dominik Aumann" userId="013c187a20e8f01a" providerId="LiveId" clId="{ECAA7777-180A-4B5D-8194-D34F96268794}" dt="2024-02-25T23:06:04.273" v="285" actId="478"/>
          <ac:cxnSpMkLst>
            <pc:docMk/>
            <pc:sldMk cId="573917548" sldId="266"/>
            <ac:cxnSpMk id="255" creationId="{CB08D8B1-3083-6EB9-FCCF-D38F221E0839}"/>
          </ac:cxnSpMkLst>
        </pc:cxnChg>
        <pc:cxnChg chg="del">
          <ac:chgData name="Dominik Aumann" userId="013c187a20e8f01a" providerId="LiveId" clId="{ECAA7777-180A-4B5D-8194-D34F96268794}" dt="2024-02-25T23:05:05.750" v="274" actId="478"/>
          <ac:cxnSpMkLst>
            <pc:docMk/>
            <pc:sldMk cId="573917548" sldId="266"/>
            <ac:cxnSpMk id="270" creationId="{47AB344A-0184-7484-D8FD-11B4D55ABD07}"/>
          </ac:cxnSpMkLst>
        </pc:cxnChg>
        <pc:cxnChg chg="del">
          <ac:chgData name="Dominik Aumann" userId="013c187a20e8f01a" providerId="LiveId" clId="{ECAA7777-180A-4B5D-8194-D34F96268794}" dt="2024-02-25T23:06:04.273" v="285" actId="478"/>
          <ac:cxnSpMkLst>
            <pc:docMk/>
            <pc:sldMk cId="573917548" sldId="266"/>
            <ac:cxnSpMk id="282" creationId="{C79A91EC-FD54-A39E-8179-39599741B80A}"/>
          </ac:cxnSpMkLst>
        </pc:cxnChg>
        <pc:cxnChg chg="del">
          <ac:chgData name="Dominik Aumann" userId="013c187a20e8f01a" providerId="LiveId" clId="{ECAA7777-180A-4B5D-8194-D34F96268794}" dt="2024-02-25T23:30:08.290" v="628" actId="478"/>
          <ac:cxnSpMkLst>
            <pc:docMk/>
            <pc:sldMk cId="573917548" sldId="266"/>
            <ac:cxnSpMk id="286" creationId="{00D6B3EF-5E44-C680-BC4B-08111B5F2A75}"/>
          </ac:cxnSpMkLst>
        </pc:cxnChg>
        <pc:cxnChg chg="del">
          <ac:chgData name="Dominik Aumann" userId="013c187a20e8f01a" providerId="LiveId" clId="{ECAA7777-180A-4B5D-8194-D34F96268794}" dt="2024-02-25T23:30:08.290" v="628" actId="478"/>
          <ac:cxnSpMkLst>
            <pc:docMk/>
            <pc:sldMk cId="573917548" sldId="266"/>
            <ac:cxnSpMk id="287" creationId="{DFC7DAD7-F338-BC1F-1F2D-AD808320B676}"/>
          </ac:cxnSpMkLst>
        </pc:cxnChg>
        <pc:cxnChg chg="del">
          <ac:chgData name="Dominik Aumann" userId="013c187a20e8f01a" providerId="LiveId" clId="{ECAA7777-180A-4B5D-8194-D34F96268794}" dt="2024-02-25T23:30:08.290" v="628" actId="478"/>
          <ac:cxnSpMkLst>
            <pc:docMk/>
            <pc:sldMk cId="573917548" sldId="266"/>
            <ac:cxnSpMk id="288" creationId="{76DFB966-CFBF-35F2-3C2C-DF2C321DFFD0}"/>
          </ac:cxnSpMkLst>
        </pc:cxnChg>
        <pc:cxnChg chg="del">
          <ac:chgData name="Dominik Aumann" userId="013c187a20e8f01a" providerId="LiveId" clId="{ECAA7777-180A-4B5D-8194-D34F96268794}" dt="2024-02-25T23:30:06.056" v="627" actId="478"/>
          <ac:cxnSpMkLst>
            <pc:docMk/>
            <pc:sldMk cId="573917548" sldId="266"/>
            <ac:cxnSpMk id="289" creationId="{398CFB12-72D8-F4FD-EDBA-E78DA54C2C0B}"/>
          </ac:cxnSpMkLst>
        </pc:cxnChg>
        <pc:cxnChg chg="del">
          <ac:chgData name="Dominik Aumann" userId="013c187a20e8f01a" providerId="LiveId" clId="{ECAA7777-180A-4B5D-8194-D34F96268794}" dt="2024-02-25T23:30:06.056" v="627" actId="478"/>
          <ac:cxnSpMkLst>
            <pc:docMk/>
            <pc:sldMk cId="573917548" sldId="266"/>
            <ac:cxnSpMk id="290" creationId="{28FE473A-A0F4-1E71-D2F2-5C4C63CD3846}"/>
          </ac:cxnSpMkLst>
        </pc:cxnChg>
        <pc:cxnChg chg="del">
          <ac:chgData name="Dominik Aumann" userId="013c187a20e8f01a" providerId="LiveId" clId="{ECAA7777-180A-4B5D-8194-D34F96268794}" dt="2024-02-25T23:05:05.750" v="274" actId="478"/>
          <ac:cxnSpMkLst>
            <pc:docMk/>
            <pc:sldMk cId="573917548" sldId="266"/>
            <ac:cxnSpMk id="291" creationId="{8F553AB3-77CF-A29D-663C-A7877F3FB100}"/>
          </ac:cxnSpMkLst>
        </pc:cxnChg>
        <pc:cxnChg chg="del">
          <ac:chgData name="Dominik Aumann" userId="013c187a20e8f01a" providerId="LiveId" clId="{ECAA7777-180A-4B5D-8194-D34F96268794}" dt="2024-02-25T23:05:05.750" v="274" actId="478"/>
          <ac:cxnSpMkLst>
            <pc:docMk/>
            <pc:sldMk cId="573917548" sldId="266"/>
            <ac:cxnSpMk id="292" creationId="{A5E32C37-09C6-0808-C3C0-DF195D886549}"/>
          </ac:cxnSpMkLst>
        </pc:cxnChg>
        <pc:cxnChg chg="del">
          <ac:chgData name="Dominik Aumann" userId="013c187a20e8f01a" providerId="LiveId" clId="{ECAA7777-180A-4B5D-8194-D34F96268794}" dt="2024-02-25T23:28:34.749" v="604" actId="478"/>
          <ac:cxnSpMkLst>
            <pc:docMk/>
            <pc:sldMk cId="573917548" sldId="266"/>
            <ac:cxnSpMk id="293" creationId="{810B3F34-288C-9085-923A-9352552F325A}"/>
          </ac:cxnSpMkLst>
        </pc:cxnChg>
        <pc:cxnChg chg="del">
          <ac:chgData name="Dominik Aumann" userId="013c187a20e8f01a" providerId="LiveId" clId="{ECAA7777-180A-4B5D-8194-D34F96268794}" dt="2024-02-25T23:28:34.749" v="604" actId="478"/>
          <ac:cxnSpMkLst>
            <pc:docMk/>
            <pc:sldMk cId="573917548" sldId="266"/>
            <ac:cxnSpMk id="294" creationId="{57E920DE-3E10-5F4F-008E-42E2FE027942}"/>
          </ac:cxnSpMkLst>
        </pc:cxnChg>
      </pc:sldChg>
      <pc:sldChg chg="add del">
        <pc:chgData name="Dominik Aumann" userId="013c187a20e8f01a" providerId="LiveId" clId="{ECAA7777-180A-4B5D-8194-D34F96268794}" dt="2024-02-25T22:50:28.148" v="60"/>
        <pc:sldMkLst>
          <pc:docMk/>
          <pc:sldMk cId="1361847993" sldId="266"/>
        </pc:sldMkLst>
      </pc:sldChg>
      <pc:sldChg chg="addSp delSp modSp add mod">
        <pc:chgData name="Dominik Aumann" userId="013c187a20e8f01a" providerId="LiveId" clId="{ECAA7777-180A-4B5D-8194-D34F96268794}" dt="2024-02-25T23:45:25.429" v="805" actId="1036"/>
        <pc:sldMkLst>
          <pc:docMk/>
          <pc:sldMk cId="4223580299" sldId="266"/>
        </pc:sldMkLst>
        <pc:grpChg chg="add 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3" creationId="{7484C7F9-1112-E05F-4AFD-859BCF477CD3}"/>
          </ac:grpSpMkLst>
        </pc:grpChg>
        <pc:grpChg chg="add 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4" creationId="{E527C909-0D69-3B2D-CFF8-A265B888A98B}"/>
          </ac:grpSpMkLst>
        </pc:grpChg>
        <pc:grpChg chg="add 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5" creationId="{2666ABE2-9150-E69B-F761-57899367CEC1}"/>
          </ac:grpSpMkLst>
        </pc:grpChg>
        <pc:grpChg chg="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146" creationId="{4741338D-567B-B916-ECF7-541D9049AB0F}"/>
          </ac:grpSpMkLst>
        </pc:grpChg>
        <pc:grpChg chg="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190" creationId="{F7A3C115-9BDF-BE76-3E79-3B7928152C9C}"/>
          </ac:grpSpMkLst>
        </pc:grpChg>
        <pc:grpChg chg="mod">
          <ac:chgData name="Dominik Aumann" userId="013c187a20e8f01a" providerId="LiveId" clId="{ECAA7777-180A-4B5D-8194-D34F96268794}" dt="2024-02-25T23:44:57.873" v="801" actId="164"/>
          <ac:grpSpMkLst>
            <pc:docMk/>
            <pc:sldMk cId="4223580299" sldId="266"/>
            <ac:grpSpMk id="1053" creationId="{945F3B95-276D-46E4-A94F-DB4A19149226}"/>
          </ac:grpSpMkLst>
        </pc:grpChg>
        <pc:grpChg chg="mod">
          <ac:chgData name="Dominik Aumann" userId="013c187a20e8f01a" providerId="LiveId" clId="{ECAA7777-180A-4B5D-8194-D34F96268794}" dt="2024-02-25T23:44:50.296" v="800" actId="164"/>
          <ac:grpSpMkLst>
            <pc:docMk/>
            <pc:sldMk cId="4223580299" sldId="266"/>
            <ac:grpSpMk id="1077" creationId="{06F4A306-B2E0-F6BF-E4FD-6A80ED740DDC}"/>
          </ac:grpSpMkLst>
        </pc:grpChg>
        <pc:grpChg chg="mod">
          <ac:chgData name="Dominik Aumann" userId="013c187a20e8f01a" providerId="LiveId" clId="{ECAA7777-180A-4B5D-8194-D34F96268794}" dt="2024-02-25T23:45:05.027" v="802" actId="164"/>
          <ac:grpSpMkLst>
            <pc:docMk/>
            <pc:sldMk cId="4223580299" sldId="266"/>
            <ac:grpSpMk id="1098" creationId="{6623688C-0F84-0877-EAB2-A634D28C7655}"/>
          </ac:grpSpMkLst>
        </pc:grpChg>
        <pc:grpChg chg="mod">
          <ac:chgData name="Dominik Aumann" userId="013c187a20e8f01a" providerId="LiveId" clId="{ECAA7777-180A-4B5D-8194-D34F96268794}" dt="2024-02-25T23:45:25.429" v="805" actId="1036"/>
          <ac:grpSpMkLst>
            <pc:docMk/>
            <pc:sldMk cId="4223580299" sldId="266"/>
            <ac:grpSpMk id="1127" creationId="{FAD4BFF5-3FD1-AE3D-7524-71F9BBF08E7B}"/>
          </ac:grpSpMkLst>
        </pc:grpChg>
        <pc:picChg chg="add mod">
          <ac:chgData name="Dominik Aumann" userId="013c187a20e8f01a" providerId="LiveId" clId="{ECAA7777-180A-4B5D-8194-D34F96268794}" dt="2024-02-25T23:44:50.296" v="800" actId="164"/>
          <ac:picMkLst>
            <pc:docMk/>
            <pc:sldMk cId="4223580299" sldId="266"/>
            <ac:picMk id="2" creationId="{88A8F468-0343-C6FB-1123-93AF4384BD79}"/>
          </ac:picMkLst>
        </pc:picChg>
        <pc:picChg chg="mod">
          <ac:chgData name="Dominik Aumann" userId="013c187a20e8f01a" providerId="LiveId" clId="{ECAA7777-180A-4B5D-8194-D34F96268794}" dt="2024-02-25T23:44:50.296" v="800" actId="164"/>
          <ac:picMkLst>
            <pc:docMk/>
            <pc:sldMk cId="4223580299" sldId="266"/>
            <ac:picMk id="256" creationId="{33F3652F-4F1A-79B6-6015-3593840DCC79}"/>
          </ac:picMkLst>
        </pc:picChg>
        <pc:picChg chg="mod">
          <ac:chgData name="Dominik Aumann" userId="013c187a20e8f01a" providerId="LiveId" clId="{ECAA7777-180A-4B5D-8194-D34F96268794}" dt="2024-02-25T23:44:50.296" v="800" actId="164"/>
          <ac:picMkLst>
            <pc:docMk/>
            <pc:sldMk cId="4223580299" sldId="266"/>
            <ac:picMk id="258" creationId="{15FADE91-38B8-C4BC-3295-7AF01DEF17FB}"/>
          </ac:picMkLst>
        </pc:picChg>
        <pc:picChg chg="mod">
          <ac:chgData name="Dominik Aumann" userId="013c187a20e8f01a" providerId="LiveId" clId="{ECAA7777-180A-4B5D-8194-D34F96268794}" dt="2024-02-25T23:44:50.296" v="800" actId="164"/>
          <ac:picMkLst>
            <pc:docMk/>
            <pc:sldMk cId="4223580299" sldId="266"/>
            <ac:picMk id="260" creationId="{3F59E3FA-29B6-D4BC-E41D-3636E9B73C7E}"/>
          </ac:picMkLst>
        </pc:picChg>
        <pc:picChg chg="mod">
          <ac:chgData name="Dominik Aumann" userId="013c187a20e8f01a" providerId="LiveId" clId="{ECAA7777-180A-4B5D-8194-D34F96268794}" dt="2024-02-25T23:45:05.027" v="802" actId="164"/>
          <ac:picMkLst>
            <pc:docMk/>
            <pc:sldMk cId="4223580299" sldId="266"/>
            <ac:picMk id="1129" creationId="{5A33466C-A8F4-E6ED-E45B-C4617E398AA7}"/>
          </ac:picMkLst>
        </pc:picChg>
        <pc:picChg chg="mod">
          <ac:chgData name="Dominik Aumann" userId="013c187a20e8f01a" providerId="LiveId" clId="{ECAA7777-180A-4B5D-8194-D34F96268794}" dt="2024-02-25T23:45:05.027" v="802" actId="164"/>
          <ac:picMkLst>
            <pc:docMk/>
            <pc:sldMk cId="4223580299" sldId="266"/>
            <ac:picMk id="1130" creationId="{076D6B72-472B-FE26-F682-B6BA225C0173}"/>
          </ac:picMkLst>
        </pc:picChg>
        <pc:picChg chg="mod">
          <ac:chgData name="Dominik Aumann" userId="013c187a20e8f01a" providerId="LiveId" clId="{ECAA7777-180A-4B5D-8194-D34F96268794}" dt="2024-02-25T23:45:05.027" v="802" actId="164"/>
          <ac:picMkLst>
            <pc:docMk/>
            <pc:sldMk cId="4223580299" sldId="266"/>
            <ac:picMk id="1134" creationId="{5F702425-559B-3143-678E-97A947064D98}"/>
          </ac:picMkLst>
        </pc:picChg>
        <pc:picChg chg="mod">
          <ac:chgData name="Dominik Aumann" userId="013c187a20e8f01a" providerId="LiveId" clId="{ECAA7777-180A-4B5D-8194-D34F96268794}" dt="2024-02-25T23:45:05.027" v="802" actId="164"/>
          <ac:picMkLst>
            <pc:docMk/>
            <pc:sldMk cId="4223580299" sldId="266"/>
            <ac:picMk id="1135" creationId="{31ECB0CF-D5AC-9F9F-B970-C023873C50B2}"/>
          </ac:picMkLst>
        </pc:picChg>
        <pc:picChg chg="mod">
          <ac:chgData name="Dominik Aumann" userId="013c187a20e8f01a" providerId="LiveId" clId="{ECAA7777-180A-4B5D-8194-D34F96268794}" dt="2024-02-25T23:44:57.873" v="801" actId="164"/>
          <ac:picMkLst>
            <pc:docMk/>
            <pc:sldMk cId="4223580299" sldId="266"/>
            <ac:picMk id="1140" creationId="{17DA350A-66E0-29F9-136A-2CCD105187CF}"/>
          </ac:picMkLst>
        </pc:picChg>
        <pc:picChg chg="mod">
          <ac:chgData name="Dominik Aumann" userId="013c187a20e8f01a" providerId="LiveId" clId="{ECAA7777-180A-4B5D-8194-D34F96268794}" dt="2024-02-25T23:44:57.873" v="801" actId="164"/>
          <ac:picMkLst>
            <pc:docMk/>
            <pc:sldMk cId="4223580299" sldId="266"/>
            <ac:picMk id="1141" creationId="{ED6AF3D5-E895-A494-D244-0AC8002112FE}"/>
          </ac:picMkLst>
        </pc:picChg>
        <pc:picChg chg="del">
          <ac:chgData name="Dominik Aumann" userId="013c187a20e8f01a" providerId="LiveId" clId="{ECAA7777-180A-4B5D-8194-D34F96268794}" dt="2024-02-25T23:43:50.491" v="796" actId="478"/>
          <ac:picMkLst>
            <pc:docMk/>
            <pc:sldMk cId="4223580299" sldId="266"/>
            <ac:picMk id="1142" creationId="{987B61C9-5180-407A-A857-304325EFDFDE}"/>
          </ac:picMkLst>
        </pc:picChg>
        <pc:picChg chg="mod">
          <ac:chgData name="Dominik Aumann" userId="013c187a20e8f01a" providerId="LiveId" clId="{ECAA7777-180A-4B5D-8194-D34F96268794}" dt="2024-02-25T23:44:57.873" v="801" actId="164"/>
          <ac:picMkLst>
            <pc:docMk/>
            <pc:sldMk cId="4223580299" sldId="266"/>
            <ac:picMk id="1143" creationId="{ED49346E-69AB-BEF0-B9A1-CBCDAA1683F5}"/>
          </ac:picMkLst>
        </pc:picChg>
        <pc:picChg chg="mod">
          <ac:chgData name="Dominik Aumann" userId="013c187a20e8f01a" providerId="LiveId" clId="{ECAA7777-180A-4B5D-8194-D34F96268794}" dt="2024-02-25T23:44:57.873" v="801" actId="164"/>
          <ac:picMkLst>
            <pc:docMk/>
            <pc:sldMk cId="4223580299" sldId="266"/>
            <ac:picMk id="1145" creationId="{01C1CC17-48B8-855B-2F8A-5C7DADC0C2CE}"/>
          </ac:picMkLst>
        </pc:picChg>
        <pc:picChg chg="add del mod">
          <ac:chgData name="Dominik Aumann" userId="013c187a20e8f01a" providerId="LiveId" clId="{ECAA7777-180A-4B5D-8194-D34F96268794}" dt="2024-02-25T23:43:49.820" v="795" actId="478"/>
          <ac:picMkLst>
            <pc:docMk/>
            <pc:sldMk cId="4223580299" sldId="266"/>
            <ac:picMk id="1146" creationId="{628E773B-A9F4-87F3-84AB-EF722F9844C4}"/>
          </ac:picMkLst>
        </pc:picChg>
        <pc:picChg chg="del">
          <ac:chgData name="Dominik Aumann" userId="013c187a20e8f01a" providerId="LiveId" clId="{ECAA7777-180A-4B5D-8194-D34F96268794}" dt="2024-02-25T23:43:51.132" v="797" actId="478"/>
          <ac:picMkLst>
            <pc:docMk/>
            <pc:sldMk cId="4223580299" sldId="266"/>
            <ac:picMk id="1147" creationId="{7E6FC677-BA6D-8368-8803-0114E2FD589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120616" y="5033131"/>
            <a:ext cx="12700318" cy="3472934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241234" y="9181148"/>
            <a:ext cx="10459085" cy="414051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7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7487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6231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497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3719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2463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1207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995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665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875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17701587" y="1481438"/>
            <a:ext cx="5491539" cy="3157144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1221785" y="1481438"/>
            <a:ext cx="16230777" cy="31571446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656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399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180279" y="10411303"/>
            <a:ext cx="12700318" cy="3217902"/>
          </a:xfrm>
        </p:spPr>
        <p:txBody>
          <a:bodyPr anchor="t"/>
          <a:lstStyle>
            <a:lvl1pPr algn="l">
              <a:defRPr sz="77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180279" y="6867110"/>
            <a:ext cx="12700318" cy="3544192"/>
          </a:xfrm>
        </p:spPr>
        <p:txBody>
          <a:bodyPr anchor="b"/>
          <a:lstStyle>
            <a:lvl1pPr marL="0" indent="0">
              <a:buNone/>
              <a:defRPr sz="3800">
                <a:solidFill>
                  <a:schemeClr val="tx1">
                    <a:tint val="75000"/>
                  </a:schemeClr>
                </a:solidFill>
              </a:defRPr>
            </a:lvl1pPr>
            <a:lvl2pPr marL="874395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74879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3pPr>
            <a:lvl4pPr marL="262318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49758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37197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24637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120765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699516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49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1221785" y="8633580"/>
            <a:ext cx="10861157" cy="24419303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12331968" y="8633580"/>
            <a:ext cx="10861159" cy="24419303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952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47079" y="648833"/>
            <a:ext cx="13447395" cy="2700337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47079" y="3626704"/>
            <a:ext cx="6601779" cy="1511438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4395" indent="0">
              <a:buNone/>
              <a:defRPr sz="3800" b="1"/>
            </a:lvl2pPr>
            <a:lvl3pPr marL="1748790" indent="0">
              <a:buNone/>
              <a:defRPr sz="3400" b="1"/>
            </a:lvl3pPr>
            <a:lvl4pPr marL="2623185" indent="0">
              <a:buNone/>
              <a:defRPr sz="3100" b="1"/>
            </a:lvl4pPr>
            <a:lvl5pPr marL="3497580" indent="0">
              <a:buNone/>
              <a:defRPr sz="3100" b="1"/>
            </a:lvl5pPr>
            <a:lvl6pPr marL="4371975" indent="0">
              <a:buNone/>
              <a:defRPr sz="3100" b="1"/>
            </a:lvl6pPr>
            <a:lvl7pPr marL="5246370" indent="0">
              <a:buNone/>
              <a:defRPr sz="3100" b="1"/>
            </a:lvl7pPr>
            <a:lvl8pPr marL="6120765" indent="0">
              <a:buNone/>
              <a:defRPr sz="3100" b="1"/>
            </a:lvl8pPr>
            <a:lvl9pPr marL="6995160" indent="0">
              <a:buNone/>
              <a:defRPr sz="31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747079" y="5138142"/>
            <a:ext cx="6601779" cy="9334918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7590102" y="3626704"/>
            <a:ext cx="6604373" cy="1511438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4395" indent="0">
              <a:buNone/>
              <a:defRPr sz="3800" b="1"/>
            </a:lvl2pPr>
            <a:lvl3pPr marL="1748790" indent="0">
              <a:buNone/>
              <a:defRPr sz="3400" b="1"/>
            </a:lvl3pPr>
            <a:lvl4pPr marL="2623185" indent="0">
              <a:buNone/>
              <a:defRPr sz="3100" b="1"/>
            </a:lvl4pPr>
            <a:lvl5pPr marL="3497580" indent="0">
              <a:buNone/>
              <a:defRPr sz="3100" b="1"/>
            </a:lvl5pPr>
            <a:lvl6pPr marL="4371975" indent="0">
              <a:buNone/>
              <a:defRPr sz="3100" b="1"/>
            </a:lvl6pPr>
            <a:lvl7pPr marL="5246370" indent="0">
              <a:buNone/>
              <a:defRPr sz="3100" b="1"/>
            </a:lvl7pPr>
            <a:lvl8pPr marL="6120765" indent="0">
              <a:buNone/>
              <a:defRPr sz="3100" b="1"/>
            </a:lvl8pPr>
            <a:lvl9pPr marL="6995160" indent="0">
              <a:buNone/>
              <a:defRPr sz="31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7590102" y="5138142"/>
            <a:ext cx="6604373" cy="9334918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925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963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745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47079" y="645081"/>
            <a:ext cx="4915667" cy="2745343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841732" y="645082"/>
            <a:ext cx="8352741" cy="13827980"/>
          </a:xfrm>
        </p:spPr>
        <p:txBody>
          <a:bodyPr/>
          <a:lstStyle>
            <a:lvl1pPr>
              <a:defRPr sz="6100"/>
            </a:lvl1pPr>
            <a:lvl2pPr>
              <a:defRPr sz="5400"/>
            </a:lvl2pPr>
            <a:lvl3pPr>
              <a:defRPr sz="4600"/>
            </a:lvl3pPr>
            <a:lvl4pPr>
              <a:defRPr sz="3800"/>
            </a:lvl4pPr>
            <a:lvl5pPr>
              <a:defRPr sz="3800"/>
            </a:lvl5pPr>
            <a:lvl6pPr>
              <a:defRPr sz="3800"/>
            </a:lvl6pPr>
            <a:lvl7pPr>
              <a:defRPr sz="3800"/>
            </a:lvl7pPr>
            <a:lvl8pPr>
              <a:defRPr sz="3800"/>
            </a:lvl8pPr>
            <a:lvl9pPr>
              <a:defRPr sz="3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747079" y="3390425"/>
            <a:ext cx="4915667" cy="11082636"/>
          </a:xfrm>
        </p:spPr>
        <p:txBody>
          <a:bodyPr/>
          <a:lstStyle>
            <a:lvl1pPr marL="0" indent="0">
              <a:buNone/>
              <a:defRPr sz="2700"/>
            </a:lvl1pPr>
            <a:lvl2pPr marL="874395" indent="0">
              <a:buNone/>
              <a:defRPr sz="2300"/>
            </a:lvl2pPr>
            <a:lvl3pPr marL="1748790" indent="0">
              <a:buNone/>
              <a:defRPr sz="1900"/>
            </a:lvl3pPr>
            <a:lvl4pPr marL="2623185" indent="0">
              <a:buNone/>
              <a:defRPr sz="1700"/>
            </a:lvl4pPr>
            <a:lvl5pPr marL="3497580" indent="0">
              <a:buNone/>
              <a:defRPr sz="1700"/>
            </a:lvl5pPr>
            <a:lvl6pPr marL="4371975" indent="0">
              <a:buNone/>
              <a:defRPr sz="1700"/>
            </a:lvl6pPr>
            <a:lvl7pPr marL="5246370" indent="0">
              <a:buNone/>
              <a:defRPr sz="1700"/>
            </a:lvl7pPr>
            <a:lvl8pPr marL="6120765" indent="0">
              <a:buNone/>
              <a:defRPr sz="1700"/>
            </a:lvl8pPr>
            <a:lvl9pPr marL="6995160" indent="0">
              <a:buNone/>
              <a:defRPr sz="17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03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928648" y="11341418"/>
            <a:ext cx="8964930" cy="1338918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2928648" y="1447681"/>
            <a:ext cx="8964930" cy="9721215"/>
          </a:xfrm>
        </p:spPr>
        <p:txBody>
          <a:bodyPr/>
          <a:lstStyle>
            <a:lvl1pPr marL="0" indent="0">
              <a:buNone/>
              <a:defRPr sz="6100"/>
            </a:lvl1pPr>
            <a:lvl2pPr marL="874395" indent="0">
              <a:buNone/>
              <a:defRPr sz="5400"/>
            </a:lvl2pPr>
            <a:lvl3pPr marL="1748790" indent="0">
              <a:buNone/>
              <a:defRPr sz="4600"/>
            </a:lvl3pPr>
            <a:lvl4pPr marL="2623185" indent="0">
              <a:buNone/>
              <a:defRPr sz="3800"/>
            </a:lvl4pPr>
            <a:lvl5pPr marL="3497580" indent="0">
              <a:buNone/>
              <a:defRPr sz="3800"/>
            </a:lvl5pPr>
            <a:lvl6pPr marL="4371975" indent="0">
              <a:buNone/>
              <a:defRPr sz="3800"/>
            </a:lvl6pPr>
            <a:lvl7pPr marL="5246370" indent="0">
              <a:buNone/>
              <a:defRPr sz="3800"/>
            </a:lvl7pPr>
            <a:lvl8pPr marL="6120765" indent="0">
              <a:buNone/>
              <a:defRPr sz="3800"/>
            </a:lvl8pPr>
            <a:lvl9pPr marL="6995160" indent="0">
              <a:buNone/>
              <a:defRPr sz="38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2928648" y="12680337"/>
            <a:ext cx="8964930" cy="1901487"/>
          </a:xfrm>
        </p:spPr>
        <p:txBody>
          <a:bodyPr/>
          <a:lstStyle>
            <a:lvl1pPr marL="0" indent="0">
              <a:buNone/>
              <a:defRPr sz="2700"/>
            </a:lvl1pPr>
            <a:lvl2pPr marL="874395" indent="0">
              <a:buNone/>
              <a:defRPr sz="2300"/>
            </a:lvl2pPr>
            <a:lvl3pPr marL="1748790" indent="0">
              <a:buNone/>
              <a:defRPr sz="1900"/>
            </a:lvl3pPr>
            <a:lvl4pPr marL="2623185" indent="0">
              <a:buNone/>
              <a:defRPr sz="1700"/>
            </a:lvl4pPr>
            <a:lvl5pPr marL="3497580" indent="0">
              <a:buNone/>
              <a:defRPr sz="1700"/>
            </a:lvl5pPr>
            <a:lvl6pPr marL="4371975" indent="0">
              <a:buNone/>
              <a:defRPr sz="1700"/>
            </a:lvl6pPr>
            <a:lvl7pPr marL="5246370" indent="0">
              <a:buNone/>
              <a:defRPr sz="1700"/>
            </a:lvl7pPr>
            <a:lvl8pPr marL="6120765" indent="0">
              <a:buNone/>
              <a:defRPr sz="1700"/>
            </a:lvl8pPr>
            <a:lvl9pPr marL="6995160" indent="0">
              <a:buNone/>
              <a:defRPr sz="17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904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747079" y="648833"/>
            <a:ext cx="13447395" cy="2700337"/>
          </a:xfrm>
          <a:prstGeom prst="rect">
            <a:avLst/>
          </a:prstGeom>
        </p:spPr>
        <p:txBody>
          <a:bodyPr vert="horz" lIns="174879" tIns="87440" rIns="174879" bIns="8744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47079" y="3780474"/>
            <a:ext cx="13447395" cy="10692588"/>
          </a:xfrm>
          <a:prstGeom prst="rect">
            <a:avLst/>
          </a:prstGeom>
        </p:spPr>
        <p:txBody>
          <a:bodyPr vert="horz" lIns="174879" tIns="87440" rIns="174879" bIns="8744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747077" y="15016879"/>
            <a:ext cx="3486362" cy="862608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l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44955D-197C-411E-9DAF-0DAB0716ABD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5105031" y="15016879"/>
            <a:ext cx="4731491" cy="862608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ct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10708111" y="15016879"/>
            <a:ext cx="3486362" cy="862608"/>
          </a:xfrm>
          <a:prstGeom prst="rect">
            <a:avLst/>
          </a:prstGeom>
        </p:spPr>
        <p:txBody>
          <a:bodyPr vert="horz" lIns="174879" tIns="87440" rIns="174879" bIns="87440" rtlCol="0" anchor="ctr"/>
          <a:lstStyle>
            <a:lvl1pPr algn="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47B4D5-0BA1-47DF-B7F3-B27070AE67B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9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748790" rtl="0" eaLnBrk="1" latinLnBrk="0" hangingPunct="1">
        <a:spcBef>
          <a:spcPct val="0"/>
        </a:spcBef>
        <a:buNone/>
        <a:defRPr sz="8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55796" indent="-655796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6100" kern="1200">
          <a:solidFill>
            <a:schemeClr val="tx1"/>
          </a:solidFill>
          <a:latin typeface="+mn-lt"/>
          <a:ea typeface="+mn-ea"/>
          <a:cs typeface="+mn-cs"/>
        </a:defRPr>
      </a:lvl1pPr>
      <a:lvl2pPr marL="1420892" indent="-546497" algn="l" defTabSz="1748790" rtl="0" eaLnBrk="1" latinLnBrk="0" hangingPunct="1">
        <a:spcBef>
          <a:spcPct val="20000"/>
        </a:spcBef>
        <a:buFont typeface="Arial" panose="020B0604020202020204" pitchFamily="34" charset="0"/>
        <a:buChar char="–"/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185988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3pPr>
      <a:lvl4pPr marL="3060383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4pPr>
      <a:lvl5pPr marL="3934778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»"/>
        <a:defRPr sz="3800" kern="1200">
          <a:solidFill>
            <a:schemeClr val="tx1"/>
          </a:solidFill>
          <a:latin typeface="+mn-lt"/>
          <a:ea typeface="+mn-ea"/>
          <a:cs typeface="+mn-cs"/>
        </a:defRPr>
      </a:lvl5pPr>
      <a:lvl6pPr marL="4809173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6pPr>
      <a:lvl7pPr marL="5683568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7pPr>
      <a:lvl8pPr marL="6557963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8pPr>
      <a:lvl9pPr marL="7432358" indent="-437198" algn="l" defTabSz="174879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87439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74879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62318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7197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24637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6120765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algn="l" defTabSz="1748790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tiff"/><Relationship Id="rId18" Type="http://schemas.openxmlformats.org/officeDocument/2006/relationships/image" Target="../media/image14.png"/><Relationship Id="rId26" Type="http://schemas.openxmlformats.org/officeDocument/2006/relationships/image" Target="../media/image20.tiff"/><Relationship Id="rId3" Type="http://schemas.openxmlformats.org/officeDocument/2006/relationships/image" Target="../media/image2.png"/><Relationship Id="rId21" Type="http://schemas.openxmlformats.org/officeDocument/2006/relationships/image" Target="../media/image16.tiff"/><Relationship Id="rId7" Type="http://schemas.openxmlformats.org/officeDocument/2006/relationships/image" Target="../media/image5.png"/><Relationship Id="rId12" Type="http://schemas.openxmlformats.org/officeDocument/2006/relationships/image" Target="../media/image9.tiff"/><Relationship Id="rId17" Type="http://schemas.openxmlformats.org/officeDocument/2006/relationships/image" Target="../media/image13.png"/><Relationship Id="rId25" Type="http://schemas.openxmlformats.org/officeDocument/2006/relationships/image" Target="../media/image19.tiff"/><Relationship Id="rId33" Type="http://schemas.openxmlformats.org/officeDocument/2006/relationships/image" Target="../media/image26.tiff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20" Type="http://schemas.openxmlformats.org/officeDocument/2006/relationships/image" Target="../media/image15.tiff"/><Relationship Id="rId29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8.tiff"/><Relationship Id="rId24" Type="http://schemas.microsoft.com/office/2007/relationships/hdphoto" Target="../media/hdphoto5.wdp"/><Relationship Id="rId32" Type="http://schemas.openxmlformats.org/officeDocument/2006/relationships/image" Target="../media/image25.tiff"/><Relationship Id="rId5" Type="http://schemas.openxmlformats.org/officeDocument/2006/relationships/image" Target="../media/image3.tiff"/><Relationship Id="rId15" Type="http://schemas.microsoft.com/office/2007/relationships/hdphoto" Target="../media/hdphoto3.wdp"/><Relationship Id="rId23" Type="http://schemas.openxmlformats.org/officeDocument/2006/relationships/image" Target="../media/image18.png"/><Relationship Id="rId28" Type="http://schemas.openxmlformats.org/officeDocument/2006/relationships/image" Target="../media/image22.png"/><Relationship Id="rId10" Type="http://schemas.openxmlformats.org/officeDocument/2006/relationships/image" Target="../media/image7.tiff"/><Relationship Id="rId19" Type="http://schemas.microsoft.com/office/2007/relationships/hdphoto" Target="../media/hdphoto4.wdp"/><Relationship Id="rId31" Type="http://schemas.microsoft.com/office/2007/relationships/hdphoto" Target="../media/hdphoto6.wdp"/><Relationship Id="rId4" Type="http://schemas.microsoft.com/office/2007/relationships/hdphoto" Target="../media/hdphoto1.wdp"/><Relationship Id="rId9" Type="http://schemas.microsoft.com/office/2007/relationships/hdphoto" Target="../media/hdphoto2.wdp"/><Relationship Id="rId14" Type="http://schemas.openxmlformats.org/officeDocument/2006/relationships/image" Target="../media/image11.png"/><Relationship Id="rId22" Type="http://schemas.openxmlformats.org/officeDocument/2006/relationships/image" Target="../media/image17.png"/><Relationship Id="rId27" Type="http://schemas.openxmlformats.org/officeDocument/2006/relationships/image" Target="../media/image21.png"/><Relationship Id="rId30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="" xmlns:a16="http://schemas.microsoft.com/office/drawing/2014/main" id="{FB78F5D5-8BC2-9135-DAB9-C04AB95021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6" name="Gruppieren 145">
            <a:extLst>
              <a:ext uri="{FF2B5EF4-FFF2-40B4-BE49-F238E27FC236}">
                <a16:creationId xmlns="" xmlns:a16="http://schemas.microsoft.com/office/drawing/2014/main" id="{4741338D-567B-B916-ECF7-541D9049AB0F}"/>
              </a:ext>
            </a:extLst>
          </p:cNvPr>
          <p:cNvGrpSpPr/>
          <p:nvPr/>
        </p:nvGrpSpPr>
        <p:grpSpPr>
          <a:xfrm>
            <a:off x="355230" y="5278545"/>
            <a:ext cx="6592538" cy="4328908"/>
            <a:chOff x="355230" y="5066684"/>
            <a:chExt cx="6592538" cy="4328908"/>
          </a:xfrm>
        </p:grpSpPr>
        <p:pic>
          <p:nvPicPr>
            <p:cNvPr id="135" name="Grafik 134" descr="Ein Bild, das Text, parallel, Reihe, Diagramm enthält.&#10;&#10;Automatisch generierte Beschreibung">
              <a:extLst>
                <a:ext uri="{FF2B5EF4-FFF2-40B4-BE49-F238E27FC236}">
                  <a16:creationId xmlns="" xmlns:a16="http://schemas.microsoft.com/office/drawing/2014/main" id="{2D37C8F1-30F1-8A80-6269-52819676CC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6579" y="5968558"/>
              <a:ext cx="2501189" cy="1130400"/>
            </a:xfrm>
            <a:prstGeom prst="rect">
              <a:avLst/>
            </a:prstGeom>
          </p:spPr>
        </p:pic>
        <p:pic>
          <p:nvPicPr>
            <p:cNvPr id="139" name="Grafik 138" descr="Ein Bild, das Text, Reihe, Diagramm, Screenshot enthält.&#10;&#10;Automatisch generierte Beschreibung">
              <a:extLst>
                <a:ext uri="{FF2B5EF4-FFF2-40B4-BE49-F238E27FC236}">
                  <a16:creationId xmlns="" xmlns:a16="http://schemas.microsoft.com/office/drawing/2014/main" id="{15FA2C90-55CE-1B66-9516-B807454156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4900" y="5968558"/>
              <a:ext cx="3092652" cy="1130400"/>
            </a:xfrm>
            <a:prstGeom prst="rect">
              <a:avLst/>
            </a:prstGeom>
          </p:spPr>
        </p:pic>
        <p:grpSp>
          <p:nvGrpSpPr>
            <p:cNvPr id="42" name="Gruppieren 41">
              <a:extLst>
                <a:ext uri="{FF2B5EF4-FFF2-40B4-BE49-F238E27FC236}">
                  <a16:creationId xmlns="" xmlns:a16="http://schemas.microsoft.com/office/drawing/2014/main" id="{BB241909-3103-EE33-999F-EB4D8121BA2B}"/>
                </a:ext>
              </a:extLst>
            </p:cNvPr>
            <p:cNvGrpSpPr/>
            <p:nvPr/>
          </p:nvGrpSpPr>
          <p:grpSpPr>
            <a:xfrm>
              <a:off x="355230" y="5066684"/>
              <a:ext cx="6590184" cy="4328908"/>
              <a:chOff x="202830" y="136144"/>
              <a:chExt cx="6590184" cy="4328908"/>
            </a:xfrm>
          </p:grpSpPr>
          <p:sp>
            <p:nvSpPr>
              <p:cNvPr id="152" name="Textfeld 151">
                <a:extLst>
                  <a:ext uri="{FF2B5EF4-FFF2-40B4-BE49-F238E27FC236}">
                    <a16:creationId xmlns="" xmlns:a16="http://schemas.microsoft.com/office/drawing/2014/main" id="{5C6B012D-36D0-36CB-4C82-75FCF552BB7A}"/>
                  </a:ext>
                </a:extLst>
              </p:cNvPr>
              <p:cNvSpPr txBox="1"/>
              <p:nvPr/>
            </p:nvSpPr>
            <p:spPr>
              <a:xfrm rot="16200000">
                <a:off x="-108848" y="1490236"/>
                <a:ext cx="11311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feld 153">
                <a:extLst>
                  <a:ext uri="{FF2B5EF4-FFF2-40B4-BE49-F238E27FC236}">
                    <a16:creationId xmlns="" xmlns:a16="http://schemas.microsoft.com/office/drawing/2014/main" id="{0B0B2805-6ED5-3DCD-FE23-70FE0AFB6D70}"/>
                  </a:ext>
                </a:extLst>
              </p:cNvPr>
              <p:cNvSpPr txBox="1"/>
              <p:nvPr/>
            </p:nvSpPr>
            <p:spPr>
              <a:xfrm>
                <a:off x="206317" y="757465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a</a:t>
                </a:r>
              </a:p>
            </p:txBody>
          </p:sp>
          <p:sp>
            <p:nvSpPr>
              <p:cNvPr id="156" name="Textfeld 155">
                <a:extLst>
                  <a:ext uri="{FF2B5EF4-FFF2-40B4-BE49-F238E27FC236}">
                    <a16:creationId xmlns="" xmlns:a16="http://schemas.microsoft.com/office/drawing/2014/main" id="{FDE5749D-C74F-6857-8343-A9E0B3966427}"/>
                  </a:ext>
                </a:extLst>
              </p:cNvPr>
              <p:cNvSpPr txBox="1"/>
              <p:nvPr/>
            </p:nvSpPr>
            <p:spPr>
              <a:xfrm>
                <a:off x="3962815" y="780560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b</a:t>
                </a:r>
              </a:p>
            </p:txBody>
          </p:sp>
          <p:sp>
            <p:nvSpPr>
              <p:cNvPr id="162" name="Textfeld 161">
                <a:extLst>
                  <a:ext uri="{FF2B5EF4-FFF2-40B4-BE49-F238E27FC236}">
                    <a16:creationId xmlns="" xmlns:a16="http://schemas.microsoft.com/office/drawing/2014/main" id="{9F322305-499B-B39A-4D23-94CBFC91E4D3}"/>
                  </a:ext>
                </a:extLst>
              </p:cNvPr>
              <p:cNvSpPr txBox="1"/>
              <p:nvPr/>
            </p:nvSpPr>
            <p:spPr>
              <a:xfrm rot="16200000">
                <a:off x="3569417" y="1523239"/>
                <a:ext cx="12221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Mean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 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Textfeld 162">
                <a:extLst>
                  <a:ext uri="{FF2B5EF4-FFF2-40B4-BE49-F238E27FC236}">
                    <a16:creationId xmlns="" xmlns:a16="http://schemas.microsoft.com/office/drawing/2014/main" id="{BC6B1024-41DE-55C4-3011-EACB98A07191}"/>
                  </a:ext>
                </a:extLst>
              </p:cNvPr>
              <p:cNvSpPr txBox="1"/>
              <p:nvPr/>
            </p:nvSpPr>
            <p:spPr>
              <a:xfrm>
                <a:off x="579532" y="2148018"/>
                <a:ext cx="30913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feld 163">
                <a:extLst>
                  <a:ext uri="{FF2B5EF4-FFF2-40B4-BE49-F238E27FC236}">
                    <a16:creationId xmlns="" xmlns:a16="http://schemas.microsoft.com/office/drawing/2014/main" id="{C2B3EA38-9A33-1A5A-495F-D5CC993C01DA}"/>
                  </a:ext>
                </a:extLst>
              </p:cNvPr>
              <p:cNvSpPr txBox="1"/>
              <p:nvPr/>
            </p:nvSpPr>
            <p:spPr>
              <a:xfrm>
                <a:off x="4294016" y="2151068"/>
                <a:ext cx="24989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Textfeld 164">
                <a:extLst>
                  <a:ext uri="{FF2B5EF4-FFF2-40B4-BE49-F238E27FC236}">
                    <a16:creationId xmlns="" xmlns:a16="http://schemas.microsoft.com/office/drawing/2014/main" id="{94F3E216-F0CE-C16C-6A74-478C23052279}"/>
                  </a:ext>
                </a:extLst>
              </p:cNvPr>
              <p:cNvSpPr txBox="1"/>
              <p:nvPr/>
            </p:nvSpPr>
            <p:spPr>
              <a:xfrm rot="16200000">
                <a:off x="3602725" y="3540074"/>
                <a:ext cx="1155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feld 173">
                <a:extLst>
                  <a:ext uri="{FF2B5EF4-FFF2-40B4-BE49-F238E27FC236}">
                    <a16:creationId xmlns="" xmlns:a16="http://schemas.microsoft.com/office/drawing/2014/main" id="{738C967E-8D94-1A66-2AA9-6B5E23C5E469}"/>
                  </a:ext>
                </a:extLst>
              </p:cNvPr>
              <p:cNvSpPr txBox="1"/>
              <p:nvPr/>
            </p:nvSpPr>
            <p:spPr>
              <a:xfrm>
                <a:off x="528281" y="4234220"/>
                <a:ext cx="307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Textfeld 182">
                <a:extLst>
                  <a:ext uri="{FF2B5EF4-FFF2-40B4-BE49-F238E27FC236}">
                    <a16:creationId xmlns="" xmlns:a16="http://schemas.microsoft.com/office/drawing/2014/main" id="{7E755743-DA88-9AF8-B861-4A9B4B039EFE}"/>
                  </a:ext>
                </a:extLst>
              </p:cNvPr>
              <p:cNvSpPr txBox="1"/>
              <p:nvPr/>
            </p:nvSpPr>
            <p:spPr>
              <a:xfrm>
                <a:off x="4299864" y="4233243"/>
                <a:ext cx="247393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Textfeld 183">
                <a:extLst>
                  <a:ext uri="{FF2B5EF4-FFF2-40B4-BE49-F238E27FC236}">
                    <a16:creationId xmlns="" xmlns:a16="http://schemas.microsoft.com/office/drawing/2014/main" id="{5387B013-B00A-005D-D62C-E1905186F392}"/>
                  </a:ext>
                </a:extLst>
              </p:cNvPr>
              <p:cNvSpPr txBox="1"/>
              <p:nvPr/>
            </p:nvSpPr>
            <p:spPr>
              <a:xfrm rot="16200000">
                <a:off x="-144597" y="3558343"/>
                <a:ext cx="11920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4" name="Textfeld 1023">
                <a:extLst>
                  <a:ext uri="{FF2B5EF4-FFF2-40B4-BE49-F238E27FC236}">
                    <a16:creationId xmlns="" xmlns:a16="http://schemas.microsoft.com/office/drawing/2014/main" id="{6EE58ABE-5042-A4FA-49BB-B296FB8DC55E}"/>
                  </a:ext>
                </a:extLst>
              </p:cNvPr>
              <p:cNvSpPr txBox="1"/>
              <p:nvPr/>
            </p:nvSpPr>
            <p:spPr>
              <a:xfrm>
                <a:off x="202830" y="2843327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c</a:t>
                </a:r>
              </a:p>
            </p:txBody>
          </p:sp>
          <p:sp>
            <p:nvSpPr>
              <p:cNvPr id="1025" name="Textfeld 1024">
                <a:extLst>
                  <a:ext uri="{FF2B5EF4-FFF2-40B4-BE49-F238E27FC236}">
                    <a16:creationId xmlns="" xmlns:a16="http://schemas.microsoft.com/office/drawing/2014/main" id="{04BC29A6-3A2C-017F-3ED6-E5064A552523}"/>
                  </a:ext>
                </a:extLst>
              </p:cNvPr>
              <p:cNvSpPr txBox="1"/>
              <p:nvPr/>
            </p:nvSpPr>
            <p:spPr>
              <a:xfrm>
                <a:off x="3959328" y="2866422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d</a:t>
                </a:r>
              </a:p>
            </p:txBody>
          </p:sp>
          <p:cxnSp>
            <p:nvCxnSpPr>
              <p:cNvPr id="1028" name="Gerade Verbindung 269">
                <a:extLst>
                  <a:ext uri="{FF2B5EF4-FFF2-40B4-BE49-F238E27FC236}">
                    <a16:creationId xmlns="" xmlns:a16="http://schemas.microsoft.com/office/drawing/2014/main" id="{6569C437-D054-89EF-9560-B888EC770628}"/>
                  </a:ext>
                </a:extLst>
              </p:cNvPr>
              <p:cNvCxnSpPr/>
              <p:nvPr/>
            </p:nvCxnSpPr>
            <p:spPr>
              <a:xfrm flipH="1">
                <a:off x="603891" y="1651282"/>
                <a:ext cx="3024000" cy="0"/>
              </a:xfrm>
              <a:prstGeom prst="line">
                <a:avLst/>
              </a:prstGeom>
              <a:ln>
                <a:solidFill>
                  <a:srgbClr val="339E6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9" name="Gerade Verbindung 290">
                <a:extLst>
                  <a:ext uri="{FF2B5EF4-FFF2-40B4-BE49-F238E27FC236}">
                    <a16:creationId xmlns="" xmlns:a16="http://schemas.microsoft.com/office/drawing/2014/main" id="{17C9B9D4-AE2B-CC8F-74BE-E3B647A10D69}"/>
                  </a:ext>
                </a:extLst>
              </p:cNvPr>
              <p:cNvCxnSpPr/>
              <p:nvPr/>
            </p:nvCxnSpPr>
            <p:spPr>
              <a:xfrm>
                <a:off x="4401952" y="1693210"/>
                <a:ext cx="2358000" cy="0"/>
              </a:xfrm>
              <a:prstGeom prst="line">
                <a:avLst/>
              </a:prstGeom>
              <a:ln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0" name="Gerade Verbindung 291">
                <a:extLst>
                  <a:ext uri="{FF2B5EF4-FFF2-40B4-BE49-F238E27FC236}">
                    <a16:creationId xmlns="" xmlns:a16="http://schemas.microsoft.com/office/drawing/2014/main" id="{FBAC9A5C-D4FB-0059-A2D0-2D1FC23BB56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4863" y="1231407"/>
                <a:ext cx="2358000" cy="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Google Shape;87;p1">
                <a:extLst>
                  <a:ext uri="{FF2B5EF4-FFF2-40B4-BE49-F238E27FC236}">
                    <a16:creationId xmlns="" xmlns:a16="http://schemas.microsoft.com/office/drawing/2014/main" id="{1B9247B0-AD87-78BA-B08F-BB97E6521460}"/>
                  </a:ext>
                </a:extLst>
              </p:cNvPr>
              <p:cNvSpPr txBox="1"/>
              <p:nvPr/>
            </p:nvSpPr>
            <p:spPr>
              <a:xfrm>
                <a:off x="206318" y="136144"/>
                <a:ext cx="6578680" cy="3765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000" b="1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SAMPLE ID023</a:t>
                </a:r>
              </a:p>
            </p:txBody>
          </p:sp>
          <p:sp>
            <p:nvSpPr>
              <p:cNvPr id="33" name="Google Shape;87;p1">
                <a:extLst>
                  <a:ext uri="{FF2B5EF4-FFF2-40B4-BE49-F238E27FC236}">
                    <a16:creationId xmlns="" xmlns:a16="http://schemas.microsoft.com/office/drawing/2014/main" id="{DFEE346A-E980-7E62-DA83-942649C94D65}"/>
                  </a:ext>
                </a:extLst>
              </p:cNvPr>
              <p:cNvSpPr txBox="1"/>
              <p:nvPr/>
            </p:nvSpPr>
            <p:spPr>
              <a:xfrm>
                <a:off x="202830" y="2592363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u="sng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ONT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aneuploid (-5)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  <p:sp>
            <p:nvSpPr>
              <p:cNvPr id="34" name="Google Shape;87;p1">
                <a:extLst>
                  <a:ext uri="{FF2B5EF4-FFF2-40B4-BE49-F238E27FC236}">
                    <a16:creationId xmlns="" xmlns:a16="http://schemas.microsoft.com/office/drawing/2014/main" id="{D9B2E54E-E92C-E319-3792-48CF972F6959}"/>
                  </a:ext>
                </a:extLst>
              </p:cNvPr>
              <p:cNvSpPr txBox="1"/>
              <p:nvPr/>
            </p:nvSpPr>
            <p:spPr>
              <a:xfrm>
                <a:off x="202830" y="506441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lvl="0" algn="ctr"/>
                <a:r>
                  <a:rPr lang="en-US" sz="1600" u="sng" dirty="0" err="1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aCGH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euploid | reported: euploid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</p:grpSp>
        <p:pic>
          <p:nvPicPr>
            <p:cNvPr id="143" name="Grafik 142">
              <a:extLst>
                <a:ext uri="{FF2B5EF4-FFF2-40B4-BE49-F238E27FC236}">
                  <a16:creationId xmlns="" xmlns:a16="http://schemas.microsoft.com/office/drawing/2014/main" id="{A7F6CA14-EC34-0E6C-52E0-9187309A76B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308" y="8033048"/>
              <a:ext cx="3075251" cy="1144024"/>
            </a:xfrm>
            <a:prstGeom prst="rect">
              <a:avLst/>
            </a:prstGeom>
          </p:spPr>
        </p:pic>
        <p:pic>
          <p:nvPicPr>
            <p:cNvPr id="145" name="Grafik 144">
              <a:extLst>
                <a:ext uri="{FF2B5EF4-FFF2-40B4-BE49-F238E27FC236}">
                  <a16:creationId xmlns="" xmlns:a16="http://schemas.microsoft.com/office/drawing/2014/main" id="{3B21379E-5F80-F171-E437-DF8116AB478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1242" y="8004630"/>
              <a:ext cx="2488027" cy="1195028"/>
            </a:xfrm>
            <a:prstGeom prst="rect">
              <a:avLst/>
            </a:prstGeom>
          </p:spPr>
        </p:pic>
      </p:grpSp>
      <p:grpSp>
        <p:nvGrpSpPr>
          <p:cNvPr id="190" name="Gruppieren 189">
            <a:extLst>
              <a:ext uri="{FF2B5EF4-FFF2-40B4-BE49-F238E27FC236}">
                <a16:creationId xmlns="" xmlns:a16="http://schemas.microsoft.com/office/drawing/2014/main" id="{F7A3C115-9BDF-BE76-3E79-3B7928152C9C}"/>
              </a:ext>
            </a:extLst>
          </p:cNvPr>
          <p:cNvGrpSpPr/>
          <p:nvPr/>
        </p:nvGrpSpPr>
        <p:grpSpPr>
          <a:xfrm>
            <a:off x="341983" y="300109"/>
            <a:ext cx="6596031" cy="4328908"/>
            <a:chOff x="202830" y="136144"/>
            <a:chExt cx="6596031" cy="4328908"/>
          </a:xfrm>
        </p:grpSpPr>
        <p:pic>
          <p:nvPicPr>
            <p:cNvPr id="191" name="Grafik 190" descr="Ein Bild, das Text, parallel, Diagramm, Reihe enthält.&#10;&#10;Automatisch generierte Beschreibung">
              <a:extLst>
                <a:ext uri="{FF2B5EF4-FFF2-40B4-BE49-F238E27FC236}">
                  <a16:creationId xmlns="" xmlns:a16="http://schemas.microsoft.com/office/drawing/2014/main" id="{24D9E6FB-87DE-7F0F-B4EA-97098A8F31E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3672" y="1038018"/>
              <a:ext cx="2501189" cy="1130400"/>
            </a:xfrm>
            <a:prstGeom prst="rect">
              <a:avLst/>
            </a:prstGeom>
          </p:spPr>
        </p:pic>
        <p:pic>
          <p:nvPicPr>
            <p:cNvPr id="1026" name="Grafik 1025" descr="Ein Bild, das Text, Reihe, Schrift, Screenshot enthält.&#10;&#10;Automatisch generierte Beschreibung">
              <a:extLst>
                <a:ext uri="{FF2B5EF4-FFF2-40B4-BE49-F238E27FC236}">
                  <a16:creationId xmlns="" xmlns:a16="http://schemas.microsoft.com/office/drawing/2014/main" id="{12300E3A-85FA-41DB-3732-01FA3B3C7FF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0728" y="1040255"/>
              <a:ext cx="3096000" cy="1131624"/>
            </a:xfrm>
            <a:prstGeom prst="rect">
              <a:avLst/>
            </a:prstGeom>
          </p:spPr>
        </p:pic>
        <p:pic>
          <p:nvPicPr>
            <p:cNvPr id="1027" name="Grafik 1026">
              <a:extLst>
                <a:ext uri="{FF2B5EF4-FFF2-40B4-BE49-F238E27FC236}">
                  <a16:creationId xmlns="" xmlns:a16="http://schemas.microsoft.com/office/drawing/2014/main" id="{60F8E9CA-21DB-27FE-9FFD-9D623872C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3908" y="3076245"/>
              <a:ext cx="3075251" cy="1195028"/>
            </a:xfrm>
            <a:prstGeom prst="rect">
              <a:avLst/>
            </a:prstGeom>
          </p:spPr>
        </p:pic>
        <p:pic>
          <p:nvPicPr>
            <p:cNvPr id="1031" name="Grafik 1030">
              <a:extLst>
                <a:ext uri="{FF2B5EF4-FFF2-40B4-BE49-F238E27FC236}">
                  <a16:creationId xmlns="" xmlns:a16="http://schemas.microsoft.com/office/drawing/2014/main" id="{448DC6C5-6FF9-994C-A491-9ACDEACDAE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9864" y="3074090"/>
              <a:ext cx="2498997" cy="1195028"/>
            </a:xfrm>
            <a:prstGeom prst="rect">
              <a:avLst/>
            </a:prstGeom>
          </p:spPr>
        </p:pic>
        <p:sp>
          <p:nvSpPr>
            <p:cNvPr id="1032" name="Textfeld 1031">
              <a:extLst>
                <a:ext uri="{FF2B5EF4-FFF2-40B4-BE49-F238E27FC236}">
                  <a16:creationId xmlns="" xmlns:a16="http://schemas.microsoft.com/office/drawing/2014/main" id="{73F5BD49-1607-F484-1584-B462B7475649}"/>
                </a:ext>
              </a:extLst>
            </p:cNvPr>
            <p:cNvSpPr txBox="1"/>
            <p:nvPr/>
          </p:nvSpPr>
          <p:spPr>
            <a:xfrm rot="16200000">
              <a:off x="-108848" y="1490236"/>
              <a:ext cx="11311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Log</a:t>
              </a:r>
              <a:r>
                <a:rPr lang="de-AT" sz="900" baseline="-25000" dirty="0">
                  <a:latin typeface="Consolas" panose="020B0609020204030204" pitchFamily="49" charset="0"/>
                  <a:cs typeface="Arial" panose="020B0604020202020204" pitchFamily="34" charset="0"/>
                </a:rPr>
                <a:t>2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atio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33" name="Textfeld 1032">
              <a:extLst>
                <a:ext uri="{FF2B5EF4-FFF2-40B4-BE49-F238E27FC236}">
                  <a16:creationId xmlns="" xmlns:a16="http://schemas.microsoft.com/office/drawing/2014/main" id="{4C7CECB1-99BC-03D4-37A4-03DD68E437D9}"/>
                </a:ext>
              </a:extLst>
            </p:cNvPr>
            <p:cNvSpPr txBox="1"/>
            <p:nvPr/>
          </p:nvSpPr>
          <p:spPr>
            <a:xfrm>
              <a:off x="206317" y="757465"/>
              <a:ext cx="330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</a:t>
              </a:r>
            </a:p>
          </p:txBody>
        </p:sp>
        <p:sp>
          <p:nvSpPr>
            <p:cNvPr id="1034" name="Textfeld 1033">
              <a:extLst>
                <a:ext uri="{FF2B5EF4-FFF2-40B4-BE49-F238E27FC236}">
                  <a16:creationId xmlns="" xmlns:a16="http://schemas.microsoft.com/office/drawing/2014/main" id="{5213CD85-F2C2-8E94-5740-3AE5EE9B18BE}"/>
                </a:ext>
              </a:extLst>
            </p:cNvPr>
            <p:cNvSpPr txBox="1"/>
            <p:nvPr/>
          </p:nvSpPr>
          <p:spPr>
            <a:xfrm>
              <a:off x="3962815" y="780560"/>
              <a:ext cx="331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b</a:t>
              </a:r>
            </a:p>
          </p:txBody>
        </p:sp>
        <p:sp>
          <p:nvSpPr>
            <p:cNvPr id="1035" name="Textfeld 1034">
              <a:extLst>
                <a:ext uri="{FF2B5EF4-FFF2-40B4-BE49-F238E27FC236}">
                  <a16:creationId xmlns="" xmlns:a16="http://schemas.microsoft.com/office/drawing/2014/main" id="{E774F788-0E12-0E3C-CE2A-92D38D7A68E5}"/>
                </a:ext>
              </a:extLst>
            </p:cNvPr>
            <p:cNvSpPr txBox="1"/>
            <p:nvPr/>
          </p:nvSpPr>
          <p:spPr>
            <a:xfrm rot="16200000">
              <a:off x="3569417" y="1523239"/>
              <a:ext cx="12221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Mean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 log</a:t>
              </a:r>
              <a:r>
                <a:rPr lang="de-AT" sz="900" baseline="-25000" dirty="0">
                  <a:latin typeface="Consolas" panose="020B0609020204030204" pitchFamily="49" charset="0"/>
                  <a:cs typeface="Arial" panose="020B0604020202020204" pitchFamily="34" charset="0"/>
                </a:rPr>
                <a:t>2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atio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36" name="Textfeld 1035">
              <a:extLst>
                <a:ext uri="{FF2B5EF4-FFF2-40B4-BE49-F238E27FC236}">
                  <a16:creationId xmlns="" xmlns:a16="http://schemas.microsoft.com/office/drawing/2014/main" id="{85DAEFC6-071E-A973-0FA3-5B08B9B69740}"/>
                </a:ext>
              </a:extLst>
            </p:cNvPr>
            <p:cNvSpPr txBox="1"/>
            <p:nvPr/>
          </p:nvSpPr>
          <p:spPr>
            <a:xfrm>
              <a:off x="579532" y="2148018"/>
              <a:ext cx="3091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37" name="Textfeld 1036">
              <a:extLst>
                <a:ext uri="{FF2B5EF4-FFF2-40B4-BE49-F238E27FC236}">
                  <a16:creationId xmlns="" xmlns:a16="http://schemas.microsoft.com/office/drawing/2014/main" id="{0C340CCD-FD06-70CD-526C-BBA948F5B264}"/>
                </a:ext>
              </a:extLst>
            </p:cNvPr>
            <p:cNvSpPr txBox="1"/>
            <p:nvPr/>
          </p:nvSpPr>
          <p:spPr>
            <a:xfrm>
              <a:off x="4294016" y="2151068"/>
              <a:ext cx="2498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38" name="Textfeld 1037">
              <a:extLst>
                <a:ext uri="{FF2B5EF4-FFF2-40B4-BE49-F238E27FC236}">
                  <a16:creationId xmlns="" xmlns:a16="http://schemas.microsoft.com/office/drawing/2014/main" id="{6A0B9BC8-E28C-B46B-C1C4-082E7A2CEA23}"/>
                </a:ext>
              </a:extLst>
            </p:cNvPr>
            <p:cNvSpPr txBox="1"/>
            <p:nvPr/>
          </p:nvSpPr>
          <p:spPr>
            <a:xfrm rot="16200000">
              <a:off x="3602725" y="3540074"/>
              <a:ext cx="11555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ead </a:t>
              </a:r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ount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39" name="Textfeld 1038">
              <a:extLst>
                <a:ext uri="{FF2B5EF4-FFF2-40B4-BE49-F238E27FC236}">
                  <a16:creationId xmlns="" xmlns:a16="http://schemas.microsoft.com/office/drawing/2014/main" id="{7F41DD27-02E8-DF35-3271-1472667917FB}"/>
                </a:ext>
              </a:extLst>
            </p:cNvPr>
            <p:cNvSpPr txBox="1"/>
            <p:nvPr/>
          </p:nvSpPr>
          <p:spPr>
            <a:xfrm>
              <a:off x="528281" y="4234220"/>
              <a:ext cx="30752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40" name="Textfeld 1039">
              <a:extLst>
                <a:ext uri="{FF2B5EF4-FFF2-40B4-BE49-F238E27FC236}">
                  <a16:creationId xmlns="" xmlns:a16="http://schemas.microsoft.com/office/drawing/2014/main" id="{8233E7D5-4995-6EBF-EB01-8DE001356763}"/>
                </a:ext>
              </a:extLst>
            </p:cNvPr>
            <p:cNvSpPr txBox="1"/>
            <p:nvPr/>
          </p:nvSpPr>
          <p:spPr>
            <a:xfrm>
              <a:off x="4299864" y="4233243"/>
              <a:ext cx="24739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41" name="Textfeld 1040">
              <a:extLst>
                <a:ext uri="{FF2B5EF4-FFF2-40B4-BE49-F238E27FC236}">
                  <a16:creationId xmlns="" xmlns:a16="http://schemas.microsoft.com/office/drawing/2014/main" id="{0EBE7235-9706-4369-C914-0009A992FD27}"/>
                </a:ext>
              </a:extLst>
            </p:cNvPr>
            <p:cNvSpPr txBox="1"/>
            <p:nvPr/>
          </p:nvSpPr>
          <p:spPr>
            <a:xfrm rot="16200000">
              <a:off x="-144597" y="3558343"/>
              <a:ext cx="11920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ead </a:t>
              </a:r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ount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042" name="Textfeld 1041">
              <a:extLst>
                <a:ext uri="{FF2B5EF4-FFF2-40B4-BE49-F238E27FC236}">
                  <a16:creationId xmlns="" xmlns:a16="http://schemas.microsoft.com/office/drawing/2014/main" id="{D00268A8-8BC3-A306-42A8-048F707D6995}"/>
                </a:ext>
              </a:extLst>
            </p:cNvPr>
            <p:cNvSpPr txBox="1"/>
            <p:nvPr/>
          </p:nvSpPr>
          <p:spPr>
            <a:xfrm>
              <a:off x="202830" y="2843327"/>
              <a:ext cx="330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c</a:t>
              </a:r>
            </a:p>
          </p:txBody>
        </p:sp>
        <p:sp>
          <p:nvSpPr>
            <p:cNvPr id="1043" name="Textfeld 1042">
              <a:extLst>
                <a:ext uri="{FF2B5EF4-FFF2-40B4-BE49-F238E27FC236}">
                  <a16:creationId xmlns="" xmlns:a16="http://schemas.microsoft.com/office/drawing/2014/main" id="{27211496-B1B1-F571-24B7-6DB86B665951}"/>
                </a:ext>
              </a:extLst>
            </p:cNvPr>
            <p:cNvSpPr txBox="1"/>
            <p:nvPr/>
          </p:nvSpPr>
          <p:spPr>
            <a:xfrm>
              <a:off x="3959328" y="2866422"/>
              <a:ext cx="331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d</a:t>
              </a:r>
            </a:p>
          </p:txBody>
        </p:sp>
        <p:cxnSp>
          <p:nvCxnSpPr>
            <p:cNvPr id="1044" name="Gerade Verbindung 269">
              <a:extLst>
                <a:ext uri="{FF2B5EF4-FFF2-40B4-BE49-F238E27FC236}">
                  <a16:creationId xmlns="" xmlns:a16="http://schemas.microsoft.com/office/drawing/2014/main" id="{84391768-5CE7-B088-1E59-09DFC1477853}"/>
                </a:ext>
              </a:extLst>
            </p:cNvPr>
            <p:cNvCxnSpPr/>
            <p:nvPr/>
          </p:nvCxnSpPr>
          <p:spPr>
            <a:xfrm flipH="1">
              <a:off x="603891" y="1651282"/>
              <a:ext cx="3024000" cy="0"/>
            </a:xfrm>
            <a:prstGeom prst="line">
              <a:avLst/>
            </a:prstGeom>
            <a:ln>
              <a:solidFill>
                <a:srgbClr val="339E66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5" name="Gerade Verbindung 290">
              <a:extLst>
                <a:ext uri="{FF2B5EF4-FFF2-40B4-BE49-F238E27FC236}">
                  <a16:creationId xmlns="" xmlns:a16="http://schemas.microsoft.com/office/drawing/2014/main" id="{1B193DE6-4051-D812-C227-A2FBA7EE26D5}"/>
                </a:ext>
              </a:extLst>
            </p:cNvPr>
            <p:cNvCxnSpPr/>
            <p:nvPr/>
          </p:nvCxnSpPr>
          <p:spPr>
            <a:xfrm>
              <a:off x="4401952" y="1693210"/>
              <a:ext cx="2358000" cy="0"/>
            </a:xfrm>
            <a:prstGeom prst="line">
              <a:avLst/>
            </a:prstGeom>
            <a:ln>
              <a:solidFill>
                <a:srgbClr val="0070C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6" name="Gerade Verbindung 291">
              <a:extLst>
                <a:ext uri="{FF2B5EF4-FFF2-40B4-BE49-F238E27FC236}">
                  <a16:creationId xmlns="" xmlns:a16="http://schemas.microsoft.com/office/drawing/2014/main" id="{E07E132D-47AD-A084-3882-810E8721CFC7}"/>
                </a:ext>
              </a:extLst>
            </p:cNvPr>
            <p:cNvCxnSpPr>
              <a:cxnSpLocks/>
            </p:cNvCxnSpPr>
            <p:nvPr/>
          </p:nvCxnSpPr>
          <p:spPr>
            <a:xfrm>
              <a:off x="4404863" y="1231407"/>
              <a:ext cx="2358000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7" name="Google Shape;87;p1">
              <a:extLst>
                <a:ext uri="{FF2B5EF4-FFF2-40B4-BE49-F238E27FC236}">
                  <a16:creationId xmlns="" xmlns:a16="http://schemas.microsoft.com/office/drawing/2014/main" id="{87DBC4AB-B927-B920-0E0B-7B95C8D84625}"/>
                </a:ext>
              </a:extLst>
            </p:cNvPr>
            <p:cNvSpPr txBox="1"/>
            <p:nvPr/>
          </p:nvSpPr>
          <p:spPr>
            <a:xfrm>
              <a:off x="206318" y="136144"/>
              <a:ext cx="6578680" cy="37656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marL="0" marR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000" b="1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SAMPLE ID006</a:t>
              </a:r>
              <a:endParaRPr b="1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endParaRPr>
            </a:p>
          </p:txBody>
        </p:sp>
        <p:sp>
          <p:nvSpPr>
            <p:cNvPr id="1048" name="Google Shape;87;p1">
              <a:extLst>
                <a:ext uri="{FF2B5EF4-FFF2-40B4-BE49-F238E27FC236}">
                  <a16:creationId xmlns="" xmlns:a16="http://schemas.microsoft.com/office/drawing/2014/main" id="{DBF235BF-DA5D-7102-9044-CB7BE40A6894}"/>
                </a:ext>
              </a:extLst>
            </p:cNvPr>
            <p:cNvSpPr txBox="1"/>
            <p:nvPr/>
          </p:nvSpPr>
          <p:spPr>
            <a:xfrm>
              <a:off x="202830" y="2592363"/>
              <a:ext cx="6590184" cy="3245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u="sng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ONT</a:t>
              </a:r>
              <a:r>
                <a:rPr lang="en-US" sz="16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: </a:t>
              </a:r>
              <a:r>
                <a:rPr lang="en-US" sz="1600" dirty="0" err="1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aneuploid</a:t>
              </a:r>
              <a:r>
                <a:rPr lang="en-US" sz="16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 (-4, -19, -21)</a:t>
              </a:r>
              <a:endParaRPr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endParaRPr>
            </a:p>
          </p:txBody>
        </p:sp>
        <p:sp>
          <p:nvSpPr>
            <p:cNvPr id="1049" name="Google Shape;87;p1">
              <a:extLst>
                <a:ext uri="{FF2B5EF4-FFF2-40B4-BE49-F238E27FC236}">
                  <a16:creationId xmlns="" xmlns:a16="http://schemas.microsoft.com/office/drawing/2014/main" id="{5BC86276-FC07-111A-D3C6-D60B1471ACF7}"/>
                </a:ext>
              </a:extLst>
            </p:cNvPr>
            <p:cNvSpPr txBox="1"/>
            <p:nvPr/>
          </p:nvSpPr>
          <p:spPr>
            <a:xfrm>
              <a:off x="202830" y="506441"/>
              <a:ext cx="6590184" cy="3245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lvl="0" algn="ctr"/>
              <a:r>
                <a:rPr lang="en-US" sz="1600" u="sng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aCGH</a:t>
              </a:r>
              <a:r>
                <a:rPr lang="en-US" sz="16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: aneuploid (-19) | reported: N/A</a:t>
              </a:r>
              <a:endPara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endParaRPr>
            </a:p>
          </p:txBody>
        </p:sp>
      </p:grpSp>
      <p:grpSp>
        <p:nvGrpSpPr>
          <p:cNvPr id="1127" name="Gruppieren 1126">
            <a:extLst>
              <a:ext uri="{FF2B5EF4-FFF2-40B4-BE49-F238E27FC236}">
                <a16:creationId xmlns="" xmlns:a16="http://schemas.microsoft.com/office/drawing/2014/main" id="{FAD4BFF5-3FD1-AE3D-7524-71F9BBF08E7B}"/>
              </a:ext>
            </a:extLst>
          </p:cNvPr>
          <p:cNvGrpSpPr/>
          <p:nvPr/>
        </p:nvGrpSpPr>
        <p:grpSpPr>
          <a:xfrm>
            <a:off x="355230" y="10252824"/>
            <a:ext cx="6592538" cy="4328908"/>
            <a:chOff x="355230" y="10040963"/>
            <a:chExt cx="6592538" cy="4328908"/>
          </a:xfrm>
        </p:grpSpPr>
        <p:sp>
          <p:nvSpPr>
            <p:cNvPr id="158" name="Textfeld 157">
              <a:extLst>
                <a:ext uri="{FF2B5EF4-FFF2-40B4-BE49-F238E27FC236}">
                  <a16:creationId xmlns="" xmlns:a16="http://schemas.microsoft.com/office/drawing/2014/main" id="{3761A036-53F4-6CA5-8F7E-F5378832358F}"/>
                </a:ext>
              </a:extLst>
            </p:cNvPr>
            <p:cNvSpPr txBox="1"/>
            <p:nvPr/>
          </p:nvSpPr>
          <p:spPr>
            <a:xfrm rot="16200000">
              <a:off x="43552" y="11395055"/>
              <a:ext cx="11311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Log</a:t>
              </a:r>
              <a:r>
                <a:rPr lang="de-AT" sz="900" baseline="-25000" dirty="0">
                  <a:latin typeface="Consolas" panose="020B0609020204030204" pitchFamily="49" charset="0"/>
                  <a:cs typeface="Arial" panose="020B0604020202020204" pitchFamily="34" charset="0"/>
                </a:rPr>
                <a:t>2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atio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66" name="Textfeld 165">
              <a:extLst>
                <a:ext uri="{FF2B5EF4-FFF2-40B4-BE49-F238E27FC236}">
                  <a16:creationId xmlns="" xmlns:a16="http://schemas.microsoft.com/office/drawing/2014/main" id="{CFD883CA-04F2-6F33-583D-5714B75D94A8}"/>
                </a:ext>
              </a:extLst>
            </p:cNvPr>
            <p:cNvSpPr txBox="1"/>
            <p:nvPr/>
          </p:nvSpPr>
          <p:spPr>
            <a:xfrm>
              <a:off x="358717" y="10662284"/>
              <a:ext cx="330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</a:t>
              </a:r>
            </a:p>
          </p:txBody>
        </p:sp>
        <p:sp>
          <p:nvSpPr>
            <p:cNvPr id="167" name="Textfeld 166">
              <a:extLst>
                <a:ext uri="{FF2B5EF4-FFF2-40B4-BE49-F238E27FC236}">
                  <a16:creationId xmlns="" xmlns:a16="http://schemas.microsoft.com/office/drawing/2014/main" id="{91DFEF64-2E54-9622-9728-400A734B5702}"/>
                </a:ext>
              </a:extLst>
            </p:cNvPr>
            <p:cNvSpPr txBox="1"/>
            <p:nvPr/>
          </p:nvSpPr>
          <p:spPr>
            <a:xfrm>
              <a:off x="4115215" y="10685379"/>
              <a:ext cx="331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b</a:t>
              </a:r>
            </a:p>
          </p:txBody>
        </p:sp>
        <p:sp>
          <p:nvSpPr>
            <p:cNvPr id="168" name="Textfeld 167">
              <a:extLst>
                <a:ext uri="{FF2B5EF4-FFF2-40B4-BE49-F238E27FC236}">
                  <a16:creationId xmlns="" xmlns:a16="http://schemas.microsoft.com/office/drawing/2014/main" id="{00163BCB-0981-7D01-D5CC-F5E8ACE8BADB}"/>
                </a:ext>
              </a:extLst>
            </p:cNvPr>
            <p:cNvSpPr txBox="1"/>
            <p:nvPr/>
          </p:nvSpPr>
          <p:spPr>
            <a:xfrm rot="16200000">
              <a:off x="3721817" y="11428058"/>
              <a:ext cx="12221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Mean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 log</a:t>
              </a:r>
              <a:r>
                <a:rPr lang="de-AT" sz="900" baseline="-25000" dirty="0">
                  <a:latin typeface="Consolas" panose="020B0609020204030204" pitchFamily="49" charset="0"/>
                  <a:cs typeface="Arial" panose="020B0604020202020204" pitchFamily="34" charset="0"/>
                </a:rPr>
                <a:t>2</a:t>
              </a:r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atio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69" name="Textfeld 168">
              <a:extLst>
                <a:ext uri="{FF2B5EF4-FFF2-40B4-BE49-F238E27FC236}">
                  <a16:creationId xmlns="" xmlns:a16="http://schemas.microsoft.com/office/drawing/2014/main" id="{985B8272-ED33-EBD8-9A47-1F200C17108C}"/>
                </a:ext>
              </a:extLst>
            </p:cNvPr>
            <p:cNvSpPr txBox="1"/>
            <p:nvPr/>
          </p:nvSpPr>
          <p:spPr>
            <a:xfrm>
              <a:off x="731932" y="12052837"/>
              <a:ext cx="30913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0" name="Textfeld 169">
              <a:extLst>
                <a:ext uri="{FF2B5EF4-FFF2-40B4-BE49-F238E27FC236}">
                  <a16:creationId xmlns="" xmlns:a16="http://schemas.microsoft.com/office/drawing/2014/main" id="{F29AD5FC-A143-C21D-BB5D-090CB8194534}"/>
                </a:ext>
              </a:extLst>
            </p:cNvPr>
            <p:cNvSpPr txBox="1"/>
            <p:nvPr/>
          </p:nvSpPr>
          <p:spPr>
            <a:xfrm>
              <a:off x="4446416" y="12055887"/>
              <a:ext cx="24989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1" name="Textfeld 170">
              <a:extLst>
                <a:ext uri="{FF2B5EF4-FFF2-40B4-BE49-F238E27FC236}">
                  <a16:creationId xmlns="" xmlns:a16="http://schemas.microsoft.com/office/drawing/2014/main" id="{63440302-683C-C474-9767-000250E3AE76}"/>
                </a:ext>
              </a:extLst>
            </p:cNvPr>
            <p:cNvSpPr txBox="1"/>
            <p:nvPr/>
          </p:nvSpPr>
          <p:spPr>
            <a:xfrm rot="16200000">
              <a:off x="3755125" y="13444893"/>
              <a:ext cx="11555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ead </a:t>
              </a:r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ount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2" name="Textfeld 171">
              <a:extLst>
                <a:ext uri="{FF2B5EF4-FFF2-40B4-BE49-F238E27FC236}">
                  <a16:creationId xmlns="" xmlns:a16="http://schemas.microsoft.com/office/drawing/2014/main" id="{3DCE4D6F-DB93-B656-FBE4-90622733B738}"/>
                </a:ext>
              </a:extLst>
            </p:cNvPr>
            <p:cNvSpPr txBox="1"/>
            <p:nvPr/>
          </p:nvSpPr>
          <p:spPr>
            <a:xfrm>
              <a:off x="680681" y="14139039"/>
              <a:ext cx="30752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3" name="Textfeld 172">
              <a:extLst>
                <a:ext uri="{FF2B5EF4-FFF2-40B4-BE49-F238E27FC236}">
                  <a16:creationId xmlns="" xmlns:a16="http://schemas.microsoft.com/office/drawing/2014/main" id="{037A2800-09C3-AD34-16E8-B5D5CB2A3665}"/>
                </a:ext>
              </a:extLst>
            </p:cNvPr>
            <p:cNvSpPr txBox="1"/>
            <p:nvPr/>
          </p:nvSpPr>
          <p:spPr>
            <a:xfrm>
              <a:off x="4452264" y="14138062"/>
              <a:ext cx="247393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hromosomes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5" name="Textfeld 174">
              <a:extLst>
                <a:ext uri="{FF2B5EF4-FFF2-40B4-BE49-F238E27FC236}">
                  <a16:creationId xmlns="" xmlns:a16="http://schemas.microsoft.com/office/drawing/2014/main" id="{95843CAD-9614-01B2-12D8-D817710B1BA6}"/>
                </a:ext>
              </a:extLst>
            </p:cNvPr>
            <p:cNvSpPr txBox="1"/>
            <p:nvPr/>
          </p:nvSpPr>
          <p:spPr>
            <a:xfrm rot="16200000">
              <a:off x="7803" y="13463162"/>
              <a:ext cx="11920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AT" sz="900" dirty="0">
                  <a:latin typeface="Consolas" panose="020B0609020204030204" pitchFamily="49" charset="0"/>
                  <a:cs typeface="Arial" panose="020B0604020202020204" pitchFamily="34" charset="0"/>
                </a:rPr>
                <a:t>Read </a:t>
              </a:r>
              <a:r>
                <a:rPr lang="de-AT" sz="900" dirty="0" err="1">
                  <a:latin typeface="Consolas" panose="020B0609020204030204" pitchFamily="49" charset="0"/>
                  <a:cs typeface="Arial" panose="020B0604020202020204" pitchFamily="34" charset="0"/>
                </a:rPr>
                <a:t>count</a:t>
              </a:r>
              <a:endParaRPr lang="de-AT" sz="800" dirty="0">
                <a:latin typeface="Consolas" panose="020B0609020204030204" pitchFamily="49" charset="0"/>
                <a:cs typeface="Arial" panose="020B0604020202020204" pitchFamily="34" charset="0"/>
              </a:endParaRPr>
            </a:p>
          </p:txBody>
        </p:sp>
        <p:sp>
          <p:nvSpPr>
            <p:cNvPr id="176" name="Textfeld 175">
              <a:extLst>
                <a:ext uri="{FF2B5EF4-FFF2-40B4-BE49-F238E27FC236}">
                  <a16:creationId xmlns="" xmlns:a16="http://schemas.microsoft.com/office/drawing/2014/main" id="{97262903-2181-38C2-63BB-762B51693825}"/>
                </a:ext>
              </a:extLst>
            </p:cNvPr>
            <p:cNvSpPr txBox="1"/>
            <p:nvPr/>
          </p:nvSpPr>
          <p:spPr>
            <a:xfrm>
              <a:off x="355230" y="12748146"/>
              <a:ext cx="33035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c</a:t>
              </a:r>
            </a:p>
          </p:txBody>
        </p:sp>
        <p:sp>
          <p:nvSpPr>
            <p:cNvPr id="177" name="Textfeld 176">
              <a:extLst>
                <a:ext uri="{FF2B5EF4-FFF2-40B4-BE49-F238E27FC236}">
                  <a16:creationId xmlns="" xmlns:a16="http://schemas.microsoft.com/office/drawing/2014/main" id="{600689C2-062D-B9EA-DC8E-266DC414DB0A}"/>
                </a:ext>
              </a:extLst>
            </p:cNvPr>
            <p:cNvSpPr txBox="1"/>
            <p:nvPr/>
          </p:nvSpPr>
          <p:spPr>
            <a:xfrm>
              <a:off x="4111728" y="12771241"/>
              <a:ext cx="331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d</a:t>
              </a:r>
            </a:p>
          </p:txBody>
        </p:sp>
        <p:sp>
          <p:nvSpPr>
            <p:cNvPr id="181" name="Google Shape;87;p1">
              <a:extLst>
                <a:ext uri="{FF2B5EF4-FFF2-40B4-BE49-F238E27FC236}">
                  <a16:creationId xmlns="" xmlns:a16="http://schemas.microsoft.com/office/drawing/2014/main" id="{CE6DCB63-FDE0-B414-4DD0-B22D4CCA9944}"/>
                </a:ext>
              </a:extLst>
            </p:cNvPr>
            <p:cNvSpPr txBox="1"/>
            <p:nvPr/>
          </p:nvSpPr>
          <p:spPr>
            <a:xfrm>
              <a:off x="358718" y="10040963"/>
              <a:ext cx="6578680" cy="376569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marL="0" marR="0" lvl="0" indent="0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2000" b="1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SAMPLE ID028</a:t>
              </a:r>
            </a:p>
          </p:txBody>
        </p:sp>
        <p:sp>
          <p:nvSpPr>
            <p:cNvPr id="182" name="Google Shape;87;p1">
              <a:extLst>
                <a:ext uri="{FF2B5EF4-FFF2-40B4-BE49-F238E27FC236}">
                  <a16:creationId xmlns="" xmlns:a16="http://schemas.microsoft.com/office/drawing/2014/main" id="{91D9D109-9553-09C8-B20C-B77693068811}"/>
                </a:ext>
              </a:extLst>
            </p:cNvPr>
            <p:cNvSpPr txBox="1"/>
            <p:nvPr/>
          </p:nvSpPr>
          <p:spPr>
            <a:xfrm>
              <a:off x="355230" y="12497182"/>
              <a:ext cx="6590184" cy="3245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u="sng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ONT</a:t>
              </a:r>
              <a:r>
                <a:rPr lang="en-US" sz="16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: aneuploid (-21)</a:t>
              </a:r>
              <a:endPara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endParaRPr>
            </a:p>
          </p:txBody>
        </p:sp>
        <p:sp>
          <p:nvSpPr>
            <p:cNvPr id="185" name="Google Shape;87;p1">
              <a:extLst>
                <a:ext uri="{FF2B5EF4-FFF2-40B4-BE49-F238E27FC236}">
                  <a16:creationId xmlns="" xmlns:a16="http://schemas.microsoft.com/office/drawing/2014/main" id="{1EC7C6B6-48FA-FB6F-C453-4C064041516B}"/>
                </a:ext>
              </a:extLst>
            </p:cNvPr>
            <p:cNvSpPr txBox="1"/>
            <p:nvPr/>
          </p:nvSpPr>
          <p:spPr>
            <a:xfrm>
              <a:off x="355230" y="10411260"/>
              <a:ext cx="6590184" cy="32458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0000" tIns="45000" rIns="90000" bIns="45000" anchor="t" anchorCtr="0">
              <a:noAutofit/>
            </a:bodyPr>
            <a:lstStyle/>
            <a:p>
              <a:pPr lvl="0" algn="ctr"/>
              <a:r>
                <a:rPr lang="en-US" sz="1600" u="sng" dirty="0" err="1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aCGH</a:t>
              </a:r>
              <a:r>
                <a:rPr lang="en-US" sz="16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rPr>
                <a:t>: euploid | reported: aneuploid (-10, -14, -21)</a:t>
              </a:r>
              <a:endParaRPr lang="en-US" sz="14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endParaRPr>
            </a:p>
          </p:txBody>
        </p:sp>
        <p:pic>
          <p:nvPicPr>
            <p:cNvPr id="188" name="Grafik 187">
              <a:extLst>
                <a:ext uri="{FF2B5EF4-FFF2-40B4-BE49-F238E27FC236}">
                  <a16:creationId xmlns="" xmlns:a16="http://schemas.microsoft.com/office/drawing/2014/main" id="{EEED6813-9DD8-6FA4-EFB8-5CD9DE2251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6072" y="12977085"/>
              <a:ext cx="2480125" cy="1195027"/>
            </a:xfrm>
            <a:prstGeom prst="rect">
              <a:avLst/>
            </a:prstGeom>
          </p:spPr>
        </p:pic>
        <p:pic>
          <p:nvPicPr>
            <p:cNvPr id="189" name="Grafik 188">
              <a:extLst>
                <a:ext uri="{FF2B5EF4-FFF2-40B4-BE49-F238E27FC236}">
                  <a16:creationId xmlns="" xmlns:a16="http://schemas.microsoft.com/office/drawing/2014/main" id="{8EC6EFBC-D799-F941-DCF3-79EA596826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1295" y="13030258"/>
              <a:ext cx="3074400" cy="1100432"/>
            </a:xfrm>
            <a:prstGeom prst="rect">
              <a:avLst/>
            </a:prstGeom>
          </p:spPr>
        </p:pic>
        <p:pic>
          <p:nvPicPr>
            <p:cNvPr id="1122" name="Grafik 1121" descr="Ein Bild, das Text, Reihe, Screenshot, Diagramm enthält.&#10;&#10;Automatisch generierte Beschreibung">
              <a:extLst>
                <a:ext uri="{FF2B5EF4-FFF2-40B4-BE49-F238E27FC236}">
                  <a16:creationId xmlns="" xmlns:a16="http://schemas.microsoft.com/office/drawing/2014/main" id="{DAD437BB-660A-7D4F-9AF2-74104BF937B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1965" y="10942837"/>
              <a:ext cx="3092652" cy="1130400"/>
            </a:xfrm>
            <a:prstGeom prst="rect">
              <a:avLst/>
            </a:prstGeom>
          </p:spPr>
        </p:pic>
        <p:cxnSp>
          <p:nvCxnSpPr>
            <p:cNvPr id="1123" name="Gerade Verbindung 269">
              <a:extLst>
                <a:ext uri="{FF2B5EF4-FFF2-40B4-BE49-F238E27FC236}">
                  <a16:creationId xmlns="" xmlns:a16="http://schemas.microsoft.com/office/drawing/2014/main" id="{9A7F997F-608A-9BD5-13BD-31590F005C69}"/>
                </a:ext>
              </a:extLst>
            </p:cNvPr>
            <p:cNvCxnSpPr/>
            <p:nvPr/>
          </p:nvCxnSpPr>
          <p:spPr>
            <a:xfrm flipH="1">
              <a:off x="756291" y="11556101"/>
              <a:ext cx="3024000" cy="0"/>
            </a:xfrm>
            <a:prstGeom prst="line">
              <a:avLst/>
            </a:prstGeom>
            <a:ln>
              <a:solidFill>
                <a:srgbClr val="339E66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24" name="Grafik 1123" descr="Ein Bild, das Text, Zahl, parallel, Reihe enthält.&#10;&#10;Automatisch generierte Beschreibung">
              <a:extLst>
                <a:ext uri="{FF2B5EF4-FFF2-40B4-BE49-F238E27FC236}">
                  <a16:creationId xmlns="" xmlns:a16="http://schemas.microsoft.com/office/drawing/2014/main" id="{EB5F64BD-E033-85EF-F3C3-F1B5B6DCD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46579" y="10942838"/>
              <a:ext cx="2501189" cy="1130400"/>
            </a:xfrm>
            <a:prstGeom prst="rect">
              <a:avLst/>
            </a:prstGeom>
          </p:spPr>
        </p:pic>
        <p:cxnSp>
          <p:nvCxnSpPr>
            <p:cNvPr id="1125" name="Gerade Verbindung 290">
              <a:extLst>
                <a:ext uri="{FF2B5EF4-FFF2-40B4-BE49-F238E27FC236}">
                  <a16:creationId xmlns="" xmlns:a16="http://schemas.microsoft.com/office/drawing/2014/main" id="{3371A79B-4F3B-DE2A-64BD-CCADF7BC18B5}"/>
                </a:ext>
              </a:extLst>
            </p:cNvPr>
            <p:cNvCxnSpPr/>
            <p:nvPr/>
          </p:nvCxnSpPr>
          <p:spPr>
            <a:xfrm>
              <a:off x="4554352" y="11598029"/>
              <a:ext cx="2358000" cy="0"/>
            </a:xfrm>
            <a:prstGeom prst="line">
              <a:avLst/>
            </a:prstGeom>
            <a:ln>
              <a:solidFill>
                <a:srgbClr val="0070C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6" name="Gerade Verbindung 291">
              <a:extLst>
                <a:ext uri="{FF2B5EF4-FFF2-40B4-BE49-F238E27FC236}">
                  <a16:creationId xmlns="" xmlns:a16="http://schemas.microsoft.com/office/drawing/2014/main" id="{A5EED1F7-009A-EE54-3167-2A0B1C308009}"/>
                </a:ext>
              </a:extLst>
            </p:cNvPr>
            <p:cNvCxnSpPr>
              <a:cxnSpLocks/>
            </p:cNvCxnSpPr>
            <p:nvPr/>
          </p:nvCxnSpPr>
          <p:spPr>
            <a:xfrm>
              <a:off x="4557263" y="11136226"/>
              <a:ext cx="2358000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31" name="Textfeld 1">
            <a:extLst>
              <a:ext uri="{FF2B5EF4-FFF2-40B4-BE49-F238E27FC236}">
                <a16:creationId xmlns="" xmlns:a16="http://schemas.microsoft.com/office/drawing/2014/main" id="{D0341227-8EB1-6336-5D0B-5F930399BF61}"/>
              </a:ext>
            </a:extLst>
          </p:cNvPr>
          <p:cNvSpPr txBox="1"/>
          <p:nvPr/>
        </p:nvSpPr>
        <p:spPr>
          <a:xfrm>
            <a:off x="13577107" y="17107"/>
            <a:ext cx="13630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/>
              <a:t>Suppl. Fig 1</a:t>
            </a:r>
          </a:p>
        </p:txBody>
      </p:sp>
      <p:grpSp>
        <p:nvGrpSpPr>
          <p:cNvPr id="5" name="Gruppieren 4">
            <a:extLst>
              <a:ext uri="{FF2B5EF4-FFF2-40B4-BE49-F238E27FC236}">
                <a16:creationId xmlns="" xmlns:a16="http://schemas.microsoft.com/office/drawing/2014/main" id="{2666ABE2-9150-E69B-F761-57899367CEC1}"/>
              </a:ext>
            </a:extLst>
          </p:cNvPr>
          <p:cNvGrpSpPr/>
          <p:nvPr/>
        </p:nvGrpSpPr>
        <p:grpSpPr>
          <a:xfrm>
            <a:off x="7534382" y="300109"/>
            <a:ext cx="6596031" cy="4328908"/>
            <a:chOff x="7534382" y="88248"/>
            <a:chExt cx="6596031" cy="4328908"/>
          </a:xfrm>
        </p:grpSpPr>
        <p:pic>
          <p:nvPicPr>
            <p:cNvPr id="1130" name="Grafik 1129" descr="Ein Bild, das Text, Diagramm, Zahl, Reihe enthält.&#10;&#10;Automatisch generierte Beschreibung">
              <a:extLst>
                <a:ext uri="{FF2B5EF4-FFF2-40B4-BE49-F238E27FC236}">
                  <a16:creationId xmlns="" xmlns:a16="http://schemas.microsoft.com/office/drawing/2014/main" id="{076D6B72-472B-FE26-F682-B6BA225C01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25222" y="990121"/>
              <a:ext cx="2501191" cy="1130401"/>
            </a:xfrm>
            <a:prstGeom prst="rect">
              <a:avLst/>
            </a:prstGeom>
          </p:spPr>
        </p:pic>
        <p:pic>
          <p:nvPicPr>
            <p:cNvPr id="1129" name="Grafik 1128" descr="Ein Bild, das Text, Reihe, Screenshot, Schrift enthält.&#10;&#10;Automatisch generierte Beschreibung">
              <a:extLst>
                <a:ext uri="{FF2B5EF4-FFF2-40B4-BE49-F238E27FC236}">
                  <a16:creationId xmlns="" xmlns:a16="http://schemas.microsoft.com/office/drawing/2014/main" id="{5A33466C-A8F4-E6ED-E45B-C4617E398A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2280" y="987659"/>
              <a:ext cx="3096000" cy="1131623"/>
            </a:xfrm>
            <a:prstGeom prst="rect">
              <a:avLst/>
            </a:prstGeom>
          </p:spPr>
        </p:pic>
        <p:grpSp>
          <p:nvGrpSpPr>
            <p:cNvPr id="1098" name="Gruppieren 1097">
              <a:extLst>
                <a:ext uri="{FF2B5EF4-FFF2-40B4-BE49-F238E27FC236}">
                  <a16:creationId xmlns="" xmlns:a16="http://schemas.microsoft.com/office/drawing/2014/main" id="{6623688C-0F84-0877-EAB2-A634D28C7655}"/>
                </a:ext>
              </a:extLst>
            </p:cNvPr>
            <p:cNvGrpSpPr/>
            <p:nvPr/>
          </p:nvGrpSpPr>
          <p:grpSpPr>
            <a:xfrm>
              <a:off x="7534382" y="88248"/>
              <a:ext cx="6590184" cy="4328908"/>
              <a:chOff x="202830" y="136144"/>
              <a:chExt cx="6590184" cy="4328908"/>
            </a:xfrm>
          </p:grpSpPr>
          <p:sp>
            <p:nvSpPr>
              <p:cNvPr id="1103" name="Textfeld 1102">
                <a:extLst>
                  <a:ext uri="{FF2B5EF4-FFF2-40B4-BE49-F238E27FC236}">
                    <a16:creationId xmlns="" xmlns:a16="http://schemas.microsoft.com/office/drawing/2014/main" id="{DF529EA5-C813-A406-BD41-AD1D31D2E625}"/>
                  </a:ext>
                </a:extLst>
              </p:cNvPr>
              <p:cNvSpPr txBox="1"/>
              <p:nvPr/>
            </p:nvSpPr>
            <p:spPr>
              <a:xfrm rot="16200000">
                <a:off x="-108848" y="1490236"/>
                <a:ext cx="11311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4" name="Textfeld 1103">
                <a:extLst>
                  <a:ext uri="{FF2B5EF4-FFF2-40B4-BE49-F238E27FC236}">
                    <a16:creationId xmlns="" xmlns:a16="http://schemas.microsoft.com/office/drawing/2014/main" id="{1B6B5030-E061-1CFA-2779-0A6657821CD5}"/>
                  </a:ext>
                </a:extLst>
              </p:cNvPr>
              <p:cNvSpPr txBox="1"/>
              <p:nvPr/>
            </p:nvSpPr>
            <p:spPr>
              <a:xfrm>
                <a:off x="206317" y="757465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a</a:t>
                </a:r>
              </a:p>
            </p:txBody>
          </p:sp>
          <p:sp>
            <p:nvSpPr>
              <p:cNvPr id="1105" name="Textfeld 1104">
                <a:extLst>
                  <a:ext uri="{FF2B5EF4-FFF2-40B4-BE49-F238E27FC236}">
                    <a16:creationId xmlns="" xmlns:a16="http://schemas.microsoft.com/office/drawing/2014/main" id="{EC83659C-BE02-F1DF-D948-8491F8DE669E}"/>
                  </a:ext>
                </a:extLst>
              </p:cNvPr>
              <p:cNvSpPr txBox="1"/>
              <p:nvPr/>
            </p:nvSpPr>
            <p:spPr>
              <a:xfrm>
                <a:off x="3962815" y="780560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b</a:t>
                </a:r>
              </a:p>
            </p:txBody>
          </p:sp>
          <p:sp>
            <p:nvSpPr>
              <p:cNvPr id="1106" name="Textfeld 1105">
                <a:extLst>
                  <a:ext uri="{FF2B5EF4-FFF2-40B4-BE49-F238E27FC236}">
                    <a16:creationId xmlns="" xmlns:a16="http://schemas.microsoft.com/office/drawing/2014/main" id="{C3D2BD13-CB6F-B810-9B53-4A3C33166A84}"/>
                  </a:ext>
                </a:extLst>
              </p:cNvPr>
              <p:cNvSpPr txBox="1"/>
              <p:nvPr/>
            </p:nvSpPr>
            <p:spPr>
              <a:xfrm rot="16200000">
                <a:off x="3569417" y="1523239"/>
                <a:ext cx="12221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Mean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 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7" name="Textfeld 1106">
                <a:extLst>
                  <a:ext uri="{FF2B5EF4-FFF2-40B4-BE49-F238E27FC236}">
                    <a16:creationId xmlns="" xmlns:a16="http://schemas.microsoft.com/office/drawing/2014/main" id="{A3A8F4D5-542A-7237-A782-C36383DAE2E4}"/>
                  </a:ext>
                </a:extLst>
              </p:cNvPr>
              <p:cNvSpPr txBox="1"/>
              <p:nvPr/>
            </p:nvSpPr>
            <p:spPr>
              <a:xfrm>
                <a:off x="579532" y="2148018"/>
                <a:ext cx="30913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8" name="Textfeld 1107">
                <a:extLst>
                  <a:ext uri="{FF2B5EF4-FFF2-40B4-BE49-F238E27FC236}">
                    <a16:creationId xmlns="" xmlns:a16="http://schemas.microsoft.com/office/drawing/2014/main" id="{92459C60-5B96-ABC2-60C5-C4138C82E227}"/>
                  </a:ext>
                </a:extLst>
              </p:cNvPr>
              <p:cNvSpPr txBox="1"/>
              <p:nvPr/>
            </p:nvSpPr>
            <p:spPr>
              <a:xfrm>
                <a:off x="4294016" y="2151068"/>
                <a:ext cx="24989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09" name="Textfeld 1108">
                <a:extLst>
                  <a:ext uri="{FF2B5EF4-FFF2-40B4-BE49-F238E27FC236}">
                    <a16:creationId xmlns="" xmlns:a16="http://schemas.microsoft.com/office/drawing/2014/main" id="{28843243-7CDC-EAB2-0C43-6C4DA5E6CDD8}"/>
                  </a:ext>
                </a:extLst>
              </p:cNvPr>
              <p:cNvSpPr txBox="1"/>
              <p:nvPr/>
            </p:nvSpPr>
            <p:spPr>
              <a:xfrm rot="16200000">
                <a:off x="3602725" y="3540074"/>
                <a:ext cx="1155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0" name="Textfeld 1109">
                <a:extLst>
                  <a:ext uri="{FF2B5EF4-FFF2-40B4-BE49-F238E27FC236}">
                    <a16:creationId xmlns="" xmlns:a16="http://schemas.microsoft.com/office/drawing/2014/main" id="{EC434D63-4AE4-B88B-DE64-883867DCF7AD}"/>
                  </a:ext>
                </a:extLst>
              </p:cNvPr>
              <p:cNvSpPr txBox="1"/>
              <p:nvPr/>
            </p:nvSpPr>
            <p:spPr>
              <a:xfrm>
                <a:off x="528281" y="4234220"/>
                <a:ext cx="307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1" name="Textfeld 1110">
                <a:extLst>
                  <a:ext uri="{FF2B5EF4-FFF2-40B4-BE49-F238E27FC236}">
                    <a16:creationId xmlns="" xmlns:a16="http://schemas.microsoft.com/office/drawing/2014/main" id="{44460BF4-AF00-8748-B284-E3F97F39C625}"/>
                  </a:ext>
                </a:extLst>
              </p:cNvPr>
              <p:cNvSpPr txBox="1"/>
              <p:nvPr/>
            </p:nvSpPr>
            <p:spPr>
              <a:xfrm>
                <a:off x="4299864" y="4233243"/>
                <a:ext cx="247393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2" name="Textfeld 1111">
                <a:extLst>
                  <a:ext uri="{FF2B5EF4-FFF2-40B4-BE49-F238E27FC236}">
                    <a16:creationId xmlns="" xmlns:a16="http://schemas.microsoft.com/office/drawing/2014/main" id="{7E069CC9-EDB3-221A-0BAE-72ED2188A385}"/>
                  </a:ext>
                </a:extLst>
              </p:cNvPr>
              <p:cNvSpPr txBox="1"/>
              <p:nvPr/>
            </p:nvSpPr>
            <p:spPr>
              <a:xfrm rot="16200000">
                <a:off x="-144597" y="3558343"/>
                <a:ext cx="11920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3" name="Textfeld 1112">
                <a:extLst>
                  <a:ext uri="{FF2B5EF4-FFF2-40B4-BE49-F238E27FC236}">
                    <a16:creationId xmlns="" xmlns:a16="http://schemas.microsoft.com/office/drawing/2014/main" id="{1D5D44D9-F15A-2502-5FBA-DE1F6B0063C5}"/>
                  </a:ext>
                </a:extLst>
              </p:cNvPr>
              <p:cNvSpPr txBox="1"/>
              <p:nvPr/>
            </p:nvSpPr>
            <p:spPr>
              <a:xfrm>
                <a:off x="202830" y="2843327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c</a:t>
                </a:r>
              </a:p>
            </p:txBody>
          </p:sp>
          <p:sp>
            <p:nvSpPr>
              <p:cNvPr id="1114" name="Textfeld 1113">
                <a:extLst>
                  <a:ext uri="{FF2B5EF4-FFF2-40B4-BE49-F238E27FC236}">
                    <a16:creationId xmlns="" xmlns:a16="http://schemas.microsoft.com/office/drawing/2014/main" id="{412B3F51-BE2E-C005-9AE3-8B00CF49D764}"/>
                  </a:ext>
                </a:extLst>
              </p:cNvPr>
              <p:cNvSpPr txBox="1"/>
              <p:nvPr/>
            </p:nvSpPr>
            <p:spPr>
              <a:xfrm>
                <a:off x="3959328" y="2866422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d</a:t>
                </a:r>
              </a:p>
            </p:txBody>
          </p:sp>
          <p:cxnSp>
            <p:nvCxnSpPr>
              <p:cNvPr id="1115" name="Gerade Verbindung 269">
                <a:extLst>
                  <a:ext uri="{FF2B5EF4-FFF2-40B4-BE49-F238E27FC236}">
                    <a16:creationId xmlns="" xmlns:a16="http://schemas.microsoft.com/office/drawing/2014/main" id="{2C1744DB-DC29-8D6E-940D-2F33853A6F38}"/>
                  </a:ext>
                </a:extLst>
              </p:cNvPr>
              <p:cNvCxnSpPr/>
              <p:nvPr/>
            </p:nvCxnSpPr>
            <p:spPr>
              <a:xfrm flipH="1">
                <a:off x="603891" y="1651282"/>
                <a:ext cx="3024000" cy="0"/>
              </a:xfrm>
              <a:prstGeom prst="line">
                <a:avLst/>
              </a:prstGeom>
              <a:ln>
                <a:solidFill>
                  <a:srgbClr val="339E6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6" name="Gerade Verbindung 290">
                <a:extLst>
                  <a:ext uri="{FF2B5EF4-FFF2-40B4-BE49-F238E27FC236}">
                    <a16:creationId xmlns="" xmlns:a16="http://schemas.microsoft.com/office/drawing/2014/main" id="{DD6D738F-7AC6-D137-6AE0-1E9D4E6A05CF}"/>
                  </a:ext>
                </a:extLst>
              </p:cNvPr>
              <p:cNvCxnSpPr/>
              <p:nvPr/>
            </p:nvCxnSpPr>
            <p:spPr>
              <a:xfrm>
                <a:off x="4401952" y="1693210"/>
                <a:ext cx="2358000" cy="0"/>
              </a:xfrm>
              <a:prstGeom prst="line">
                <a:avLst/>
              </a:prstGeom>
              <a:ln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7" name="Gerade Verbindung 291">
                <a:extLst>
                  <a:ext uri="{FF2B5EF4-FFF2-40B4-BE49-F238E27FC236}">
                    <a16:creationId xmlns="" xmlns:a16="http://schemas.microsoft.com/office/drawing/2014/main" id="{08414519-883E-7B08-544B-3EA02C3CBE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4863" y="1231407"/>
                <a:ext cx="2358000" cy="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8" name="Google Shape;87;p1">
                <a:extLst>
                  <a:ext uri="{FF2B5EF4-FFF2-40B4-BE49-F238E27FC236}">
                    <a16:creationId xmlns="" xmlns:a16="http://schemas.microsoft.com/office/drawing/2014/main" id="{3A3787E5-25C8-AA87-584E-2A47987779DB}"/>
                  </a:ext>
                </a:extLst>
              </p:cNvPr>
              <p:cNvSpPr txBox="1"/>
              <p:nvPr/>
            </p:nvSpPr>
            <p:spPr>
              <a:xfrm>
                <a:off x="206318" y="136144"/>
                <a:ext cx="6578680" cy="3765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000" b="1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SAMPLE ID062</a:t>
                </a:r>
              </a:p>
            </p:txBody>
          </p:sp>
          <p:sp>
            <p:nvSpPr>
              <p:cNvPr id="1119" name="Google Shape;87;p1">
                <a:extLst>
                  <a:ext uri="{FF2B5EF4-FFF2-40B4-BE49-F238E27FC236}">
                    <a16:creationId xmlns="" xmlns:a16="http://schemas.microsoft.com/office/drawing/2014/main" id="{CDE35CC5-54B5-6302-8FB0-6000333E2AC3}"/>
                  </a:ext>
                </a:extLst>
              </p:cNvPr>
              <p:cNvSpPr txBox="1"/>
              <p:nvPr/>
            </p:nvSpPr>
            <p:spPr>
              <a:xfrm>
                <a:off x="202830" y="2592363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u="sng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ONT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aneuploid (-21, -22)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  <p:sp>
            <p:nvSpPr>
              <p:cNvPr id="1120" name="Google Shape;87;p1">
                <a:extLst>
                  <a:ext uri="{FF2B5EF4-FFF2-40B4-BE49-F238E27FC236}">
                    <a16:creationId xmlns="" xmlns:a16="http://schemas.microsoft.com/office/drawing/2014/main" id="{6FBF9FFE-8574-CA59-EE07-6556E8C822AC}"/>
                  </a:ext>
                </a:extLst>
              </p:cNvPr>
              <p:cNvSpPr txBox="1"/>
              <p:nvPr/>
            </p:nvSpPr>
            <p:spPr>
              <a:xfrm>
                <a:off x="202830" y="506441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lvl="0" algn="ctr"/>
                <a:r>
                  <a:rPr lang="en-US" sz="1600" u="sng" dirty="0" err="1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aCGH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euploid | reported: euploid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</p:grpSp>
        <p:pic>
          <p:nvPicPr>
            <p:cNvPr id="1134" name="Grafik 1133">
              <a:extLst>
                <a:ext uri="{FF2B5EF4-FFF2-40B4-BE49-F238E27FC236}">
                  <a16:creationId xmlns="" xmlns:a16="http://schemas.microsoft.com/office/drawing/2014/main" id="{5F702425-559B-3143-678E-97A947064D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45460" y="3026194"/>
              <a:ext cx="3075251" cy="1174901"/>
            </a:xfrm>
            <a:prstGeom prst="rect">
              <a:avLst/>
            </a:prstGeom>
          </p:spPr>
        </p:pic>
        <p:pic>
          <p:nvPicPr>
            <p:cNvPr id="1135" name="Grafik 1134">
              <a:extLst>
                <a:ext uri="{FF2B5EF4-FFF2-40B4-BE49-F238E27FC236}">
                  <a16:creationId xmlns="" xmlns:a16="http://schemas.microsoft.com/office/drawing/2014/main" id="{31ECB0CF-D5AC-9F9F-B970-C023873C50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1416" y="3026194"/>
              <a:ext cx="2498997" cy="1195028"/>
            </a:xfrm>
            <a:prstGeom prst="rect">
              <a:avLst/>
            </a:prstGeom>
          </p:spPr>
        </p:pic>
      </p:grpSp>
      <p:grpSp>
        <p:nvGrpSpPr>
          <p:cNvPr id="4" name="Gruppieren 3">
            <a:extLst>
              <a:ext uri="{FF2B5EF4-FFF2-40B4-BE49-F238E27FC236}">
                <a16:creationId xmlns="" xmlns:a16="http://schemas.microsoft.com/office/drawing/2014/main" id="{E527C909-0D69-3B2D-CFF8-A265B888A98B}"/>
              </a:ext>
            </a:extLst>
          </p:cNvPr>
          <p:cNvGrpSpPr/>
          <p:nvPr/>
        </p:nvGrpSpPr>
        <p:grpSpPr>
          <a:xfrm>
            <a:off x="7547629" y="5278545"/>
            <a:ext cx="6592538" cy="4328908"/>
            <a:chOff x="7547629" y="5066684"/>
            <a:chExt cx="6592538" cy="4328908"/>
          </a:xfrm>
        </p:grpSpPr>
        <p:pic>
          <p:nvPicPr>
            <p:cNvPr id="1143" name="Grafik 1142" descr="Ein Bild, das Text, parallel, Diagramm, Zahl enthält.&#10;&#10;Automatisch generierte Beschreibung">
              <a:extLst>
                <a:ext uri="{FF2B5EF4-FFF2-40B4-BE49-F238E27FC236}">
                  <a16:creationId xmlns="" xmlns:a16="http://schemas.microsoft.com/office/drawing/2014/main" id="{ED49346E-69AB-BEF0-B9A1-CBCDAA1683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8977" y="5962922"/>
              <a:ext cx="2501190" cy="1130400"/>
            </a:xfrm>
            <a:prstGeom prst="rect">
              <a:avLst/>
            </a:prstGeom>
          </p:spPr>
        </p:pic>
        <p:pic>
          <p:nvPicPr>
            <p:cNvPr id="1145" name="Grafik 1144" descr="Ein Bild, das Text, Reihe, Screenshot, Schrift enthält.&#10;&#10;Automatisch generierte Beschreibung">
              <a:extLst>
                <a:ext uri="{FF2B5EF4-FFF2-40B4-BE49-F238E27FC236}">
                  <a16:creationId xmlns="" xmlns:a16="http://schemas.microsoft.com/office/drawing/2014/main" id="{01C1CC17-48B8-855B-2F8A-5C7DADC0C2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07299" y="5968558"/>
              <a:ext cx="3092653" cy="1130400"/>
            </a:xfrm>
            <a:prstGeom prst="rect">
              <a:avLst/>
            </a:prstGeom>
          </p:spPr>
        </p:pic>
        <p:grpSp>
          <p:nvGrpSpPr>
            <p:cNvPr id="1053" name="Gruppieren 1052">
              <a:extLst>
                <a:ext uri="{FF2B5EF4-FFF2-40B4-BE49-F238E27FC236}">
                  <a16:creationId xmlns="" xmlns:a16="http://schemas.microsoft.com/office/drawing/2014/main" id="{945F3B95-276D-46E4-A94F-DB4A19149226}"/>
                </a:ext>
              </a:extLst>
            </p:cNvPr>
            <p:cNvGrpSpPr/>
            <p:nvPr/>
          </p:nvGrpSpPr>
          <p:grpSpPr>
            <a:xfrm>
              <a:off x="7547629" y="5066684"/>
              <a:ext cx="6590184" cy="4328908"/>
              <a:chOff x="202830" y="136144"/>
              <a:chExt cx="6590184" cy="4328908"/>
            </a:xfrm>
          </p:grpSpPr>
          <p:sp>
            <p:nvSpPr>
              <p:cNvPr id="1056" name="Textfeld 1055">
                <a:extLst>
                  <a:ext uri="{FF2B5EF4-FFF2-40B4-BE49-F238E27FC236}">
                    <a16:creationId xmlns="" xmlns:a16="http://schemas.microsoft.com/office/drawing/2014/main" id="{0525475F-6EA4-0C4C-A38A-BEDDCA102764}"/>
                  </a:ext>
                </a:extLst>
              </p:cNvPr>
              <p:cNvSpPr txBox="1"/>
              <p:nvPr/>
            </p:nvSpPr>
            <p:spPr>
              <a:xfrm rot="16200000">
                <a:off x="-108848" y="1490236"/>
                <a:ext cx="11311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7" name="Textfeld 1056">
                <a:extLst>
                  <a:ext uri="{FF2B5EF4-FFF2-40B4-BE49-F238E27FC236}">
                    <a16:creationId xmlns="" xmlns:a16="http://schemas.microsoft.com/office/drawing/2014/main" id="{31C7F83B-0323-AE80-6A21-416E1759DA21}"/>
                  </a:ext>
                </a:extLst>
              </p:cNvPr>
              <p:cNvSpPr txBox="1"/>
              <p:nvPr/>
            </p:nvSpPr>
            <p:spPr>
              <a:xfrm>
                <a:off x="206317" y="757465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a</a:t>
                </a:r>
              </a:p>
            </p:txBody>
          </p:sp>
          <p:sp>
            <p:nvSpPr>
              <p:cNvPr id="1058" name="Textfeld 1057">
                <a:extLst>
                  <a:ext uri="{FF2B5EF4-FFF2-40B4-BE49-F238E27FC236}">
                    <a16:creationId xmlns="" xmlns:a16="http://schemas.microsoft.com/office/drawing/2014/main" id="{8357DFF7-B589-8438-B41C-E34E79ED7BFB}"/>
                  </a:ext>
                </a:extLst>
              </p:cNvPr>
              <p:cNvSpPr txBox="1"/>
              <p:nvPr/>
            </p:nvSpPr>
            <p:spPr>
              <a:xfrm>
                <a:off x="3962815" y="780560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b</a:t>
                </a:r>
              </a:p>
            </p:txBody>
          </p:sp>
          <p:sp>
            <p:nvSpPr>
              <p:cNvPr id="1059" name="Textfeld 1058">
                <a:extLst>
                  <a:ext uri="{FF2B5EF4-FFF2-40B4-BE49-F238E27FC236}">
                    <a16:creationId xmlns="" xmlns:a16="http://schemas.microsoft.com/office/drawing/2014/main" id="{E8F042ED-55BA-2430-B96B-B52FF6A9ECAE}"/>
                  </a:ext>
                </a:extLst>
              </p:cNvPr>
              <p:cNvSpPr txBox="1"/>
              <p:nvPr/>
            </p:nvSpPr>
            <p:spPr>
              <a:xfrm rot="16200000">
                <a:off x="3569417" y="1523239"/>
                <a:ext cx="12221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Mean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 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0" name="Textfeld 1059">
                <a:extLst>
                  <a:ext uri="{FF2B5EF4-FFF2-40B4-BE49-F238E27FC236}">
                    <a16:creationId xmlns="" xmlns:a16="http://schemas.microsoft.com/office/drawing/2014/main" id="{CE5A319A-27FC-B79D-21BB-4AD4863E5BC0}"/>
                  </a:ext>
                </a:extLst>
              </p:cNvPr>
              <p:cNvSpPr txBox="1"/>
              <p:nvPr/>
            </p:nvSpPr>
            <p:spPr>
              <a:xfrm>
                <a:off x="579532" y="2148018"/>
                <a:ext cx="30913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1" name="Textfeld 1060">
                <a:extLst>
                  <a:ext uri="{FF2B5EF4-FFF2-40B4-BE49-F238E27FC236}">
                    <a16:creationId xmlns="" xmlns:a16="http://schemas.microsoft.com/office/drawing/2014/main" id="{881C1149-D1D8-29C3-1B3D-1C6B274CF8EE}"/>
                  </a:ext>
                </a:extLst>
              </p:cNvPr>
              <p:cNvSpPr txBox="1"/>
              <p:nvPr/>
            </p:nvSpPr>
            <p:spPr>
              <a:xfrm>
                <a:off x="4294016" y="2151068"/>
                <a:ext cx="24989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2" name="Textfeld 1061">
                <a:extLst>
                  <a:ext uri="{FF2B5EF4-FFF2-40B4-BE49-F238E27FC236}">
                    <a16:creationId xmlns="" xmlns:a16="http://schemas.microsoft.com/office/drawing/2014/main" id="{65BCAA40-5994-8E65-6BD6-339E5E3F2EAA}"/>
                  </a:ext>
                </a:extLst>
              </p:cNvPr>
              <p:cNvSpPr txBox="1"/>
              <p:nvPr/>
            </p:nvSpPr>
            <p:spPr>
              <a:xfrm rot="16200000">
                <a:off x="3602725" y="3540074"/>
                <a:ext cx="1155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3" name="Textfeld 1062">
                <a:extLst>
                  <a:ext uri="{FF2B5EF4-FFF2-40B4-BE49-F238E27FC236}">
                    <a16:creationId xmlns="" xmlns:a16="http://schemas.microsoft.com/office/drawing/2014/main" id="{6E11ACCA-970C-5BC3-7410-7B3292643B57}"/>
                  </a:ext>
                </a:extLst>
              </p:cNvPr>
              <p:cNvSpPr txBox="1"/>
              <p:nvPr/>
            </p:nvSpPr>
            <p:spPr>
              <a:xfrm>
                <a:off x="528281" y="4234220"/>
                <a:ext cx="307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4" name="Textfeld 1063">
                <a:extLst>
                  <a:ext uri="{FF2B5EF4-FFF2-40B4-BE49-F238E27FC236}">
                    <a16:creationId xmlns="" xmlns:a16="http://schemas.microsoft.com/office/drawing/2014/main" id="{714CE237-6B5C-683E-12E5-2585347A661E}"/>
                  </a:ext>
                </a:extLst>
              </p:cNvPr>
              <p:cNvSpPr txBox="1"/>
              <p:nvPr/>
            </p:nvSpPr>
            <p:spPr>
              <a:xfrm>
                <a:off x="4299864" y="4233243"/>
                <a:ext cx="247393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5" name="Textfeld 1064">
                <a:extLst>
                  <a:ext uri="{FF2B5EF4-FFF2-40B4-BE49-F238E27FC236}">
                    <a16:creationId xmlns="" xmlns:a16="http://schemas.microsoft.com/office/drawing/2014/main" id="{A0BCDDD7-D1C9-A17B-2ED1-7EB6E0B93107}"/>
                  </a:ext>
                </a:extLst>
              </p:cNvPr>
              <p:cNvSpPr txBox="1"/>
              <p:nvPr/>
            </p:nvSpPr>
            <p:spPr>
              <a:xfrm rot="16200000">
                <a:off x="-144597" y="3558343"/>
                <a:ext cx="11920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6" name="Textfeld 1065">
                <a:extLst>
                  <a:ext uri="{FF2B5EF4-FFF2-40B4-BE49-F238E27FC236}">
                    <a16:creationId xmlns="" xmlns:a16="http://schemas.microsoft.com/office/drawing/2014/main" id="{FF672265-D3EF-D34C-0CAE-2E06E544415E}"/>
                  </a:ext>
                </a:extLst>
              </p:cNvPr>
              <p:cNvSpPr txBox="1"/>
              <p:nvPr/>
            </p:nvSpPr>
            <p:spPr>
              <a:xfrm>
                <a:off x="202830" y="2843327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c</a:t>
                </a:r>
              </a:p>
            </p:txBody>
          </p:sp>
          <p:sp>
            <p:nvSpPr>
              <p:cNvPr id="1067" name="Textfeld 1066">
                <a:extLst>
                  <a:ext uri="{FF2B5EF4-FFF2-40B4-BE49-F238E27FC236}">
                    <a16:creationId xmlns="" xmlns:a16="http://schemas.microsoft.com/office/drawing/2014/main" id="{1AA7A03C-5405-526A-1014-F84C309E5AB6}"/>
                  </a:ext>
                </a:extLst>
              </p:cNvPr>
              <p:cNvSpPr txBox="1"/>
              <p:nvPr/>
            </p:nvSpPr>
            <p:spPr>
              <a:xfrm>
                <a:off x="3959328" y="2866422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d</a:t>
                </a:r>
              </a:p>
            </p:txBody>
          </p:sp>
          <p:cxnSp>
            <p:nvCxnSpPr>
              <p:cNvPr id="1068" name="Gerade Verbindung 269">
                <a:extLst>
                  <a:ext uri="{FF2B5EF4-FFF2-40B4-BE49-F238E27FC236}">
                    <a16:creationId xmlns="" xmlns:a16="http://schemas.microsoft.com/office/drawing/2014/main" id="{32AA5EE3-0999-1563-56EB-3D9A1270B447}"/>
                  </a:ext>
                </a:extLst>
              </p:cNvPr>
              <p:cNvCxnSpPr/>
              <p:nvPr/>
            </p:nvCxnSpPr>
            <p:spPr>
              <a:xfrm flipH="1">
                <a:off x="603891" y="1651282"/>
                <a:ext cx="3024000" cy="0"/>
              </a:xfrm>
              <a:prstGeom prst="line">
                <a:avLst/>
              </a:prstGeom>
              <a:ln>
                <a:solidFill>
                  <a:srgbClr val="339E6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9" name="Gerade Verbindung 290">
                <a:extLst>
                  <a:ext uri="{FF2B5EF4-FFF2-40B4-BE49-F238E27FC236}">
                    <a16:creationId xmlns="" xmlns:a16="http://schemas.microsoft.com/office/drawing/2014/main" id="{1376A945-7945-BB3F-B088-7B2DEF0B4C57}"/>
                  </a:ext>
                </a:extLst>
              </p:cNvPr>
              <p:cNvCxnSpPr/>
              <p:nvPr/>
            </p:nvCxnSpPr>
            <p:spPr>
              <a:xfrm>
                <a:off x="4401952" y="1693210"/>
                <a:ext cx="2358000" cy="0"/>
              </a:xfrm>
              <a:prstGeom prst="line">
                <a:avLst/>
              </a:prstGeom>
              <a:ln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0" name="Gerade Verbindung 291">
                <a:extLst>
                  <a:ext uri="{FF2B5EF4-FFF2-40B4-BE49-F238E27FC236}">
                    <a16:creationId xmlns="" xmlns:a16="http://schemas.microsoft.com/office/drawing/2014/main" id="{551BB1CE-A1EE-3080-E4BD-01C535A58E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4863" y="1231407"/>
                <a:ext cx="2358000" cy="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1" name="Google Shape;87;p1">
                <a:extLst>
                  <a:ext uri="{FF2B5EF4-FFF2-40B4-BE49-F238E27FC236}">
                    <a16:creationId xmlns="" xmlns:a16="http://schemas.microsoft.com/office/drawing/2014/main" id="{7EF5C049-65E5-1831-47E6-47EA56DCB59A}"/>
                  </a:ext>
                </a:extLst>
              </p:cNvPr>
              <p:cNvSpPr txBox="1"/>
              <p:nvPr/>
            </p:nvSpPr>
            <p:spPr>
              <a:xfrm>
                <a:off x="206318" y="136144"/>
                <a:ext cx="6578680" cy="3765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2000" b="1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SAMPLE ID063</a:t>
                </a:r>
              </a:p>
            </p:txBody>
          </p:sp>
          <p:sp>
            <p:nvSpPr>
              <p:cNvPr id="1072" name="Google Shape;87;p1">
                <a:extLst>
                  <a:ext uri="{FF2B5EF4-FFF2-40B4-BE49-F238E27FC236}">
                    <a16:creationId xmlns="" xmlns:a16="http://schemas.microsoft.com/office/drawing/2014/main" id="{E018B30F-2351-446F-043C-7F87262D96D2}"/>
                  </a:ext>
                </a:extLst>
              </p:cNvPr>
              <p:cNvSpPr txBox="1"/>
              <p:nvPr/>
            </p:nvSpPr>
            <p:spPr>
              <a:xfrm>
                <a:off x="202830" y="2592363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600" u="sng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ONT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aneuploid (-14)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  <p:sp>
            <p:nvSpPr>
              <p:cNvPr id="1073" name="Google Shape;87;p1">
                <a:extLst>
                  <a:ext uri="{FF2B5EF4-FFF2-40B4-BE49-F238E27FC236}">
                    <a16:creationId xmlns="" xmlns:a16="http://schemas.microsoft.com/office/drawing/2014/main" id="{C191A608-D770-24FD-24FA-450FACC9CC30}"/>
                  </a:ext>
                </a:extLst>
              </p:cNvPr>
              <p:cNvSpPr txBox="1"/>
              <p:nvPr/>
            </p:nvSpPr>
            <p:spPr>
              <a:xfrm>
                <a:off x="202830" y="506441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lvl="0" algn="ctr"/>
                <a:r>
                  <a:rPr lang="en-US" sz="1600" u="sng" dirty="0" err="1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aCGH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aneuploid (-14, +22) | reported: N/A</a:t>
                </a:r>
                <a:endParaRPr lang="en-US" sz="1400" dirty="0">
                  <a:solidFill>
                    <a:schemeClr val="dk1"/>
                  </a:solidFill>
                  <a:latin typeface="Consolas"/>
                  <a:ea typeface="Consolas"/>
                  <a:cs typeface="Consolas"/>
                  <a:sym typeface="Consolas"/>
                </a:endParaRPr>
              </a:p>
            </p:txBody>
          </p:sp>
        </p:grpSp>
        <p:pic>
          <p:nvPicPr>
            <p:cNvPr id="1140" name="Grafik 1139">
              <a:extLst>
                <a:ext uri="{FF2B5EF4-FFF2-40B4-BE49-F238E27FC236}">
                  <a16:creationId xmlns="" xmlns:a16="http://schemas.microsoft.com/office/drawing/2014/main" id="{17DA350A-66E0-29F9-136A-2CCD105187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58707" y="8027727"/>
              <a:ext cx="3075251" cy="1148132"/>
            </a:xfrm>
            <a:prstGeom prst="rect">
              <a:avLst/>
            </a:prstGeom>
          </p:spPr>
        </p:pic>
        <p:pic>
          <p:nvPicPr>
            <p:cNvPr id="1141" name="Grafik 1140">
              <a:extLst>
                <a:ext uri="{FF2B5EF4-FFF2-40B4-BE49-F238E27FC236}">
                  <a16:creationId xmlns="" xmlns:a16="http://schemas.microsoft.com/office/drawing/2014/main" id="{ED6AF3D5-E895-A494-D244-0AC8002112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3641" y="8004630"/>
              <a:ext cx="2488027" cy="1195028"/>
            </a:xfrm>
            <a:prstGeom prst="rect">
              <a:avLst/>
            </a:prstGeom>
          </p:spPr>
        </p:pic>
      </p:grpSp>
      <p:pic>
        <p:nvPicPr>
          <p:cNvPr id="1136" name="Picture 2">
            <a:extLst>
              <a:ext uri="{FF2B5EF4-FFF2-40B4-BE49-F238E27FC236}">
                <a16:creationId xmlns="" xmlns:a16="http://schemas.microsoft.com/office/drawing/2014/main" id="{FF5AE1D2-AADC-6649-1AA8-91A386ACC3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0215" y="15126679"/>
            <a:ext cx="4354782" cy="75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37" name="Picture 3">
            <a:extLst>
              <a:ext uri="{FF2B5EF4-FFF2-40B4-BE49-F238E27FC236}">
                <a16:creationId xmlns="" xmlns:a16="http://schemas.microsoft.com/office/drawing/2014/main" id="{E9C2C12D-0A1A-D7F2-4128-C138EFC6E8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68609" y="15286667"/>
            <a:ext cx="5541962" cy="414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Gruppieren 2">
            <a:extLst>
              <a:ext uri="{FF2B5EF4-FFF2-40B4-BE49-F238E27FC236}">
                <a16:creationId xmlns="" xmlns:a16="http://schemas.microsoft.com/office/drawing/2014/main" id="{7484C7F9-1112-E05F-4AFD-859BCF477CD3}"/>
              </a:ext>
            </a:extLst>
          </p:cNvPr>
          <p:cNvGrpSpPr/>
          <p:nvPr/>
        </p:nvGrpSpPr>
        <p:grpSpPr>
          <a:xfrm>
            <a:off x="7547629" y="10252824"/>
            <a:ext cx="6597921" cy="4328908"/>
            <a:chOff x="7547629" y="10040963"/>
            <a:chExt cx="6597921" cy="4328908"/>
          </a:xfrm>
        </p:grpSpPr>
        <p:pic>
          <p:nvPicPr>
            <p:cNvPr id="258" name="Grafik 257" descr="Ein Bild, das Text, Zahl, Reihe, Schrift enthält.&#10;&#10;Automatisch generierte Beschreibung">
              <a:extLst>
                <a:ext uri="{FF2B5EF4-FFF2-40B4-BE49-F238E27FC236}">
                  <a16:creationId xmlns="" xmlns:a16="http://schemas.microsoft.com/office/drawing/2014/main" id="{15FADE91-38B8-C4BC-3295-7AF01DEF1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8978" y="10940404"/>
              <a:ext cx="2506572" cy="1132833"/>
            </a:xfrm>
            <a:prstGeom prst="rect">
              <a:avLst/>
            </a:prstGeom>
          </p:spPr>
        </p:pic>
        <p:pic>
          <p:nvPicPr>
            <p:cNvPr id="260" name="Grafik 259" descr="Ein Bild, das Text, Reihe, Screenshot, Schrift enthält.&#10;&#10;Automatisch generierte Beschreibung">
              <a:extLst>
                <a:ext uri="{FF2B5EF4-FFF2-40B4-BE49-F238E27FC236}">
                  <a16:creationId xmlns="" xmlns:a16="http://schemas.microsoft.com/office/drawing/2014/main" id="{3F59E3FA-29B6-D4BC-E41D-3636E9B73C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07299" y="10942837"/>
              <a:ext cx="3092652" cy="1130400"/>
            </a:xfrm>
            <a:prstGeom prst="rect">
              <a:avLst/>
            </a:prstGeom>
          </p:spPr>
        </p:pic>
        <p:grpSp>
          <p:nvGrpSpPr>
            <p:cNvPr id="1077" name="Gruppieren 1076">
              <a:extLst>
                <a:ext uri="{FF2B5EF4-FFF2-40B4-BE49-F238E27FC236}">
                  <a16:creationId xmlns="" xmlns:a16="http://schemas.microsoft.com/office/drawing/2014/main" id="{06F4A306-B2E0-F6BF-E4FD-6A80ED740DDC}"/>
                </a:ext>
              </a:extLst>
            </p:cNvPr>
            <p:cNvGrpSpPr/>
            <p:nvPr/>
          </p:nvGrpSpPr>
          <p:grpSpPr>
            <a:xfrm>
              <a:off x="7547629" y="10040963"/>
              <a:ext cx="6590184" cy="4328908"/>
              <a:chOff x="202830" y="136144"/>
              <a:chExt cx="6590184" cy="4328908"/>
            </a:xfrm>
          </p:grpSpPr>
          <p:sp>
            <p:nvSpPr>
              <p:cNvPr id="1078" name="Textfeld 1077">
                <a:extLst>
                  <a:ext uri="{FF2B5EF4-FFF2-40B4-BE49-F238E27FC236}">
                    <a16:creationId xmlns="" xmlns:a16="http://schemas.microsoft.com/office/drawing/2014/main" id="{96AC3430-AE4B-9A9A-2D8A-10528A51C659}"/>
                  </a:ext>
                </a:extLst>
              </p:cNvPr>
              <p:cNvSpPr txBox="1"/>
              <p:nvPr/>
            </p:nvSpPr>
            <p:spPr>
              <a:xfrm rot="16200000">
                <a:off x="-108848" y="1490236"/>
                <a:ext cx="113112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9" name="Textfeld 1078">
                <a:extLst>
                  <a:ext uri="{FF2B5EF4-FFF2-40B4-BE49-F238E27FC236}">
                    <a16:creationId xmlns="" xmlns:a16="http://schemas.microsoft.com/office/drawing/2014/main" id="{0D7E62A6-654E-400E-3E56-3B6A85DDCBA4}"/>
                  </a:ext>
                </a:extLst>
              </p:cNvPr>
              <p:cNvSpPr txBox="1"/>
              <p:nvPr/>
            </p:nvSpPr>
            <p:spPr>
              <a:xfrm>
                <a:off x="206317" y="757465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a</a:t>
                </a:r>
              </a:p>
            </p:txBody>
          </p:sp>
          <p:sp>
            <p:nvSpPr>
              <p:cNvPr id="1080" name="Textfeld 1079">
                <a:extLst>
                  <a:ext uri="{FF2B5EF4-FFF2-40B4-BE49-F238E27FC236}">
                    <a16:creationId xmlns="" xmlns:a16="http://schemas.microsoft.com/office/drawing/2014/main" id="{94BE099A-ED8F-FC22-8D9B-68FCD8AE89F5}"/>
                  </a:ext>
                </a:extLst>
              </p:cNvPr>
              <p:cNvSpPr txBox="1"/>
              <p:nvPr/>
            </p:nvSpPr>
            <p:spPr>
              <a:xfrm>
                <a:off x="3962815" y="780560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b</a:t>
                </a:r>
              </a:p>
            </p:txBody>
          </p:sp>
          <p:sp>
            <p:nvSpPr>
              <p:cNvPr id="1081" name="Textfeld 1080">
                <a:extLst>
                  <a:ext uri="{FF2B5EF4-FFF2-40B4-BE49-F238E27FC236}">
                    <a16:creationId xmlns="" xmlns:a16="http://schemas.microsoft.com/office/drawing/2014/main" id="{C2C90E73-040F-B66B-9952-3048D64FC42F}"/>
                  </a:ext>
                </a:extLst>
              </p:cNvPr>
              <p:cNvSpPr txBox="1"/>
              <p:nvPr/>
            </p:nvSpPr>
            <p:spPr>
              <a:xfrm rot="16200000">
                <a:off x="3569417" y="1523239"/>
                <a:ext cx="12221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Mean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 log</a:t>
                </a:r>
                <a:r>
                  <a:rPr lang="de-AT" sz="900" baseline="-25000" dirty="0">
                    <a:latin typeface="Consolas" panose="020B0609020204030204" pitchFamily="49" charset="0"/>
                    <a:cs typeface="Arial" panose="020B0604020202020204" pitchFamily="34" charset="0"/>
                  </a:rPr>
                  <a:t>2</a:t>
                </a:r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atio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2" name="Textfeld 1081">
                <a:extLst>
                  <a:ext uri="{FF2B5EF4-FFF2-40B4-BE49-F238E27FC236}">
                    <a16:creationId xmlns="" xmlns:a16="http://schemas.microsoft.com/office/drawing/2014/main" id="{EB3C2BB4-FAD4-8926-043B-0A5483101B28}"/>
                  </a:ext>
                </a:extLst>
              </p:cNvPr>
              <p:cNvSpPr txBox="1"/>
              <p:nvPr/>
            </p:nvSpPr>
            <p:spPr>
              <a:xfrm>
                <a:off x="579532" y="2148018"/>
                <a:ext cx="309130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3" name="Textfeld 1082">
                <a:extLst>
                  <a:ext uri="{FF2B5EF4-FFF2-40B4-BE49-F238E27FC236}">
                    <a16:creationId xmlns="" xmlns:a16="http://schemas.microsoft.com/office/drawing/2014/main" id="{2131CD2D-A3BF-0F21-6E31-A2EBB9732C62}"/>
                  </a:ext>
                </a:extLst>
              </p:cNvPr>
              <p:cNvSpPr txBox="1"/>
              <p:nvPr/>
            </p:nvSpPr>
            <p:spPr>
              <a:xfrm>
                <a:off x="4294016" y="2151068"/>
                <a:ext cx="24989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4" name="Textfeld 1083">
                <a:extLst>
                  <a:ext uri="{FF2B5EF4-FFF2-40B4-BE49-F238E27FC236}">
                    <a16:creationId xmlns="" xmlns:a16="http://schemas.microsoft.com/office/drawing/2014/main" id="{0581E6A2-3EDB-01BE-6871-76D0EDE3C9B5}"/>
                  </a:ext>
                </a:extLst>
              </p:cNvPr>
              <p:cNvSpPr txBox="1"/>
              <p:nvPr/>
            </p:nvSpPr>
            <p:spPr>
              <a:xfrm rot="16200000">
                <a:off x="3602725" y="3540074"/>
                <a:ext cx="115550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5" name="Textfeld 1084">
                <a:extLst>
                  <a:ext uri="{FF2B5EF4-FFF2-40B4-BE49-F238E27FC236}">
                    <a16:creationId xmlns="" xmlns:a16="http://schemas.microsoft.com/office/drawing/2014/main" id="{80217E30-0DEB-6460-7028-B97754C1F8F2}"/>
                  </a:ext>
                </a:extLst>
              </p:cNvPr>
              <p:cNvSpPr txBox="1"/>
              <p:nvPr/>
            </p:nvSpPr>
            <p:spPr>
              <a:xfrm>
                <a:off x="528281" y="4234220"/>
                <a:ext cx="30752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6" name="Textfeld 1085">
                <a:extLst>
                  <a:ext uri="{FF2B5EF4-FFF2-40B4-BE49-F238E27FC236}">
                    <a16:creationId xmlns="" xmlns:a16="http://schemas.microsoft.com/office/drawing/2014/main" id="{D2DAEC3C-A5C6-6E83-6314-958A17D75302}"/>
                  </a:ext>
                </a:extLst>
              </p:cNvPr>
              <p:cNvSpPr txBox="1"/>
              <p:nvPr/>
            </p:nvSpPr>
            <p:spPr>
              <a:xfrm>
                <a:off x="4299864" y="4233243"/>
                <a:ext cx="247393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hromosomes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7" name="Textfeld 1086">
                <a:extLst>
                  <a:ext uri="{FF2B5EF4-FFF2-40B4-BE49-F238E27FC236}">
                    <a16:creationId xmlns="" xmlns:a16="http://schemas.microsoft.com/office/drawing/2014/main" id="{4585325F-8B5C-13C0-5645-5B56CB8A8032}"/>
                  </a:ext>
                </a:extLst>
              </p:cNvPr>
              <p:cNvSpPr txBox="1"/>
              <p:nvPr/>
            </p:nvSpPr>
            <p:spPr>
              <a:xfrm rot="16200000">
                <a:off x="-144597" y="3558343"/>
                <a:ext cx="11920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AT" sz="900" dirty="0">
                    <a:latin typeface="Consolas" panose="020B0609020204030204" pitchFamily="49" charset="0"/>
                    <a:cs typeface="Arial" panose="020B0604020202020204" pitchFamily="34" charset="0"/>
                  </a:rPr>
                  <a:t>Read </a:t>
                </a:r>
                <a:r>
                  <a:rPr lang="de-AT" sz="900" dirty="0" err="1">
                    <a:latin typeface="Consolas" panose="020B0609020204030204" pitchFamily="49" charset="0"/>
                    <a:cs typeface="Arial" panose="020B0604020202020204" pitchFamily="34" charset="0"/>
                  </a:rPr>
                  <a:t>count</a:t>
                </a:r>
                <a:endParaRPr lang="de-AT" sz="800" dirty="0">
                  <a:latin typeface="Consolas" panose="020B0609020204030204" pitchFamily="49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8" name="Textfeld 1087">
                <a:extLst>
                  <a:ext uri="{FF2B5EF4-FFF2-40B4-BE49-F238E27FC236}">
                    <a16:creationId xmlns="" xmlns:a16="http://schemas.microsoft.com/office/drawing/2014/main" id="{C1D6F63D-1C36-5A9A-C524-78474BE62B11}"/>
                  </a:ext>
                </a:extLst>
              </p:cNvPr>
              <p:cNvSpPr txBox="1"/>
              <p:nvPr/>
            </p:nvSpPr>
            <p:spPr>
              <a:xfrm>
                <a:off x="202830" y="2843327"/>
                <a:ext cx="33035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c</a:t>
                </a:r>
              </a:p>
            </p:txBody>
          </p:sp>
          <p:sp>
            <p:nvSpPr>
              <p:cNvPr id="1089" name="Textfeld 1088">
                <a:extLst>
                  <a:ext uri="{FF2B5EF4-FFF2-40B4-BE49-F238E27FC236}">
                    <a16:creationId xmlns="" xmlns:a16="http://schemas.microsoft.com/office/drawing/2014/main" id="{AF89C42D-5FC5-75D3-77EE-84751E047ACC}"/>
                  </a:ext>
                </a:extLst>
              </p:cNvPr>
              <p:cNvSpPr txBox="1"/>
              <p:nvPr/>
            </p:nvSpPr>
            <p:spPr>
              <a:xfrm>
                <a:off x="3959328" y="2866422"/>
                <a:ext cx="331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d</a:t>
                </a:r>
              </a:p>
            </p:txBody>
          </p:sp>
          <p:cxnSp>
            <p:nvCxnSpPr>
              <p:cNvPr id="1090" name="Gerade Verbindung 269">
                <a:extLst>
                  <a:ext uri="{FF2B5EF4-FFF2-40B4-BE49-F238E27FC236}">
                    <a16:creationId xmlns="" xmlns:a16="http://schemas.microsoft.com/office/drawing/2014/main" id="{2B2823DB-97BB-C7D8-DA60-93D29EC4D47A}"/>
                  </a:ext>
                </a:extLst>
              </p:cNvPr>
              <p:cNvCxnSpPr/>
              <p:nvPr/>
            </p:nvCxnSpPr>
            <p:spPr>
              <a:xfrm flipH="1">
                <a:off x="603891" y="1651282"/>
                <a:ext cx="3024000" cy="0"/>
              </a:xfrm>
              <a:prstGeom prst="line">
                <a:avLst/>
              </a:prstGeom>
              <a:ln>
                <a:solidFill>
                  <a:srgbClr val="339E66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1" name="Gerade Verbindung 290">
                <a:extLst>
                  <a:ext uri="{FF2B5EF4-FFF2-40B4-BE49-F238E27FC236}">
                    <a16:creationId xmlns="" xmlns:a16="http://schemas.microsoft.com/office/drawing/2014/main" id="{EF07098C-AFFC-AF11-FAB4-9DDD89E77064}"/>
                  </a:ext>
                </a:extLst>
              </p:cNvPr>
              <p:cNvCxnSpPr/>
              <p:nvPr/>
            </p:nvCxnSpPr>
            <p:spPr>
              <a:xfrm>
                <a:off x="4401952" y="1693210"/>
                <a:ext cx="2358000" cy="0"/>
              </a:xfrm>
              <a:prstGeom prst="line">
                <a:avLst/>
              </a:prstGeom>
              <a:ln>
                <a:solidFill>
                  <a:srgbClr val="0070C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2" name="Gerade Verbindung 291">
                <a:extLst>
                  <a:ext uri="{FF2B5EF4-FFF2-40B4-BE49-F238E27FC236}">
                    <a16:creationId xmlns="" xmlns:a16="http://schemas.microsoft.com/office/drawing/2014/main" id="{7C3470F0-7835-37DD-3CB1-8CDCC5E709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4863" y="1231407"/>
                <a:ext cx="2358000" cy="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3" name="Google Shape;87;p1">
                <a:extLst>
                  <a:ext uri="{FF2B5EF4-FFF2-40B4-BE49-F238E27FC236}">
                    <a16:creationId xmlns="" xmlns:a16="http://schemas.microsoft.com/office/drawing/2014/main" id="{07A173FD-3AD1-C270-FEA9-A37A2D498D65}"/>
                  </a:ext>
                </a:extLst>
              </p:cNvPr>
              <p:cNvSpPr txBox="1"/>
              <p:nvPr/>
            </p:nvSpPr>
            <p:spPr>
              <a:xfrm>
                <a:off x="206318" y="136144"/>
                <a:ext cx="6578680" cy="37656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r>
                  <a:rPr lang="en-US" sz="2000" b="1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SAMPLE </a:t>
                </a:r>
                <a:r>
                  <a:rPr lang="de-AT" sz="2000" b="1" dirty="0">
                    <a:latin typeface="Consolas" panose="020B0609020204030204" pitchFamily="49" charset="0"/>
                  </a:rPr>
                  <a:t>ID072</a:t>
                </a:r>
                <a:endParaRPr lang="de-AT" sz="2000" b="1" dirty="0"/>
              </a:p>
            </p:txBody>
          </p:sp>
          <p:sp>
            <p:nvSpPr>
              <p:cNvPr id="1094" name="Google Shape;87;p1">
                <a:extLst>
                  <a:ext uri="{FF2B5EF4-FFF2-40B4-BE49-F238E27FC236}">
                    <a16:creationId xmlns="" xmlns:a16="http://schemas.microsoft.com/office/drawing/2014/main" id="{9D09F90F-72E8-D21E-42EF-E30EB2205D08}"/>
                  </a:ext>
                </a:extLst>
              </p:cNvPr>
              <p:cNvSpPr txBox="1"/>
              <p:nvPr/>
            </p:nvSpPr>
            <p:spPr>
              <a:xfrm>
                <a:off x="202830" y="2592363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lvl="0" algn="ctr"/>
                <a:r>
                  <a:rPr lang="en-US" sz="1600" u="sng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ONT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aneuploid (+X)</a:t>
                </a:r>
              </a:p>
            </p:txBody>
          </p:sp>
          <p:sp>
            <p:nvSpPr>
              <p:cNvPr id="1095" name="Google Shape;87;p1">
                <a:extLst>
                  <a:ext uri="{FF2B5EF4-FFF2-40B4-BE49-F238E27FC236}">
                    <a16:creationId xmlns="" xmlns:a16="http://schemas.microsoft.com/office/drawing/2014/main" id="{A93E6698-6034-880D-AD10-703D034EF829}"/>
                  </a:ext>
                </a:extLst>
              </p:cNvPr>
              <p:cNvSpPr txBox="1"/>
              <p:nvPr/>
            </p:nvSpPr>
            <p:spPr>
              <a:xfrm>
                <a:off x="202830" y="506441"/>
                <a:ext cx="6590184" cy="32458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0000" tIns="45000" rIns="90000" bIns="45000" anchor="t" anchorCtr="0">
                <a:noAutofit/>
              </a:bodyPr>
              <a:lstStyle/>
              <a:p>
                <a:pPr lvl="0" algn="ctr"/>
                <a:r>
                  <a:rPr lang="en-US" sz="1600" u="sng" dirty="0" err="1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aCGH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: euploid | reported: aneuploid (+2p, -7p, +</a:t>
                </a:r>
                <a:r>
                  <a:rPr lang="en-US" sz="1600" dirty="0" err="1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Xq</a:t>
                </a:r>
                <a:r>
                  <a:rPr lang="en-US" sz="1600" dirty="0">
                    <a:solidFill>
                      <a:schemeClr val="dk1"/>
                    </a:solidFill>
                    <a:latin typeface="Consolas"/>
                    <a:ea typeface="Consolas"/>
                    <a:cs typeface="Consolas"/>
                    <a:sym typeface="Consolas"/>
                  </a:rPr>
                  <a:t>)</a:t>
                </a:r>
              </a:p>
            </p:txBody>
          </p:sp>
        </p:grpSp>
        <p:pic>
          <p:nvPicPr>
            <p:cNvPr id="256" name="Grafik 255">
              <a:extLst>
                <a:ext uri="{FF2B5EF4-FFF2-40B4-BE49-F238E27FC236}">
                  <a16:creationId xmlns="" xmlns:a16="http://schemas.microsoft.com/office/drawing/2014/main" id="{33F3652F-4F1A-79B6-6015-3593840DCC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63694" y="13032812"/>
              <a:ext cx="3074400" cy="1139300"/>
            </a:xfrm>
            <a:prstGeom prst="rect">
              <a:avLst/>
            </a:prstGeom>
          </p:spPr>
        </p:pic>
        <p:pic>
          <p:nvPicPr>
            <p:cNvPr id="2" name="Grafik 1">
              <a:extLst>
                <a:ext uri="{FF2B5EF4-FFF2-40B4-BE49-F238E27FC236}">
                  <a16:creationId xmlns="" xmlns:a16="http://schemas.microsoft.com/office/drawing/2014/main" id="{88A8F468-0343-C6FB-1123-93AF4384BD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38472" y="12975262"/>
              <a:ext cx="2501696" cy="11004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2358029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0</Words>
  <Application>Microsoft Office PowerPoint</Application>
  <PresentationFormat>Benutzerdefiniert</PresentationFormat>
  <Paragraphs>9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</dc:creator>
  <cp:lastModifiedBy>Vivienne</cp:lastModifiedBy>
  <cp:revision>23</cp:revision>
  <dcterms:created xsi:type="dcterms:W3CDTF">2023-11-08T08:17:08Z</dcterms:created>
  <dcterms:modified xsi:type="dcterms:W3CDTF">2024-02-26T13:02:53Z</dcterms:modified>
</cp:coreProperties>
</file>